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57" r:id="rId5"/>
    <p:sldId id="256" r:id="rId6"/>
    <p:sldId id="258" r:id="rId7"/>
  </p:sldIdLst>
  <p:sldSz cx="7562850" cy="106886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F8C04DF-1CD5-497C-8C6B-F97E6150A02D}" v="6" dt="2024-05-09T18:05:30.02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70" d="100"/>
          <a:sy n="70" d="100"/>
        </p:scale>
        <p:origin x="3090"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5/10/relationships/revisionInfo" Target="revisionInfo.xml"/><Relationship Id="rId3" Type="http://schemas.openxmlformats.org/officeDocument/2006/relationships/customXml" Target="../customXml/item3.xml"/><Relationship Id="rId7" Type="http://schemas.openxmlformats.org/officeDocument/2006/relationships/slide" Target="slides/slide3.xml"/><Relationship Id="rId12" Type="http://schemas.microsoft.com/office/2016/11/relationships/changesInfo" Target="changesInfos/changesInfo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urre Kamphorst" userId="ea5a6d19-7a1a-404d-92c1-711466574960" providerId="ADAL" clId="{FF8C04DF-1CD5-497C-8C6B-F97E6150A02D}"/>
    <pc:docChg chg="undo custSel modSld">
      <pc:chgData name="Jurre Kamphorst" userId="ea5a6d19-7a1a-404d-92c1-711466574960" providerId="ADAL" clId="{FF8C04DF-1CD5-497C-8C6B-F97E6150A02D}" dt="2024-05-09T18:06:33.669" v="94" actId="1076"/>
      <pc:docMkLst>
        <pc:docMk/>
      </pc:docMkLst>
      <pc:sldChg chg="addSp modSp mod">
        <pc:chgData name="Jurre Kamphorst" userId="ea5a6d19-7a1a-404d-92c1-711466574960" providerId="ADAL" clId="{FF8C04DF-1CD5-497C-8C6B-F97E6150A02D}" dt="2024-05-09T18:02:24.973" v="46" actId="6549"/>
        <pc:sldMkLst>
          <pc:docMk/>
          <pc:sldMk cId="2576429967" sldId="256"/>
        </pc:sldMkLst>
        <pc:spChg chg="add mod">
          <ac:chgData name="Jurre Kamphorst" userId="ea5a6d19-7a1a-404d-92c1-711466574960" providerId="ADAL" clId="{FF8C04DF-1CD5-497C-8C6B-F97E6150A02D}" dt="2024-05-09T18:02:24.973" v="46" actId="6549"/>
          <ac:spMkLst>
            <pc:docMk/>
            <pc:sldMk cId="2576429967" sldId="256"/>
            <ac:spMk id="2" creationId="{41A4E1ED-C99F-B4E0-1133-6E0C6F9A44A1}"/>
          </ac:spMkLst>
        </pc:spChg>
        <pc:spChg chg="mod">
          <ac:chgData name="Jurre Kamphorst" userId="ea5a6d19-7a1a-404d-92c1-711466574960" providerId="ADAL" clId="{FF8C04DF-1CD5-497C-8C6B-F97E6150A02D}" dt="2024-05-09T18:01:55.253" v="38" actId="1076"/>
          <ac:spMkLst>
            <pc:docMk/>
            <pc:sldMk cId="2576429967" sldId="256"/>
            <ac:spMk id="4" creationId="{70778960-9A41-7EA9-E3B6-3F271E2FA499}"/>
          </ac:spMkLst>
        </pc:spChg>
        <pc:spChg chg="mod">
          <ac:chgData name="Jurre Kamphorst" userId="ea5a6d19-7a1a-404d-92c1-711466574960" providerId="ADAL" clId="{FF8C04DF-1CD5-497C-8C6B-F97E6150A02D}" dt="2024-05-09T18:01:55.253" v="38" actId="1076"/>
          <ac:spMkLst>
            <pc:docMk/>
            <pc:sldMk cId="2576429967" sldId="256"/>
            <ac:spMk id="7" creationId="{56025FF9-58BC-DE9C-2FBE-FDD2CBE37FB1}"/>
          </ac:spMkLst>
        </pc:spChg>
        <pc:spChg chg="mod">
          <ac:chgData name="Jurre Kamphorst" userId="ea5a6d19-7a1a-404d-92c1-711466574960" providerId="ADAL" clId="{FF8C04DF-1CD5-497C-8C6B-F97E6150A02D}" dt="2024-05-09T18:01:55.253" v="38" actId="1076"/>
          <ac:spMkLst>
            <pc:docMk/>
            <pc:sldMk cId="2576429967" sldId="256"/>
            <ac:spMk id="10" creationId="{845389DF-4A9C-3AE6-6F89-6232D8BE35DD}"/>
          </ac:spMkLst>
        </pc:spChg>
        <pc:spChg chg="mod">
          <ac:chgData name="Jurre Kamphorst" userId="ea5a6d19-7a1a-404d-92c1-711466574960" providerId="ADAL" clId="{FF8C04DF-1CD5-497C-8C6B-F97E6150A02D}" dt="2024-05-09T18:01:55.253" v="38" actId="1076"/>
          <ac:spMkLst>
            <pc:docMk/>
            <pc:sldMk cId="2576429967" sldId="256"/>
            <ac:spMk id="11" creationId="{2798851D-ADF4-E294-E38B-F63E1095A837}"/>
          </ac:spMkLst>
        </pc:spChg>
        <pc:spChg chg="mod">
          <ac:chgData name="Jurre Kamphorst" userId="ea5a6d19-7a1a-404d-92c1-711466574960" providerId="ADAL" clId="{FF8C04DF-1CD5-497C-8C6B-F97E6150A02D}" dt="2024-05-09T18:01:55.253" v="38" actId="1076"/>
          <ac:spMkLst>
            <pc:docMk/>
            <pc:sldMk cId="2576429967" sldId="256"/>
            <ac:spMk id="12" creationId="{946C90A9-EB83-090B-9F03-BF3FB2122CD7}"/>
          </ac:spMkLst>
        </pc:spChg>
        <pc:spChg chg="mod">
          <ac:chgData name="Jurre Kamphorst" userId="ea5a6d19-7a1a-404d-92c1-711466574960" providerId="ADAL" clId="{FF8C04DF-1CD5-497C-8C6B-F97E6150A02D}" dt="2024-05-09T18:01:55.253" v="38" actId="1076"/>
          <ac:spMkLst>
            <pc:docMk/>
            <pc:sldMk cId="2576429967" sldId="256"/>
            <ac:spMk id="13" creationId="{13BF9BEC-1C17-64BD-A91B-B0E567DAC2D1}"/>
          </ac:spMkLst>
        </pc:spChg>
        <pc:spChg chg="mod">
          <ac:chgData name="Jurre Kamphorst" userId="ea5a6d19-7a1a-404d-92c1-711466574960" providerId="ADAL" clId="{FF8C04DF-1CD5-497C-8C6B-F97E6150A02D}" dt="2024-05-09T18:01:55.253" v="38" actId="1076"/>
          <ac:spMkLst>
            <pc:docMk/>
            <pc:sldMk cId="2576429967" sldId="256"/>
            <ac:spMk id="14" creationId="{B696EEB4-AE4E-F5F7-3285-54B7135A6835}"/>
          </ac:spMkLst>
        </pc:spChg>
        <pc:spChg chg="mod">
          <ac:chgData name="Jurre Kamphorst" userId="ea5a6d19-7a1a-404d-92c1-711466574960" providerId="ADAL" clId="{FF8C04DF-1CD5-497C-8C6B-F97E6150A02D}" dt="2024-05-09T18:01:58.066" v="39" actId="1076"/>
          <ac:spMkLst>
            <pc:docMk/>
            <pc:sldMk cId="2576429967" sldId="256"/>
            <ac:spMk id="17" creationId="{ED079F89-A266-351F-A718-A7EBA4D908BC}"/>
          </ac:spMkLst>
        </pc:spChg>
        <pc:graphicFrameChg chg="mod">
          <ac:chgData name="Jurre Kamphorst" userId="ea5a6d19-7a1a-404d-92c1-711466574960" providerId="ADAL" clId="{FF8C04DF-1CD5-497C-8C6B-F97E6150A02D}" dt="2024-05-09T18:01:55.253" v="38" actId="1076"/>
          <ac:graphicFrameMkLst>
            <pc:docMk/>
            <pc:sldMk cId="2576429967" sldId="256"/>
            <ac:graphicFrameMk id="5" creationId="{B7ADEA06-DD7E-452F-7E41-D9D7DD81C511}"/>
          </ac:graphicFrameMkLst>
        </pc:graphicFrameChg>
        <pc:graphicFrameChg chg="mod">
          <ac:chgData name="Jurre Kamphorst" userId="ea5a6d19-7a1a-404d-92c1-711466574960" providerId="ADAL" clId="{FF8C04DF-1CD5-497C-8C6B-F97E6150A02D}" dt="2024-05-09T18:01:55.253" v="38" actId="1076"/>
          <ac:graphicFrameMkLst>
            <pc:docMk/>
            <pc:sldMk cId="2576429967" sldId="256"/>
            <ac:graphicFrameMk id="6" creationId="{6708EA20-EE9C-0519-F8FC-5CA6DC0698D3}"/>
          </ac:graphicFrameMkLst>
        </pc:graphicFrameChg>
        <pc:graphicFrameChg chg="mod">
          <ac:chgData name="Jurre Kamphorst" userId="ea5a6d19-7a1a-404d-92c1-711466574960" providerId="ADAL" clId="{FF8C04DF-1CD5-497C-8C6B-F97E6150A02D}" dt="2024-05-09T18:01:55.253" v="38" actId="1076"/>
          <ac:graphicFrameMkLst>
            <pc:docMk/>
            <pc:sldMk cId="2576429967" sldId="256"/>
            <ac:graphicFrameMk id="8" creationId="{D55106A4-5565-2ECA-A9D0-D348A3DB1912}"/>
          </ac:graphicFrameMkLst>
        </pc:graphicFrameChg>
        <pc:graphicFrameChg chg="mod">
          <ac:chgData name="Jurre Kamphorst" userId="ea5a6d19-7a1a-404d-92c1-711466574960" providerId="ADAL" clId="{FF8C04DF-1CD5-497C-8C6B-F97E6150A02D}" dt="2024-05-09T18:01:55.253" v="38" actId="1076"/>
          <ac:graphicFrameMkLst>
            <pc:docMk/>
            <pc:sldMk cId="2576429967" sldId="256"/>
            <ac:graphicFrameMk id="9" creationId="{BCEE585D-B964-A4E1-A649-DB347AD4B9FE}"/>
          </ac:graphicFrameMkLst>
        </pc:graphicFrameChg>
        <pc:graphicFrameChg chg="mod">
          <ac:chgData name="Jurre Kamphorst" userId="ea5a6d19-7a1a-404d-92c1-711466574960" providerId="ADAL" clId="{FF8C04DF-1CD5-497C-8C6B-F97E6150A02D}" dt="2024-05-09T18:01:55.253" v="38" actId="1076"/>
          <ac:graphicFrameMkLst>
            <pc:docMk/>
            <pc:sldMk cId="2576429967" sldId="256"/>
            <ac:graphicFrameMk id="15" creationId="{C521C839-9306-4228-E40F-96A3DFA5CF5F}"/>
          </ac:graphicFrameMkLst>
        </pc:graphicFrameChg>
        <pc:picChg chg="mod">
          <ac:chgData name="Jurre Kamphorst" userId="ea5a6d19-7a1a-404d-92c1-711466574960" providerId="ADAL" clId="{FF8C04DF-1CD5-497C-8C6B-F97E6150A02D}" dt="2024-05-09T18:02:07.610" v="41" actId="1076"/>
          <ac:picMkLst>
            <pc:docMk/>
            <pc:sldMk cId="2576429967" sldId="256"/>
            <ac:picMk id="18" creationId="{142CDCD9-D0A9-112D-C97D-EB4BF9253DFE}"/>
          </ac:picMkLst>
        </pc:picChg>
      </pc:sldChg>
      <pc:sldChg chg="addSp modSp mod">
        <pc:chgData name="Jurre Kamphorst" userId="ea5a6d19-7a1a-404d-92c1-711466574960" providerId="ADAL" clId="{FF8C04DF-1CD5-497C-8C6B-F97E6150A02D}" dt="2024-05-09T18:00:15.249" v="26" actId="20577"/>
        <pc:sldMkLst>
          <pc:docMk/>
          <pc:sldMk cId="1513836502" sldId="257"/>
        </pc:sldMkLst>
        <pc:spChg chg="mod">
          <ac:chgData name="Jurre Kamphorst" userId="ea5a6d19-7a1a-404d-92c1-711466574960" providerId="ADAL" clId="{FF8C04DF-1CD5-497C-8C6B-F97E6150A02D}" dt="2024-05-09T17:59:09.604" v="7" actId="1076"/>
          <ac:spMkLst>
            <pc:docMk/>
            <pc:sldMk cId="1513836502" sldId="257"/>
            <ac:spMk id="2" creationId="{23178C4D-B3E8-0972-3C3E-97795B3FAE5A}"/>
          </ac:spMkLst>
        </pc:spChg>
        <pc:spChg chg="mod">
          <ac:chgData name="Jurre Kamphorst" userId="ea5a6d19-7a1a-404d-92c1-711466574960" providerId="ADAL" clId="{FF8C04DF-1CD5-497C-8C6B-F97E6150A02D}" dt="2024-05-09T17:59:09.604" v="7" actId="1076"/>
          <ac:spMkLst>
            <pc:docMk/>
            <pc:sldMk cId="1513836502" sldId="257"/>
            <ac:spMk id="3" creationId="{6663A3A0-76F2-0D7C-2966-64BE4EB0C795}"/>
          </ac:spMkLst>
        </pc:spChg>
        <pc:spChg chg="mod">
          <ac:chgData name="Jurre Kamphorst" userId="ea5a6d19-7a1a-404d-92c1-711466574960" providerId="ADAL" clId="{FF8C04DF-1CD5-497C-8C6B-F97E6150A02D}" dt="2024-05-09T17:59:09.604" v="7" actId="1076"/>
          <ac:spMkLst>
            <pc:docMk/>
            <pc:sldMk cId="1513836502" sldId="257"/>
            <ac:spMk id="4" creationId="{05D71F9E-B5D0-675D-A974-D7FBFCF97FC6}"/>
          </ac:spMkLst>
        </pc:spChg>
        <pc:spChg chg="mod">
          <ac:chgData name="Jurre Kamphorst" userId="ea5a6d19-7a1a-404d-92c1-711466574960" providerId="ADAL" clId="{FF8C04DF-1CD5-497C-8C6B-F97E6150A02D}" dt="2024-05-09T17:59:09.604" v="7" actId="1076"/>
          <ac:spMkLst>
            <pc:docMk/>
            <pc:sldMk cId="1513836502" sldId="257"/>
            <ac:spMk id="11" creationId="{707FA75D-51F5-4DA9-13BA-6D49DE9EDC59}"/>
          </ac:spMkLst>
        </pc:spChg>
        <pc:spChg chg="mod">
          <ac:chgData name="Jurre Kamphorst" userId="ea5a6d19-7a1a-404d-92c1-711466574960" providerId="ADAL" clId="{FF8C04DF-1CD5-497C-8C6B-F97E6150A02D}" dt="2024-05-09T17:59:09.604" v="7" actId="1076"/>
          <ac:spMkLst>
            <pc:docMk/>
            <pc:sldMk cId="1513836502" sldId="257"/>
            <ac:spMk id="12" creationId="{795E2299-F25A-524C-20B4-04281C9922DE}"/>
          </ac:spMkLst>
        </pc:spChg>
        <pc:spChg chg="mod">
          <ac:chgData name="Jurre Kamphorst" userId="ea5a6d19-7a1a-404d-92c1-711466574960" providerId="ADAL" clId="{FF8C04DF-1CD5-497C-8C6B-F97E6150A02D}" dt="2024-05-09T17:59:09.604" v="7" actId="1076"/>
          <ac:spMkLst>
            <pc:docMk/>
            <pc:sldMk cId="1513836502" sldId="257"/>
            <ac:spMk id="13" creationId="{0976A6DC-434F-ABDF-B33E-93437D308A97}"/>
          </ac:spMkLst>
        </pc:spChg>
        <pc:spChg chg="mod">
          <ac:chgData name="Jurre Kamphorst" userId="ea5a6d19-7a1a-404d-92c1-711466574960" providerId="ADAL" clId="{FF8C04DF-1CD5-497C-8C6B-F97E6150A02D}" dt="2024-05-09T17:59:09.604" v="7" actId="1076"/>
          <ac:spMkLst>
            <pc:docMk/>
            <pc:sldMk cId="1513836502" sldId="257"/>
            <ac:spMk id="14" creationId="{8372945B-B951-EB93-B514-376187D7AFC7}"/>
          </ac:spMkLst>
        </pc:spChg>
        <pc:spChg chg="mod">
          <ac:chgData name="Jurre Kamphorst" userId="ea5a6d19-7a1a-404d-92c1-711466574960" providerId="ADAL" clId="{FF8C04DF-1CD5-497C-8C6B-F97E6150A02D}" dt="2024-05-09T17:59:09.604" v="7" actId="1076"/>
          <ac:spMkLst>
            <pc:docMk/>
            <pc:sldMk cId="1513836502" sldId="257"/>
            <ac:spMk id="15" creationId="{FEDC7601-69C5-C220-8BDB-3D333F257196}"/>
          </ac:spMkLst>
        </pc:spChg>
        <pc:spChg chg="mod">
          <ac:chgData name="Jurre Kamphorst" userId="ea5a6d19-7a1a-404d-92c1-711466574960" providerId="ADAL" clId="{FF8C04DF-1CD5-497C-8C6B-F97E6150A02D}" dt="2024-05-09T17:59:09.604" v="7" actId="1076"/>
          <ac:spMkLst>
            <pc:docMk/>
            <pc:sldMk cId="1513836502" sldId="257"/>
            <ac:spMk id="16" creationId="{FBB68053-39C8-EC22-174B-71DDDCE5E02F}"/>
          </ac:spMkLst>
        </pc:spChg>
        <pc:spChg chg="mod">
          <ac:chgData name="Jurre Kamphorst" userId="ea5a6d19-7a1a-404d-92c1-711466574960" providerId="ADAL" clId="{FF8C04DF-1CD5-497C-8C6B-F97E6150A02D}" dt="2024-05-09T17:59:09.604" v="7" actId="1076"/>
          <ac:spMkLst>
            <pc:docMk/>
            <pc:sldMk cId="1513836502" sldId="257"/>
            <ac:spMk id="17" creationId="{112571CC-5B9A-83EB-5C2F-98A17578FB4D}"/>
          </ac:spMkLst>
        </pc:spChg>
        <pc:spChg chg="mod">
          <ac:chgData name="Jurre Kamphorst" userId="ea5a6d19-7a1a-404d-92c1-711466574960" providerId="ADAL" clId="{FF8C04DF-1CD5-497C-8C6B-F97E6150A02D}" dt="2024-05-09T17:59:50.002" v="17" actId="1076"/>
          <ac:spMkLst>
            <pc:docMk/>
            <pc:sldMk cId="1513836502" sldId="257"/>
            <ac:spMk id="18" creationId="{7AC47DDF-5484-8915-5478-6C7E91F0D8E3}"/>
          </ac:spMkLst>
        </pc:spChg>
        <pc:spChg chg="mod">
          <ac:chgData name="Jurre Kamphorst" userId="ea5a6d19-7a1a-404d-92c1-711466574960" providerId="ADAL" clId="{FF8C04DF-1CD5-497C-8C6B-F97E6150A02D}" dt="2024-05-09T17:59:09.604" v="7" actId="1076"/>
          <ac:spMkLst>
            <pc:docMk/>
            <pc:sldMk cId="1513836502" sldId="257"/>
            <ac:spMk id="19" creationId="{56B0C2D8-0896-4A4D-40DF-97DEE22C7C69}"/>
          </ac:spMkLst>
        </pc:spChg>
        <pc:spChg chg="mod">
          <ac:chgData name="Jurre Kamphorst" userId="ea5a6d19-7a1a-404d-92c1-711466574960" providerId="ADAL" clId="{FF8C04DF-1CD5-497C-8C6B-F97E6150A02D}" dt="2024-05-09T17:59:09.604" v="7" actId="1076"/>
          <ac:spMkLst>
            <pc:docMk/>
            <pc:sldMk cId="1513836502" sldId="257"/>
            <ac:spMk id="20" creationId="{2206C8CF-63CC-DD81-F21D-E4652D3B8719}"/>
          </ac:spMkLst>
        </pc:spChg>
        <pc:spChg chg="mod">
          <ac:chgData name="Jurre Kamphorst" userId="ea5a6d19-7a1a-404d-92c1-711466574960" providerId="ADAL" clId="{FF8C04DF-1CD5-497C-8C6B-F97E6150A02D}" dt="2024-05-09T17:59:09.604" v="7" actId="1076"/>
          <ac:spMkLst>
            <pc:docMk/>
            <pc:sldMk cId="1513836502" sldId="257"/>
            <ac:spMk id="21" creationId="{25824043-C488-F444-2EDF-CDFC8E5F2E2E}"/>
          </ac:spMkLst>
        </pc:spChg>
        <pc:spChg chg="mod">
          <ac:chgData name="Jurre Kamphorst" userId="ea5a6d19-7a1a-404d-92c1-711466574960" providerId="ADAL" clId="{FF8C04DF-1CD5-497C-8C6B-F97E6150A02D}" dt="2024-05-09T17:59:09.604" v="7" actId="1076"/>
          <ac:spMkLst>
            <pc:docMk/>
            <pc:sldMk cId="1513836502" sldId="257"/>
            <ac:spMk id="22" creationId="{9C92F6D7-A62B-302D-3378-4DC04F3A4E4A}"/>
          </ac:spMkLst>
        </pc:spChg>
        <pc:spChg chg="mod">
          <ac:chgData name="Jurre Kamphorst" userId="ea5a6d19-7a1a-404d-92c1-711466574960" providerId="ADAL" clId="{FF8C04DF-1CD5-497C-8C6B-F97E6150A02D}" dt="2024-05-09T17:59:09.604" v="7" actId="1076"/>
          <ac:spMkLst>
            <pc:docMk/>
            <pc:sldMk cId="1513836502" sldId="257"/>
            <ac:spMk id="23" creationId="{76B8971D-809F-9B22-8E20-C7B637848CF0}"/>
          </ac:spMkLst>
        </pc:spChg>
        <pc:spChg chg="mod">
          <ac:chgData name="Jurre Kamphorst" userId="ea5a6d19-7a1a-404d-92c1-711466574960" providerId="ADAL" clId="{FF8C04DF-1CD5-497C-8C6B-F97E6150A02D}" dt="2024-05-09T17:59:09.604" v="7" actId="1076"/>
          <ac:spMkLst>
            <pc:docMk/>
            <pc:sldMk cId="1513836502" sldId="257"/>
            <ac:spMk id="24" creationId="{AC3A98BB-AD6A-FE79-1956-01195F27C969}"/>
          </ac:spMkLst>
        </pc:spChg>
        <pc:spChg chg="mod">
          <ac:chgData name="Jurre Kamphorst" userId="ea5a6d19-7a1a-404d-92c1-711466574960" providerId="ADAL" clId="{FF8C04DF-1CD5-497C-8C6B-F97E6150A02D}" dt="2024-05-09T17:59:09.604" v="7" actId="1076"/>
          <ac:spMkLst>
            <pc:docMk/>
            <pc:sldMk cId="1513836502" sldId="257"/>
            <ac:spMk id="25" creationId="{8DDDC64A-B184-8DBA-7081-961B56236075}"/>
          </ac:spMkLst>
        </pc:spChg>
        <pc:spChg chg="mod">
          <ac:chgData name="Jurre Kamphorst" userId="ea5a6d19-7a1a-404d-92c1-711466574960" providerId="ADAL" clId="{FF8C04DF-1CD5-497C-8C6B-F97E6150A02D}" dt="2024-05-09T17:59:09.604" v="7" actId="1076"/>
          <ac:spMkLst>
            <pc:docMk/>
            <pc:sldMk cId="1513836502" sldId="257"/>
            <ac:spMk id="26" creationId="{371D19EE-1274-C98E-F470-99C29AD29DDF}"/>
          </ac:spMkLst>
        </pc:spChg>
        <pc:spChg chg="mod">
          <ac:chgData name="Jurre Kamphorst" userId="ea5a6d19-7a1a-404d-92c1-711466574960" providerId="ADAL" clId="{FF8C04DF-1CD5-497C-8C6B-F97E6150A02D}" dt="2024-05-09T17:59:09.604" v="7" actId="1076"/>
          <ac:spMkLst>
            <pc:docMk/>
            <pc:sldMk cId="1513836502" sldId="257"/>
            <ac:spMk id="27" creationId="{E5365B10-B19F-EB22-7AF3-F278D3361946}"/>
          </ac:spMkLst>
        </pc:spChg>
        <pc:spChg chg="mod">
          <ac:chgData name="Jurre Kamphorst" userId="ea5a6d19-7a1a-404d-92c1-711466574960" providerId="ADAL" clId="{FF8C04DF-1CD5-497C-8C6B-F97E6150A02D}" dt="2024-05-09T17:59:09.604" v="7" actId="1076"/>
          <ac:spMkLst>
            <pc:docMk/>
            <pc:sldMk cId="1513836502" sldId="257"/>
            <ac:spMk id="28" creationId="{F160C26A-389B-D034-A5E8-8B13A79F4A17}"/>
          </ac:spMkLst>
        </pc:spChg>
        <pc:spChg chg="mod">
          <ac:chgData name="Jurre Kamphorst" userId="ea5a6d19-7a1a-404d-92c1-711466574960" providerId="ADAL" clId="{FF8C04DF-1CD5-497C-8C6B-F97E6150A02D}" dt="2024-05-09T17:59:09.604" v="7" actId="1076"/>
          <ac:spMkLst>
            <pc:docMk/>
            <pc:sldMk cId="1513836502" sldId="257"/>
            <ac:spMk id="29" creationId="{1A6EA7AD-F480-7C11-11BB-E91B3626149D}"/>
          </ac:spMkLst>
        </pc:spChg>
        <pc:spChg chg="mod">
          <ac:chgData name="Jurre Kamphorst" userId="ea5a6d19-7a1a-404d-92c1-711466574960" providerId="ADAL" clId="{FF8C04DF-1CD5-497C-8C6B-F97E6150A02D}" dt="2024-05-09T17:59:09.604" v="7" actId="1076"/>
          <ac:spMkLst>
            <pc:docMk/>
            <pc:sldMk cId="1513836502" sldId="257"/>
            <ac:spMk id="30" creationId="{7E17D839-3216-58AA-F928-C4B4254C2313}"/>
          </ac:spMkLst>
        </pc:spChg>
        <pc:spChg chg="mod">
          <ac:chgData name="Jurre Kamphorst" userId="ea5a6d19-7a1a-404d-92c1-711466574960" providerId="ADAL" clId="{FF8C04DF-1CD5-497C-8C6B-F97E6150A02D}" dt="2024-05-09T17:59:09.604" v="7" actId="1076"/>
          <ac:spMkLst>
            <pc:docMk/>
            <pc:sldMk cId="1513836502" sldId="257"/>
            <ac:spMk id="31" creationId="{CBCDD704-3512-11B0-0E89-6B24DE0EF0CB}"/>
          </ac:spMkLst>
        </pc:spChg>
        <pc:spChg chg="mod">
          <ac:chgData name="Jurre Kamphorst" userId="ea5a6d19-7a1a-404d-92c1-711466574960" providerId="ADAL" clId="{FF8C04DF-1CD5-497C-8C6B-F97E6150A02D}" dt="2024-05-09T17:59:09.604" v="7" actId="1076"/>
          <ac:spMkLst>
            <pc:docMk/>
            <pc:sldMk cId="1513836502" sldId="257"/>
            <ac:spMk id="32" creationId="{5CC48951-609F-0355-F717-D83AA823E981}"/>
          </ac:spMkLst>
        </pc:spChg>
        <pc:spChg chg="mod">
          <ac:chgData name="Jurre Kamphorst" userId="ea5a6d19-7a1a-404d-92c1-711466574960" providerId="ADAL" clId="{FF8C04DF-1CD5-497C-8C6B-F97E6150A02D}" dt="2024-05-09T17:59:09.604" v="7" actId="1076"/>
          <ac:spMkLst>
            <pc:docMk/>
            <pc:sldMk cId="1513836502" sldId="257"/>
            <ac:spMk id="33" creationId="{3E4AA37B-335F-D581-968E-44EDD695E211}"/>
          </ac:spMkLst>
        </pc:spChg>
        <pc:spChg chg="mod">
          <ac:chgData name="Jurre Kamphorst" userId="ea5a6d19-7a1a-404d-92c1-711466574960" providerId="ADAL" clId="{FF8C04DF-1CD5-497C-8C6B-F97E6150A02D}" dt="2024-05-09T17:59:09.604" v="7" actId="1076"/>
          <ac:spMkLst>
            <pc:docMk/>
            <pc:sldMk cId="1513836502" sldId="257"/>
            <ac:spMk id="34" creationId="{0B5A5E84-121C-878D-4FBD-01C56E9FB6C5}"/>
          </ac:spMkLst>
        </pc:spChg>
        <pc:spChg chg="mod">
          <ac:chgData name="Jurre Kamphorst" userId="ea5a6d19-7a1a-404d-92c1-711466574960" providerId="ADAL" clId="{FF8C04DF-1CD5-497C-8C6B-F97E6150A02D}" dt="2024-05-09T17:59:09.604" v="7" actId="1076"/>
          <ac:spMkLst>
            <pc:docMk/>
            <pc:sldMk cId="1513836502" sldId="257"/>
            <ac:spMk id="35" creationId="{2C8DA58C-1FEB-46E6-33BB-0527ECCF1B3B}"/>
          </ac:spMkLst>
        </pc:spChg>
        <pc:spChg chg="mod">
          <ac:chgData name="Jurre Kamphorst" userId="ea5a6d19-7a1a-404d-92c1-711466574960" providerId="ADAL" clId="{FF8C04DF-1CD5-497C-8C6B-F97E6150A02D}" dt="2024-05-09T17:59:09.604" v="7" actId="1076"/>
          <ac:spMkLst>
            <pc:docMk/>
            <pc:sldMk cId="1513836502" sldId="257"/>
            <ac:spMk id="36" creationId="{9D536413-47A7-40F6-9E6B-3E19BA6C44AC}"/>
          </ac:spMkLst>
        </pc:spChg>
        <pc:spChg chg="mod">
          <ac:chgData name="Jurre Kamphorst" userId="ea5a6d19-7a1a-404d-92c1-711466574960" providerId="ADAL" clId="{FF8C04DF-1CD5-497C-8C6B-F97E6150A02D}" dt="2024-05-09T17:59:09.604" v="7" actId="1076"/>
          <ac:spMkLst>
            <pc:docMk/>
            <pc:sldMk cId="1513836502" sldId="257"/>
            <ac:spMk id="37" creationId="{C37DC5DE-3C58-D922-17B0-C0D15B906CDC}"/>
          </ac:spMkLst>
        </pc:spChg>
        <pc:spChg chg="mod">
          <ac:chgData name="Jurre Kamphorst" userId="ea5a6d19-7a1a-404d-92c1-711466574960" providerId="ADAL" clId="{FF8C04DF-1CD5-497C-8C6B-F97E6150A02D}" dt="2024-05-09T17:59:09.604" v="7" actId="1076"/>
          <ac:spMkLst>
            <pc:docMk/>
            <pc:sldMk cId="1513836502" sldId="257"/>
            <ac:spMk id="38" creationId="{6886DF27-9E5D-B687-792C-872E2ED6CBB9}"/>
          </ac:spMkLst>
        </pc:spChg>
        <pc:spChg chg="mod">
          <ac:chgData name="Jurre Kamphorst" userId="ea5a6d19-7a1a-404d-92c1-711466574960" providerId="ADAL" clId="{FF8C04DF-1CD5-497C-8C6B-F97E6150A02D}" dt="2024-05-09T17:59:09.604" v="7" actId="1076"/>
          <ac:spMkLst>
            <pc:docMk/>
            <pc:sldMk cId="1513836502" sldId="257"/>
            <ac:spMk id="39" creationId="{F84C9252-40E9-D4EC-AB78-2510F2ECA93F}"/>
          </ac:spMkLst>
        </pc:spChg>
        <pc:spChg chg="mod">
          <ac:chgData name="Jurre Kamphorst" userId="ea5a6d19-7a1a-404d-92c1-711466574960" providerId="ADAL" clId="{FF8C04DF-1CD5-497C-8C6B-F97E6150A02D}" dt="2024-05-09T17:59:09.604" v="7" actId="1076"/>
          <ac:spMkLst>
            <pc:docMk/>
            <pc:sldMk cId="1513836502" sldId="257"/>
            <ac:spMk id="40" creationId="{1CC3B4FC-150B-AE9F-36A2-D6E4F07380C8}"/>
          </ac:spMkLst>
        </pc:spChg>
        <pc:spChg chg="mod">
          <ac:chgData name="Jurre Kamphorst" userId="ea5a6d19-7a1a-404d-92c1-711466574960" providerId="ADAL" clId="{FF8C04DF-1CD5-497C-8C6B-F97E6150A02D}" dt="2024-05-09T17:59:09.604" v="7" actId="1076"/>
          <ac:spMkLst>
            <pc:docMk/>
            <pc:sldMk cId="1513836502" sldId="257"/>
            <ac:spMk id="41" creationId="{B6ECD60F-9FB1-334A-26ED-85E4D42FDEEA}"/>
          </ac:spMkLst>
        </pc:spChg>
        <pc:spChg chg="mod">
          <ac:chgData name="Jurre Kamphorst" userId="ea5a6d19-7a1a-404d-92c1-711466574960" providerId="ADAL" clId="{FF8C04DF-1CD5-497C-8C6B-F97E6150A02D}" dt="2024-05-09T17:59:09.604" v="7" actId="1076"/>
          <ac:spMkLst>
            <pc:docMk/>
            <pc:sldMk cId="1513836502" sldId="257"/>
            <ac:spMk id="42" creationId="{C6182264-ACA9-9FE7-E092-96E3038FFA4B}"/>
          </ac:spMkLst>
        </pc:spChg>
        <pc:spChg chg="mod">
          <ac:chgData name="Jurre Kamphorst" userId="ea5a6d19-7a1a-404d-92c1-711466574960" providerId="ADAL" clId="{FF8C04DF-1CD5-497C-8C6B-F97E6150A02D}" dt="2024-05-09T17:59:09.604" v="7" actId="1076"/>
          <ac:spMkLst>
            <pc:docMk/>
            <pc:sldMk cId="1513836502" sldId="257"/>
            <ac:spMk id="43" creationId="{67AA7E1B-DD5F-3D1F-4986-5BB01A9DCCB6}"/>
          </ac:spMkLst>
        </pc:spChg>
        <pc:spChg chg="mod">
          <ac:chgData name="Jurre Kamphorst" userId="ea5a6d19-7a1a-404d-92c1-711466574960" providerId="ADAL" clId="{FF8C04DF-1CD5-497C-8C6B-F97E6150A02D}" dt="2024-05-09T17:59:09.604" v="7" actId="1076"/>
          <ac:spMkLst>
            <pc:docMk/>
            <pc:sldMk cId="1513836502" sldId="257"/>
            <ac:spMk id="44" creationId="{BB9F9508-D1C0-228A-6900-3A62E9B34746}"/>
          </ac:spMkLst>
        </pc:spChg>
        <pc:spChg chg="mod">
          <ac:chgData name="Jurre Kamphorst" userId="ea5a6d19-7a1a-404d-92c1-711466574960" providerId="ADAL" clId="{FF8C04DF-1CD5-497C-8C6B-F97E6150A02D}" dt="2024-05-09T17:59:09.604" v="7" actId="1076"/>
          <ac:spMkLst>
            <pc:docMk/>
            <pc:sldMk cId="1513836502" sldId="257"/>
            <ac:spMk id="45" creationId="{9FB3F477-B8B5-4862-0969-6D60FD77BD35}"/>
          </ac:spMkLst>
        </pc:spChg>
        <pc:spChg chg="mod">
          <ac:chgData name="Jurre Kamphorst" userId="ea5a6d19-7a1a-404d-92c1-711466574960" providerId="ADAL" clId="{FF8C04DF-1CD5-497C-8C6B-F97E6150A02D}" dt="2024-05-09T17:59:09.604" v="7" actId="1076"/>
          <ac:spMkLst>
            <pc:docMk/>
            <pc:sldMk cId="1513836502" sldId="257"/>
            <ac:spMk id="46" creationId="{17DA22EE-2898-393E-6A96-54F92CAE588B}"/>
          </ac:spMkLst>
        </pc:spChg>
        <pc:spChg chg="mod">
          <ac:chgData name="Jurre Kamphorst" userId="ea5a6d19-7a1a-404d-92c1-711466574960" providerId="ADAL" clId="{FF8C04DF-1CD5-497C-8C6B-F97E6150A02D}" dt="2024-05-09T17:59:09.604" v="7" actId="1076"/>
          <ac:spMkLst>
            <pc:docMk/>
            <pc:sldMk cId="1513836502" sldId="257"/>
            <ac:spMk id="47" creationId="{95E1A0AF-2B01-DB92-2743-EB8744AA60C5}"/>
          </ac:spMkLst>
        </pc:spChg>
        <pc:spChg chg="mod">
          <ac:chgData name="Jurre Kamphorst" userId="ea5a6d19-7a1a-404d-92c1-711466574960" providerId="ADAL" clId="{FF8C04DF-1CD5-497C-8C6B-F97E6150A02D}" dt="2024-05-09T17:59:09.604" v="7" actId="1076"/>
          <ac:spMkLst>
            <pc:docMk/>
            <pc:sldMk cId="1513836502" sldId="257"/>
            <ac:spMk id="48" creationId="{06FF1907-F78C-29A8-EFF8-B366E4EA7805}"/>
          </ac:spMkLst>
        </pc:spChg>
        <pc:spChg chg="mod">
          <ac:chgData name="Jurre Kamphorst" userId="ea5a6d19-7a1a-404d-92c1-711466574960" providerId="ADAL" clId="{FF8C04DF-1CD5-497C-8C6B-F97E6150A02D}" dt="2024-05-09T17:59:09.604" v="7" actId="1076"/>
          <ac:spMkLst>
            <pc:docMk/>
            <pc:sldMk cId="1513836502" sldId="257"/>
            <ac:spMk id="49" creationId="{C281BE37-5B8C-3843-F9B1-F0A7ACD60698}"/>
          </ac:spMkLst>
        </pc:spChg>
        <pc:spChg chg="mod">
          <ac:chgData name="Jurre Kamphorst" userId="ea5a6d19-7a1a-404d-92c1-711466574960" providerId="ADAL" clId="{FF8C04DF-1CD5-497C-8C6B-F97E6150A02D}" dt="2024-05-09T17:59:09.604" v="7" actId="1076"/>
          <ac:spMkLst>
            <pc:docMk/>
            <pc:sldMk cId="1513836502" sldId="257"/>
            <ac:spMk id="50" creationId="{38AD9FFB-DC61-09B8-B182-5550C0F08BBD}"/>
          </ac:spMkLst>
        </pc:spChg>
        <pc:spChg chg="mod">
          <ac:chgData name="Jurre Kamphorst" userId="ea5a6d19-7a1a-404d-92c1-711466574960" providerId="ADAL" clId="{FF8C04DF-1CD5-497C-8C6B-F97E6150A02D}" dt="2024-05-09T17:59:09.604" v="7" actId="1076"/>
          <ac:spMkLst>
            <pc:docMk/>
            <pc:sldMk cId="1513836502" sldId="257"/>
            <ac:spMk id="51" creationId="{B4F956EC-92E9-EBB1-04BF-C1112D014113}"/>
          </ac:spMkLst>
        </pc:spChg>
        <pc:spChg chg="add mod">
          <ac:chgData name="Jurre Kamphorst" userId="ea5a6d19-7a1a-404d-92c1-711466574960" providerId="ADAL" clId="{FF8C04DF-1CD5-497C-8C6B-F97E6150A02D}" dt="2024-05-09T18:00:15.249" v="26" actId="20577"/>
          <ac:spMkLst>
            <pc:docMk/>
            <pc:sldMk cId="1513836502" sldId="257"/>
            <ac:spMk id="52" creationId="{2E55F72E-53F1-D20B-C3BE-45C5CB7DD733}"/>
          </ac:spMkLst>
        </pc:spChg>
        <pc:picChg chg="mod">
          <ac:chgData name="Jurre Kamphorst" userId="ea5a6d19-7a1a-404d-92c1-711466574960" providerId="ADAL" clId="{FF8C04DF-1CD5-497C-8C6B-F97E6150A02D}" dt="2024-05-09T17:59:09.604" v="7" actId="1076"/>
          <ac:picMkLst>
            <pc:docMk/>
            <pc:sldMk cId="1513836502" sldId="257"/>
            <ac:picMk id="9" creationId="{44CC0774-80FF-3536-F886-04E7BE147407}"/>
          </ac:picMkLst>
        </pc:picChg>
        <pc:picChg chg="mod">
          <ac:chgData name="Jurre Kamphorst" userId="ea5a6d19-7a1a-404d-92c1-711466574960" providerId="ADAL" clId="{FF8C04DF-1CD5-497C-8C6B-F97E6150A02D}" dt="2024-05-09T17:59:09.604" v="7" actId="1076"/>
          <ac:picMkLst>
            <pc:docMk/>
            <pc:sldMk cId="1513836502" sldId="257"/>
            <ac:picMk id="10" creationId="{E0DF2F7C-8369-9D76-C6FE-899597A3FECD}"/>
          </ac:picMkLst>
        </pc:picChg>
      </pc:sldChg>
      <pc:sldChg chg="addSp delSp modSp mod">
        <pc:chgData name="Jurre Kamphorst" userId="ea5a6d19-7a1a-404d-92c1-711466574960" providerId="ADAL" clId="{FF8C04DF-1CD5-497C-8C6B-F97E6150A02D}" dt="2024-05-09T18:06:33.669" v="94" actId="1076"/>
        <pc:sldMkLst>
          <pc:docMk/>
          <pc:sldMk cId="1558932368" sldId="258"/>
        </pc:sldMkLst>
        <pc:spChg chg="mod">
          <ac:chgData name="Jurre Kamphorst" userId="ea5a6d19-7a1a-404d-92c1-711466574960" providerId="ADAL" clId="{FF8C04DF-1CD5-497C-8C6B-F97E6150A02D}" dt="2024-05-09T18:04:20.162" v="69" actId="1076"/>
          <ac:spMkLst>
            <pc:docMk/>
            <pc:sldMk cId="1558932368" sldId="258"/>
            <ac:spMk id="2" creationId="{C3D943B9-5C70-16E8-FDB1-53B6DA96A743}"/>
          </ac:spMkLst>
        </pc:spChg>
        <pc:spChg chg="mod">
          <ac:chgData name="Jurre Kamphorst" userId="ea5a6d19-7a1a-404d-92c1-711466574960" providerId="ADAL" clId="{FF8C04DF-1CD5-497C-8C6B-F97E6150A02D}" dt="2024-05-09T17:17:52.942" v="6" actId="20577"/>
          <ac:spMkLst>
            <pc:docMk/>
            <pc:sldMk cId="1558932368" sldId="258"/>
            <ac:spMk id="4" creationId="{D96AF1ED-85D6-5B62-F40A-E3A2582E20AC}"/>
          </ac:spMkLst>
        </pc:spChg>
        <pc:spChg chg="mod">
          <ac:chgData name="Jurre Kamphorst" userId="ea5a6d19-7a1a-404d-92c1-711466574960" providerId="ADAL" clId="{FF8C04DF-1CD5-497C-8C6B-F97E6150A02D}" dt="2024-05-09T18:04:15.218" v="68" actId="1076"/>
          <ac:spMkLst>
            <pc:docMk/>
            <pc:sldMk cId="1558932368" sldId="258"/>
            <ac:spMk id="5" creationId="{1AD1843E-78C2-717E-46C9-2090D89968C2}"/>
          </ac:spMkLst>
        </pc:spChg>
        <pc:spChg chg="add del mod">
          <ac:chgData name="Jurre Kamphorst" userId="ea5a6d19-7a1a-404d-92c1-711466574960" providerId="ADAL" clId="{FF8C04DF-1CD5-497C-8C6B-F97E6150A02D}" dt="2024-05-09T18:03:43.889" v="60" actId="478"/>
          <ac:spMkLst>
            <pc:docMk/>
            <pc:sldMk cId="1558932368" sldId="258"/>
            <ac:spMk id="7" creationId="{1CA429EB-356E-7A04-84D0-EBEA7980114E}"/>
          </ac:spMkLst>
        </pc:spChg>
        <pc:spChg chg="add mod">
          <ac:chgData name="Jurre Kamphorst" userId="ea5a6d19-7a1a-404d-92c1-711466574960" providerId="ADAL" clId="{FF8C04DF-1CD5-497C-8C6B-F97E6150A02D}" dt="2024-05-09T18:05:16.953" v="82" actId="6549"/>
          <ac:spMkLst>
            <pc:docMk/>
            <pc:sldMk cId="1558932368" sldId="258"/>
            <ac:spMk id="8" creationId="{3E386A09-746C-07E2-C30C-6F36A29DBF17}"/>
          </ac:spMkLst>
        </pc:spChg>
        <pc:spChg chg="add mod">
          <ac:chgData name="Jurre Kamphorst" userId="ea5a6d19-7a1a-404d-92c1-711466574960" providerId="ADAL" clId="{FF8C04DF-1CD5-497C-8C6B-F97E6150A02D}" dt="2024-05-09T18:06:33.669" v="94" actId="1076"/>
          <ac:spMkLst>
            <pc:docMk/>
            <pc:sldMk cId="1558932368" sldId="258"/>
            <ac:spMk id="10" creationId="{8DCF5705-E09B-CEA5-C9D6-BFDDCD877BEB}"/>
          </ac:spMkLst>
        </pc:spChg>
        <pc:graphicFrameChg chg="mod">
          <ac:chgData name="Jurre Kamphorst" userId="ea5a6d19-7a1a-404d-92c1-711466574960" providerId="ADAL" clId="{FF8C04DF-1CD5-497C-8C6B-F97E6150A02D}" dt="2024-05-09T18:04:15.218" v="68" actId="1076"/>
          <ac:graphicFrameMkLst>
            <pc:docMk/>
            <pc:sldMk cId="1558932368" sldId="258"/>
            <ac:graphicFrameMk id="3" creationId="{E5240DA8-BD9D-A1EC-FA81-4F4863242403}"/>
          </ac:graphicFrameMkLst>
        </pc:graphicFrameChg>
        <pc:picChg chg="mod modCrop">
          <ac:chgData name="Jurre Kamphorst" userId="ea5a6d19-7a1a-404d-92c1-711466574960" providerId="ADAL" clId="{FF8C04DF-1CD5-497C-8C6B-F97E6150A02D}" dt="2024-05-09T18:04:47.683" v="74" actId="732"/>
          <ac:picMkLst>
            <pc:docMk/>
            <pc:sldMk cId="1558932368" sldId="258"/>
            <ac:picMk id="6" creationId="{18A5B968-9AAA-512E-3EEF-9BC5A07BF5CA}"/>
          </ac:picMkLst>
        </pc:picChg>
        <pc:picChg chg="add mod modCrop">
          <ac:chgData name="Jurre Kamphorst" userId="ea5a6d19-7a1a-404d-92c1-711466574960" providerId="ADAL" clId="{FF8C04DF-1CD5-497C-8C6B-F97E6150A02D}" dt="2024-05-09T18:05:07.434" v="77" actId="1076"/>
          <ac:picMkLst>
            <pc:docMk/>
            <pc:sldMk cId="1558932368" sldId="258"/>
            <ac:picMk id="9" creationId="{D2585556-E3E7-D425-356C-C1307CFFE92D}"/>
          </ac:picMkLst>
        </pc:picChg>
      </pc:sldChg>
    </pc:docChg>
  </pc:docChgLst>
  <pc:docChgLst>
    <pc:chgData name="Jurre Kamphorst" userId="ea5a6d19-7a1a-404d-92c1-711466574960" providerId="ADAL" clId="{B6032C60-F28A-4293-8B55-FA83C5CA6942}"/>
    <pc:docChg chg="custSel addSld modSld sldOrd">
      <pc:chgData name="Jurre Kamphorst" userId="ea5a6d19-7a1a-404d-92c1-711466574960" providerId="ADAL" clId="{B6032C60-F28A-4293-8B55-FA83C5CA6942}" dt="2024-03-21T18:02:06.551" v="704" actId="1076"/>
      <pc:docMkLst>
        <pc:docMk/>
      </pc:docMkLst>
      <pc:sldChg chg="addSp delSp modSp mod">
        <pc:chgData name="Jurre Kamphorst" userId="ea5a6d19-7a1a-404d-92c1-711466574960" providerId="ADAL" clId="{B6032C60-F28A-4293-8B55-FA83C5CA6942}" dt="2024-03-21T16:46:11.232" v="669" actId="1076"/>
        <pc:sldMkLst>
          <pc:docMk/>
          <pc:sldMk cId="2576429967" sldId="256"/>
        </pc:sldMkLst>
        <pc:spChg chg="del">
          <ac:chgData name="Jurre Kamphorst" userId="ea5a6d19-7a1a-404d-92c1-711466574960" providerId="ADAL" clId="{B6032C60-F28A-4293-8B55-FA83C5CA6942}" dt="2024-03-09T19:44:05.832" v="0" actId="478"/>
          <ac:spMkLst>
            <pc:docMk/>
            <pc:sldMk cId="2576429967" sldId="256"/>
            <ac:spMk id="2" creationId="{37B45687-1040-4AEC-98F7-C1C13089E170}"/>
          </ac:spMkLst>
        </pc:spChg>
        <pc:spChg chg="del">
          <ac:chgData name="Jurre Kamphorst" userId="ea5a6d19-7a1a-404d-92c1-711466574960" providerId="ADAL" clId="{B6032C60-F28A-4293-8B55-FA83C5CA6942}" dt="2024-03-09T19:44:05.832" v="0" actId="478"/>
          <ac:spMkLst>
            <pc:docMk/>
            <pc:sldMk cId="2576429967" sldId="256"/>
            <ac:spMk id="3" creationId="{C920A666-C20A-595A-386C-D81CA29B2D9F}"/>
          </ac:spMkLst>
        </pc:spChg>
        <pc:spChg chg="add mod">
          <ac:chgData name="Jurre Kamphorst" userId="ea5a6d19-7a1a-404d-92c1-711466574960" providerId="ADAL" clId="{B6032C60-F28A-4293-8B55-FA83C5CA6942}" dt="2024-03-14T19:19:58.114" v="372" actId="1076"/>
          <ac:spMkLst>
            <pc:docMk/>
            <pc:sldMk cId="2576429967" sldId="256"/>
            <ac:spMk id="3" creationId="{D639D69B-7D89-A401-C1B1-DCE326262DCF}"/>
          </ac:spMkLst>
        </pc:spChg>
        <pc:spChg chg="add mod">
          <ac:chgData name="Jurre Kamphorst" userId="ea5a6d19-7a1a-404d-92c1-711466574960" providerId="ADAL" clId="{B6032C60-F28A-4293-8B55-FA83C5CA6942}" dt="2024-03-15T19:02:28.789" v="527" actId="20577"/>
          <ac:spMkLst>
            <pc:docMk/>
            <pc:sldMk cId="2576429967" sldId="256"/>
            <ac:spMk id="4" creationId="{70778960-9A41-7EA9-E3B6-3F271E2FA499}"/>
          </ac:spMkLst>
        </pc:spChg>
        <pc:spChg chg="add mod">
          <ac:chgData name="Jurre Kamphorst" userId="ea5a6d19-7a1a-404d-92c1-711466574960" providerId="ADAL" clId="{B6032C60-F28A-4293-8B55-FA83C5CA6942}" dt="2024-03-15T19:18:10.818" v="533" actId="1076"/>
          <ac:spMkLst>
            <pc:docMk/>
            <pc:sldMk cId="2576429967" sldId="256"/>
            <ac:spMk id="7" creationId="{56025FF9-58BC-DE9C-2FBE-FDD2CBE37FB1}"/>
          </ac:spMkLst>
        </pc:spChg>
        <pc:spChg chg="add del mod">
          <ac:chgData name="Jurre Kamphorst" userId="ea5a6d19-7a1a-404d-92c1-711466574960" providerId="ADAL" clId="{B6032C60-F28A-4293-8B55-FA83C5CA6942}" dt="2024-03-14T19:19:52.917" v="371" actId="478"/>
          <ac:spMkLst>
            <pc:docMk/>
            <pc:sldMk cId="2576429967" sldId="256"/>
            <ac:spMk id="9" creationId="{42D57A7F-C81C-4CE1-2DF7-1C170C289B36}"/>
          </ac:spMkLst>
        </pc:spChg>
        <pc:spChg chg="add mod">
          <ac:chgData name="Jurre Kamphorst" userId="ea5a6d19-7a1a-404d-92c1-711466574960" providerId="ADAL" clId="{B6032C60-F28A-4293-8B55-FA83C5CA6942}" dt="2024-03-15T19:18:10.818" v="533" actId="1076"/>
          <ac:spMkLst>
            <pc:docMk/>
            <pc:sldMk cId="2576429967" sldId="256"/>
            <ac:spMk id="10" creationId="{845389DF-4A9C-3AE6-6F89-6232D8BE35DD}"/>
          </ac:spMkLst>
        </pc:spChg>
        <pc:spChg chg="add mod">
          <ac:chgData name="Jurre Kamphorst" userId="ea5a6d19-7a1a-404d-92c1-711466574960" providerId="ADAL" clId="{B6032C60-F28A-4293-8B55-FA83C5CA6942}" dt="2024-03-15T19:18:26.465" v="537" actId="1076"/>
          <ac:spMkLst>
            <pc:docMk/>
            <pc:sldMk cId="2576429967" sldId="256"/>
            <ac:spMk id="11" creationId="{2798851D-ADF4-E294-E38B-F63E1095A837}"/>
          </ac:spMkLst>
        </pc:spChg>
        <pc:spChg chg="add del mod">
          <ac:chgData name="Jurre Kamphorst" userId="ea5a6d19-7a1a-404d-92c1-711466574960" providerId="ADAL" clId="{B6032C60-F28A-4293-8B55-FA83C5CA6942}" dt="2024-03-14T19:19:52.917" v="371" actId="478"/>
          <ac:spMkLst>
            <pc:docMk/>
            <pc:sldMk cId="2576429967" sldId="256"/>
            <ac:spMk id="11" creationId="{6AD4A5F6-DE82-27B8-8DA5-B0F0D18CE034}"/>
          </ac:spMkLst>
        </pc:spChg>
        <pc:spChg chg="add del mod">
          <ac:chgData name="Jurre Kamphorst" userId="ea5a6d19-7a1a-404d-92c1-711466574960" providerId="ADAL" clId="{B6032C60-F28A-4293-8B55-FA83C5CA6942}" dt="2024-03-14T19:19:52.917" v="371" actId="478"/>
          <ac:spMkLst>
            <pc:docMk/>
            <pc:sldMk cId="2576429967" sldId="256"/>
            <ac:spMk id="12" creationId="{39B47B0E-3B63-0E95-1264-C38386F1384A}"/>
          </ac:spMkLst>
        </pc:spChg>
        <pc:spChg chg="add mod">
          <ac:chgData name="Jurre Kamphorst" userId="ea5a6d19-7a1a-404d-92c1-711466574960" providerId="ADAL" clId="{B6032C60-F28A-4293-8B55-FA83C5CA6942}" dt="2024-03-15T19:18:10.818" v="533" actId="1076"/>
          <ac:spMkLst>
            <pc:docMk/>
            <pc:sldMk cId="2576429967" sldId="256"/>
            <ac:spMk id="12" creationId="{946C90A9-EB83-090B-9F03-BF3FB2122CD7}"/>
          </ac:spMkLst>
        </pc:spChg>
        <pc:spChg chg="add mod">
          <ac:chgData name="Jurre Kamphorst" userId="ea5a6d19-7a1a-404d-92c1-711466574960" providerId="ADAL" clId="{B6032C60-F28A-4293-8B55-FA83C5CA6942}" dt="2024-03-15T19:18:10.818" v="533" actId="1076"/>
          <ac:spMkLst>
            <pc:docMk/>
            <pc:sldMk cId="2576429967" sldId="256"/>
            <ac:spMk id="13" creationId="{13BF9BEC-1C17-64BD-A91B-B0E567DAC2D1}"/>
          </ac:spMkLst>
        </pc:spChg>
        <pc:spChg chg="add del mod">
          <ac:chgData name="Jurre Kamphorst" userId="ea5a6d19-7a1a-404d-92c1-711466574960" providerId="ADAL" clId="{B6032C60-F28A-4293-8B55-FA83C5CA6942}" dt="2024-03-14T19:19:52.917" v="371" actId="478"/>
          <ac:spMkLst>
            <pc:docMk/>
            <pc:sldMk cId="2576429967" sldId="256"/>
            <ac:spMk id="13" creationId="{A038AF44-5C05-910D-BE85-01AFF5329CF0}"/>
          </ac:spMkLst>
        </pc:spChg>
        <pc:spChg chg="add mod">
          <ac:chgData name="Jurre Kamphorst" userId="ea5a6d19-7a1a-404d-92c1-711466574960" providerId="ADAL" clId="{B6032C60-F28A-4293-8B55-FA83C5CA6942}" dt="2024-03-15T19:19:19.896" v="541" actId="20577"/>
          <ac:spMkLst>
            <pc:docMk/>
            <pc:sldMk cId="2576429967" sldId="256"/>
            <ac:spMk id="14" creationId="{B696EEB4-AE4E-F5F7-3285-54B7135A6835}"/>
          </ac:spMkLst>
        </pc:spChg>
        <pc:spChg chg="add del mod">
          <ac:chgData name="Jurre Kamphorst" userId="ea5a6d19-7a1a-404d-92c1-711466574960" providerId="ADAL" clId="{B6032C60-F28A-4293-8B55-FA83C5CA6942}" dt="2024-03-14T19:19:52.917" v="371" actId="478"/>
          <ac:spMkLst>
            <pc:docMk/>
            <pc:sldMk cId="2576429967" sldId="256"/>
            <ac:spMk id="15" creationId="{D81A9621-4722-625E-0417-C00B0A2FD8B6}"/>
          </ac:spMkLst>
        </pc:spChg>
        <pc:spChg chg="add del mod">
          <ac:chgData name="Jurre Kamphorst" userId="ea5a6d19-7a1a-404d-92c1-711466574960" providerId="ADAL" clId="{B6032C60-F28A-4293-8B55-FA83C5CA6942}" dt="2024-03-14T19:19:52.917" v="371" actId="478"/>
          <ac:spMkLst>
            <pc:docMk/>
            <pc:sldMk cId="2576429967" sldId="256"/>
            <ac:spMk id="16" creationId="{F134536D-A40E-B293-F7EB-720CEDE1D586}"/>
          </ac:spMkLst>
        </pc:spChg>
        <pc:spChg chg="add del mod">
          <ac:chgData name="Jurre Kamphorst" userId="ea5a6d19-7a1a-404d-92c1-711466574960" providerId="ADAL" clId="{B6032C60-F28A-4293-8B55-FA83C5CA6942}" dt="2024-03-14T19:19:52.917" v="371" actId="478"/>
          <ac:spMkLst>
            <pc:docMk/>
            <pc:sldMk cId="2576429967" sldId="256"/>
            <ac:spMk id="17" creationId="{912432A7-5F7D-17EE-580B-700EFCE43364}"/>
          </ac:spMkLst>
        </pc:spChg>
        <pc:spChg chg="add mod">
          <ac:chgData name="Jurre Kamphorst" userId="ea5a6d19-7a1a-404d-92c1-711466574960" providerId="ADAL" clId="{B6032C60-F28A-4293-8B55-FA83C5CA6942}" dt="2024-03-20T14:00:11.166" v="647" actId="1076"/>
          <ac:spMkLst>
            <pc:docMk/>
            <pc:sldMk cId="2576429967" sldId="256"/>
            <ac:spMk id="17" creationId="{ED079F89-A266-351F-A718-A7EBA4D908BC}"/>
          </ac:spMkLst>
        </pc:spChg>
        <pc:spChg chg="add del mod">
          <ac:chgData name="Jurre Kamphorst" userId="ea5a6d19-7a1a-404d-92c1-711466574960" providerId="ADAL" clId="{B6032C60-F28A-4293-8B55-FA83C5CA6942}" dt="2024-03-14T19:19:52.917" v="371" actId="478"/>
          <ac:spMkLst>
            <pc:docMk/>
            <pc:sldMk cId="2576429967" sldId="256"/>
            <ac:spMk id="18" creationId="{9B4DB142-F25C-F61E-87C1-EBC3C38A120F}"/>
          </ac:spMkLst>
        </pc:spChg>
        <pc:spChg chg="del">
          <ac:chgData name="Jurre Kamphorst" userId="ea5a6d19-7a1a-404d-92c1-711466574960" providerId="ADAL" clId="{B6032C60-F28A-4293-8B55-FA83C5CA6942}" dt="2024-03-09T19:44:05.832" v="0" actId="478"/>
          <ac:spMkLst>
            <pc:docMk/>
            <pc:sldMk cId="2576429967" sldId="256"/>
            <ac:spMk id="19" creationId="{CB969899-C8C5-ACBB-FA58-474A1C477DF9}"/>
          </ac:spMkLst>
        </pc:spChg>
        <pc:spChg chg="del">
          <ac:chgData name="Jurre Kamphorst" userId="ea5a6d19-7a1a-404d-92c1-711466574960" providerId="ADAL" clId="{B6032C60-F28A-4293-8B55-FA83C5CA6942}" dt="2024-03-09T19:44:05.832" v="0" actId="478"/>
          <ac:spMkLst>
            <pc:docMk/>
            <pc:sldMk cId="2576429967" sldId="256"/>
            <ac:spMk id="21" creationId="{684D70E2-7E3D-FAF9-D5D5-8C7427ABC957}"/>
          </ac:spMkLst>
        </pc:spChg>
        <pc:graphicFrameChg chg="add del mod">
          <ac:chgData name="Jurre Kamphorst" userId="ea5a6d19-7a1a-404d-92c1-711466574960" providerId="ADAL" clId="{B6032C60-F28A-4293-8B55-FA83C5CA6942}" dt="2024-03-20T13:58:18.862" v="549" actId="478"/>
          <ac:graphicFrameMkLst>
            <pc:docMk/>
            <pc:sldMk cId="2576429967" sldId="256"/>
            <ac:graphicFrameMk id="2" creationId="{3928B00C-D99A-EE36-2123-0F19171FD222}"/>
          </ac:graphicFrameMkLst>
        </pc:graphicFrameChg>
        <pc:graphicFrameChg chg="add mod">
          <ac:chgData name="Jurre Kamphorst" userId="ea5a6d19-7a1a-404d-92c1-711466574960" providerId="ADAL" clId="{B6032C60-F28A-4293-8B55-FA83C5CA6942}" dt="2024-03-15T19:18:10.818" v="533" actId="1076"/>
          <ac:graphicFrameMkLst>
            <pc:docMk/>
            <pc:sldMk cId="2576429967" sldId="256"/>
            <ac:graphicFrameMk id="5" creationId="{B7ADEA06-DD7E-452F-7E41-D9D7DD81C511}"/>
          </ac:graphicFrameMkLst>
        </pc:graphicFrameChg>
        <pc:graphicFrameChg chg="add mod">
          <ac:chgData name="Jurre Kamphorst" userId="ea5a6d19-7a1a-404d-92c1-711466574960" providerId="ADAL" clId="{B6032C60-F28A-4293-8B55-FA83C5CA6942}" dt="2024-03-15T19:18:10.818" v="533" actId="1076"/>
          <ac:graphicFrameMkLst>
            <pc:docMk/>
            <pc:sldMk cId="2576429967" sldId="256"/>
            <ac:graphicFrameMk id="6" creationId="{6708EA20-EE9C-0519-F8FC-5CA6DC0698D3}"/>
          </ac:graphicFrameMkLst>
        </pc:graphicFrameChg>
        <pc:graphicFrameChg chg="add mod">
          <ac:chgData name="Jurre Kamphorst" userId="ea5a6d19-7a1a-404d-92c1-711466574960" providerId="ADAL" clId="{B6032C60-F28A-4293-8B55-FA83C5CA6942}" dt="2024-03-15T19:18:10.818" v="533" actId="1076"/>
          <ac:graphicFrameMkLst>
            <pc:docMk/>
            <pc:sldMk cId="2576429967" sldId="256"/>
            <ac:graphicFrameMk id="8" creationId="{D55106A4-5565-2ECA-A9D0-D348A3DB1912}"/>
          </ac:graphicFrameMkLst>
        </pc:graphicFrameChg>
        <pc:graphicFrameChg chg="add mod">
          <ac:chgData name="Jurre Kamphorst" userId="ea5a6d19-7a1a-404d-92c1-711466574960" providerId="ADAL" clId="{B6032C60-F28A-4293-8B55-FA83C5CA6942}" dt="2024-03-15T19:18:10.818" v="533" actId="1076"/>
          <ac:graphicFrameMkLst>
            <pc:docMk/>
            <pc:sldMk cId="2576429967" sldId="256"/>
            <ac:graphicFrameMk id="9" creationId="{BCEE585D-B964-A4E1-A649-DB347AD4B9FE}"/>
          </ac:graphicFrameMkLst>
        </pc:graphicFrameChg>
        <pc:graphicFrameChg chg="add mod">
          <ac:chgData name="Jurre Kamphorst" userId="ea5a6d19-7a1a-404d-92c1-711466574960" providerId="ADAL" clId="{B6032C60-F28A-4293-8B55-FA83C5CA6942}" dt="2024-03-20T13:59:01.355" v="562" actId="1076"/>
          <ac:graphicFrameMkLst>
            <pc:docMk/>
            <pc:sldMk cId="2576429967" sldId="256"/>
            <ac:graphicFrameMk id="15" creationId="{C521C839-9306-4228-E40F-96A3DFA5CF5F}"/>
          </ac:graphicFrameMkLst>
        </pc:graphicFrameChg>
        <pc:picChg chg="add del mod">
          <ac:chgData name="Jurre Kamphorst" userId="ea5a6d19-7a1a-404d-92c1-711466574960" providerId="ADAL" clId="{B6032C60-F28A-4293-8B55-FA83C5CA6942}" dt="2024-03-14T19:19:52.917" v="371" actId="478"/>
          <ac:picMkLst>
            <pc:docMk/>
            <pc:sldMk cId="2576429967" sldId="256"/>
            <ac:picMk id="5" creationId="{76C9DBFF-B11B-113C-196D-9F9AF10C3E5D}"/>
          </ac:picMkLst>
        </pc:picChg>
        <pc:picChg chg="del">
          <ac:chgData name="Jurre Kamphorst" userId="ea5a6d19-7a1a-404d-92c1-711466574960" providerId="ADAL" clId="{B6032C60-F28A-4293-8B55-FA83C5CA6942}" dt="2024-03-09T19:44:05.832" v="0" actId="478"/>
          <ac:picMkLst>
            <pc:docMk/>
            <pc:sldMk cId="2576429967" sldId="256"/>
            <ac:picMk id="6" creationId="{F43837FE-D5BF-4ECD-80D8-E267E999AA47}"/>
          </ac:picMkLst>
        </pc:picChg>
        <pc:picChg chg="add del mod">
          <ac:chgData name="Jurre Kamphorst" userId="ea5a6d19-7a1a-404d-92c1-711466574960" providerId="ADAL" clId="{B6032C60-F28A-4293-8B55-FA83C5CA6942}" dt="2024-03-14T19:19:52.917" v="371" actId="478"/>
          <ac:picMkLst>
            <pc:docMk/>
            <pc:sldMk cId="2576429967" sldId="256"/>
            <ac:picMk id="8" creationId="{35443D9D-0FF4-0C4A-77D6-10377102D2F7}"/>
          </ac:picMkLst>
        </pc:picChg>
        <pc:picChg chg="del">
          <ac:chgData name="Jurre Kamphorst" userId="ea5a6d19-7a1a-404d-92c1-711466574960" providerId="ADAL" clId="{B6032C60-F28A-4293-8B55-FA83C5CA6942}" dt="2024-03-09T19:44:05.832" v="0" actId="478"/>
          <ac:picMkLst>
            <pc:docMk/>
            <pc:sldMk cId="2576429967" sldId="256"/>
            <ac:picMk id="10" creationId="{83624585-4C8E-1C22-43A2-A68D781AF0E0}"/>
          </ac:picMkLst>
        </pc:picChg>
        <pc:picChg chg="del">
          <ac:chgData name="Jurre Kamphorst" userId="ea5a6d19-7a1a-404d-92c1-711466574960" providerId="ADAL" clId="{B6032C60-F28A-4293-8B55-FA83C5CA6942}" dt="2024-03-09T19:44:05.832" v="0" actId="478"/>
          <ac:picMkLst>
            <pc:docMk/>
            <pc:sldMk cId="2576429967" sldId="256"/>
            <ac:picMk id="14" creationId="{239519E1-5B45-87E0-F6D6-522DCC2CE14F}"/>
          </ac:picMkLst>
        </pc:picChg>
        <pc:picChg chg="add del mod">
          <ac:chgData name="Jurre Kamphorst" userId="ea5a6d19-7a1a-404d-92c1-711466574960" providerId="ADAL" clId="{B6032C60-F28A-4293-8B55-FA83C5CA6942}" dt="2024-03-21T16:45:31.182" v="658" actId="478"/>
          <ac:picMkLst>
            <pc:docMk/>
            <pc:sldMk cId="2576429967" sldId="256"/>
            <ac:picMk id="16" creationId="{CFC71AC5-E6C7-35F7-F5F8-D373378C5AC1}"/>
          </ac:picMkLst>
        </pc:picChg>
        <pc:picChg chg="add mod ord">
          <ac:chgData name="Jurre Kamphorst" userId="ea5a6d19-7a1a-404d-92c1-711466574960" providerId="ADAL" clId="{B6032C60-F28A-4293-8B55-FA83C5CA6942}" dt="2024-03-21T16:46:11.232" v="669" actId="1076"/>
          <ac:picMkLst>
            <pc:docMk/>
            <pc:sldMk cId="2576429967" sldId="256"/>
            <ac:picMk id="18" creationId="{142CDCD9-D0A9-112D-C97D-EB4BF9253DFE}"/>
          </ac:picMkLst>
        </pc:picChg>
      </pc:sldChg>
      <pc:sldChg chg="addSp delSp modSp new mod ord">
        <pc:chgData name="Jurre Kamphorst" userId="ea5a6d19-7a1a-404d-92c1-711466574960" providerId="ADAL" clId="{B6032C60-F28A-4293-8B55-FA83C5CA6942}" dt="2024-03-14T19:30:00.879" v="519" actId="1076"/>
        <pc:sldMkLst>
          <pc:docMk/>
          <pc:sldMk cId="1513836502" sldId="257"/>
        </pc:sldMkLst>
        <pc:spChg chg="del">
          <ac:chgData name="Jurre Kamphorst" userId="ea5a6d19-7a1a-404d-92c1-711466574960" providerId="ADAL" clId="{B6032C60-F28A-4293-8B55-FA83C5CA6942}" dt="2024-03-12T12:30:47.795" v="271" actId="478"/>
          <ac:spMkLst>
            <pc:docMk/>
            <pc:sldMk cId="1513836502" sldId="257"/>
            <ac:spMk id="2" creationId="{1FC69E28-5D46-46DA-7457-9CB782FB5FB2}"/>
          </ac:spMkLst>
        </pc:spChg>
        <pc:spChg chg="add mod">
          <ac:chgData name="Jurre Kamphorst" userId="ea5a6d19-7a1a-404d-92c1-711466574960" providerId="ADAL" clId="{B6032C60-F28A-4293-8B55-FA83C5CA6942}" dt="2024-03-14T19:23:36.545" v="415" actId="14100"/>
          <ac:spMkLst>
            <pc:docMk/>
            <pc:sldMk cId="1513836502" sldId="257"/>
            <ac:spMk id="2" creationId="{23178C4D-B3E8-0972-3C3E-97795B3FAE5A}"/>
          </ac:spMkLst>
        </pc:spChg>
        <pc:spChg chg="add mod">
          <ac:chgData name="Jurre Kamphorst" userId="ea5a6d19-7a1a-404d-92c1-711466574960" providerId="ADAL" clId="{B6032C60-F28A-4293-8B55-FA83C5CA6942}" dt="2024-03-14T19:23:41.131" v="416" actId="1076"/>
          <ac:spMkLst>
            <pc:docMk/>
            <pc:sldMk cId="1513836502" sldId="257"/>
            <ac:spMk id="3" creationId="{6663A3A0-76F2-0D7C-2966-64BE4EB0C795}"/>
          </ac:spMkLst>
        </pc:spChg>
        <pc:spChg chg="del">
          <ac:chgData name="Jurre Kamphorst" userId="ea5a6d19-7a1a-404d-92c1-711466574960" providerId="ADAL" clId="{B6032C60-F28A-4293-8B55-FA83C5CA6942}" dt="2024-03-12T12:30:46.210" v="270" actId="478"/>
          <ac:spMkLst>
            <pc:docMk/>
            <pc:sldMk cId="1513836502" sldId="257"/>
            <ac:spMk id="3" creationId="{C43862E7-76E0-0701-813D-35BB667A4A33}"/>
          </ac:spMkLst>
        </pc:spChg>
        <pc:spChg chg="add mod">
          <ac:chgData name="Jurre Kamphorst" userId="ea5a6d19-7a1a-404d-92c1-711466574960" providerId="ADAL" clId="{B6032C60-F28A-4293-8B55-FA83C5CA6942}" dt="2024-03-14T19:22:10.276" v="394" actId="1076"/>
          <ac:spMkLst>
            <pc:docMk/>
            <pc:sldMk cId="1513836502" sldId="257"/>
            <ac:spMk id="4" creationId="{05D71F9E-B5D0-675D-A974-D7FBFCF97FC6}"/>
          </ac:spMkLst>
        </pc:spChg>
        <pc:spChg chg="add mod">
          <ac:chgData name="Jurre Kamphorst" userId="ea5a6d19-7a1a-404d-92c1-711466574960" providerId="ADAL" clId="{B6032C60-F28A-4293-8B55-FA83C5CA6942}" dt="2024-03-12T12:32:49.225" v="287" actId="14100"/>
          <ac:spMkLst>
            <pc:docMk/>
            <pc:sldMk cId="1513836502" sldId="257"/>
            <ac:spMk id="6" creationId="{40415617-B006-C5C7-5F93-086A22478F3B}"/>
          </ac:spMkLst>
        </pc:spChg>
        <pc:spChg chg="add mod">
          <ac:chgData name="Jurre Kamphorst" userId="ea5a6d19-7a1a-404d-92c1-711466574960" providerId="ADAL" clId="{B6032C60-F28A-4293-8B55-FA83C5CA6942}" dt="2024-03-12T12:33:02.176" v="290" actId="20577"/>
          <ac:spMkLst>
            <pc:docMk/>
            <pc:sldMk cId="1513836502" sldId="257"/>
            <ac:spMk id="7" creationId="{AA57A387-6A37-29F1-FA89-A2EC284EFBB3}"/>
          </ac:spMkLst>
        </pc:spChg>
        <pc:spChg chg="add mod">
          <ac:chgData name="Jurre Kamphorst" userId="ea5a6d19-7a1a-404d-92c1-711466574960" providerId="ADAL" clId="{B6032C60-F28A-4293-8B55-FA83C5CA6942}" dt="2024-03-12T12:35:10.569" v="366" actId="20577"/>
          <ac:spMkLst>
            <pc:docMk/>
            <pc:sldMk cId="1513836502" sldId="257"/>
            <ac:spMk id="8" creationId="{ACC323F5-02D5-7E9C-687D-931D061DC64C}"/>
          </ac:spMkLst>
        </pc:spChg>
        <pc:spChg chg="add mod">
          <ac:chgData name="Jurre Kamphorst" userId="ea5a6d19-7a1a-404d-92c1-711466574960" providerId="ADAL" clId="{B6032C60-F28A-4293-8B55-FA83C5CA6942}" dt="2024-03-12T12:35:32.541" v="368" actId="1076"/>
          <ac:spMkLst>
            <pc:docMk/>
            <pc:sldMk cId="1513836502" sldId="257"/>
            <ac:spMk id="11" creationId="{707FA75D-51F5-4DA9-13BA-6D49DE9EDC59}"/>
          </ac:spMkLst>
        </pc:spChg>
        <pc:spChg chg="add mod">
          <ac:chgData name="Jurre Kamphorst" userId="ea5a6d19-7a1a-404d-92c1-711466574960" providerId="ADAL" clId="{B6032C60-F28A-4293-8B55-FA83C5CA6942}" dt="2024-03-12T12:35:32.541" v="368" actId="1076"/>
          <ac:spMkLst>
            <pc:docMk/>
            <pc:sldMk cId="1513836502" sldId="257"/>
            <ac:spMk id="12" creationId="{795E2299-F25A-524C-20B4-04281C9922DE}"/>
          </ac:spMkLst>
        </pc:spChg>
        <pc:spChg chg="add mod">
          <ac:chgData name="Jurre Kamphorst" userId="ea5a6d19-7a1a-404d-92c1-711466574960" providerId="ADAL" clId="{B6032C60-F28A-4293-8B55-FA83C5CA6942}" dt="2024-03-12T12:35:32.541" v="368" actId="1076"/>
          <ac:spMkLst>
            <pc:docMk/>
            <pc:sldMk cId="1513836502" sldId="257"/>
            <ac:spMk id="13" creationId="{0976A6DC-434F-ABDF-B33E-93437D308A97}"/>
          </ac:spMkLst>
        </pc:spChg>
        <pc:spChg chg="add mod">
          <ac:chgData name="Jurre Kamphorst" userId="ea5a6d19-7a1a-404d-92c1-711466574960" providerId="ADAL" clId="{B6032C60-F28A-4293-8B55-FA83C5CA6942}" dt="2024-03-12T12:35:32.541" v="368" actId="1076"/>
          <ac:spMkLst>
            <pc:docMk/>
            <pc:sldMk cId="1513836502" sldId="257"/>
            <ac:spMk id="14" creationId="{8372945B-B951-EB93-B514-376187D7AFC7}"/>
          </ac:spMkLst>
        </pc:spChg>
        <pc:spChg chg="add mod">
          <ac:chgData name="Jurre Kamphorst" userId="ea5a6d19-7a1a-404d-92c1-711466574960" providerId="ADAL" clId="{B6032C60-F28A-4293-8B55-FA83C5CA6942}" dt="2024-03-14T19:20:36.668" v="386" actId="20577"/>
          <ac:spMkLst>
            <pc:docMk/>
            <pc:sldMk cId="1513836502" sldId="257"/>
            <ac:spMk id="15" creationId="{FEDC7601-69C5-C220-8BDB-3D333F257196}"/>
          </ac:spMkLst>
        </pc:spChg>
        <pc:spChg chg="add mod">
          <ac:chgData name="Jurre Kamphorst" userId="ea5a6d19-7a1a-404d-92c1-711466574960" providerId="ADAL" clId="{B6032C60-F28A-4293-8B55-FA83C5CA6942}" dt="2024-03-12T12:35:32.541" v="368" actId="1076"/>
          <ac:spMkLst>
            <pc:docMk/>
            <pc:sldMk cId="1513836502" sldId="257"/>
            <ac:spMk id="16" creationId="{FBB68053-39C8-EC22-174B-71DDDCE5E02F}"/>
          </ac:spMkLst>
        </pc:spChg>
        <pc:spChg chg="add mod">
          <ac:chgData name="Jurre Kamphorst" userId="ea5a6d19-7a1a-404d-92c1-711466574960" providerId="ADAL" clId="{B6032C60-F28A-4293-8B55-FA83C5CA6942}" dt="2024-03-12T12:35:32.541" v="368" actId="1076"/>
          <ac:spMkLst>
            <pc:docMk/>
            <pc:sldMk cId="1513836502" sldId="257"/>
            <ac:spMk id="17" creationId="{112571CC-5B9A-83EB-5C2F-98A17578FB4D}"/>
          </ac:spMkLst>
        </pc:spChg>
        <pc:spChg chg="add mod">
          <ac:chgData name="Jurre Kamphorst" userId="ea5a6d19-7a1a-404d-92c1-711466574960" providerId="ADAL" clId="{B6032C60-F28A-4293-8B55-FA83C5CA6942}" dt="2024-03-14T19:23:49.444" v="417" actId="1076"/>
          <ac:spMkLst>
            <pc:docMk/>
            <pc:sldMk cId="1513836502" sldId="257"/>
            <ac:spMk id="18" creationId="{7AC47DDF-5484-8915-5478-6C7E91F0D8E3}"/>
          </ac:spMkLst>
        </pc:spChg>
        <pc:spChg chg="add mod">
          <ac:chgData name="Jurre Kamphorst" userId="ea5a6d19-7a1a-404d-92c1-711466574960" providerId="ADAL" clId="{B6032C60-F28A-4293-8B55-FA83C5CA6942}" dt="2024-03-14T19:22:23.147" v="398" actId="1076"/>
          <ac:spMkLst>
            <pc:docMk/>
            <pc:sldMk cId="1513836502" sldId="257"/>
            <ac:spMk id="19" creationId="{56B0C2D8-0896-4A4D-40DF-97DEE22C7C69}"/>
          </ac:spMkLst>
        </pc:spChg>
        <pc:spChg chg="add mod">
          <ac:chgData name="Jurre Kamphorst" userId="ea5a6d19-7a1a-404d-92c1-711466574960" providerId="ADAL" clId="{B6032C60-F28A-4293-8B55-FA83C5CA6942}" dt="2024-03-14T19:22:39.811" v="402" actId="20577"/>
          <ac:spMkLst>
            <pc:docMk/>
            <pc:sldMk cId="1513836502" sldId="257"/>
            <ac:spMk id="20" creationId="{2206C8CF-63CC-DD81-F21D-E4652D3B8719}"/>
          </ac:spMkLst>
        </pc:spChg>
        <pc:spChg chg="add mod">
          <ac:chgData name="Jurre Kamphorst" userId="ea5a6d19-7a1a-404d-92c1-711466574960" providerId="ADAL" clId="{B6032C60-F28A-4293-8B55-FA83C5CA6942}" dt="2024-03-14T19:22:59.068" v="408" actId="20577"/>
          <ac:spMkLst>
            <pc:docMk/>
            <pc:sldMk cId="1513836502" sldId="257"/>
            <ac:spMk id="21" creationId="{25824043-C488-F444-2EDF-CDFC8E5F2E2E}"/>
          </ac:spMkLst>
        </pc:spChg>
        <pc:spChg chg="add mod">
          <ac:chgData name="Jurre Kamphorst" userId="ea5a6d19-7a1a-404d-92c1-711466574960" providerId="ADAL" clId="{B6032C60-F28A-4293-8B55-FA83C5CA6942}" dt="2024-03-14T19:23:08.035" v="412" actId="20577"/>
          <ac:spMkLst>
            <pc:docMk/>
            <pc:sldMk cId="1513836502" sldId="257"/>
            <ac:spMk id="22" creationId="{9C92F6D7-A62B-302D-3378-4DC04F3A4E4A}"/>
          </ac:spMkLst>
        </pc:spChg>
        <pc:spChg chg="add mod">
          <ac:chgData name="Jurre Kamphorst" userId="ea5a6d19-7a1a-404d-92c1-711466574960" providerId="ADAL" clId="{B6032C60-F28A-4293-8B55-FA83C5CA6942}" dt="2024-03-14T19:24:08.144" v="419" actId="1076"/>
          <ac:spMkLst>
            <pc:docMk/>
            <pc:sldMk cId="1513836502" sldId="257"/>
            <ac:spMk id="23" creationId="{76B8971D-809F-9B22-8E20-C7B637848CF0}"/>
          </ac:spMkLst>
        </pc:spChg>
        <pc:spChg chg="add mod">
          <ac:chgData name="Jurre Kamphorst" userId="ea5a6d19-7a1a-404d-92c1-711466574960" providerId="ADAL" clId="{B6032C60-F28A-4293-8B55-FA83C5CA6942}" dt="2024-03-14T19:24:08.144" v="419" actId="1076"/>
          <ac:spMkLst>
            <pc:docMk/>
            <pc:sldMk cId="1513836502" sldId="257"/>
            <ac:spMk id="24" creationId="{AC3A98BB-AD6A-FE79-1956-01195F27C969}"/>
          </ac:spMkLst>
        </pc:spChg>
        <pc:spChg chg="add mod">
          <ac:chgData name="Jurre Kamphorst" userId="ea5a6d19-7a1a-404d-92c1-711466574960" providerId="ADAL" clId="{B6032C60-F28A-4293-8B55-FA83C5CA6942}" dt="2024-03-14T19:24:08.144" v="419" actId="1076"/>
          <ac:spMkLst>
            <pc:docMk/>
            <pc:sldMk cId="1513836502" sldId="257"/>
            <ac:spMk id="25" creationId="{8DDDC64A-B184-8DBA-7081-961B56236075}"/>
          </ac:spMkLst>
        </pc:spChg>
        <pc:spChg chg="add mod">
          <ac:chgData name="Jurre Kamphorst" userId="ea5a6d19-7a1a-404d-92c1-711466574960" providerId="ADAL" clId="{B6032C60-F28A-4293-8B55-FA83C5CA6942}" dt="2024-03-14T19:24:08.144" v="419" actId="1076"/>
          <ac:spMkLst>
            <pc:docMk/>
            <pc:sldMk cId="1513836502" sldId="257"/>
            <ac:spMk id="26" creationId="{371D19EE-1274-C98E-F470-99C29AD29DDF}"/>
          </ac:spMkLst>
        </pc:spChg>
        <pc:spChg chg="add mod">
          <ac:chgData name="Jurre Kamphorst" userId="ea5a6d19-7a1a-404d-92c1-711466574960" providerId="ADAL" clId="{B6032C60-F28A-4293-8B55-FA83C5CA6942}" dt="2024-03-14T19:24:08.144" v="419" actId="1076"/>
          <ac:spMkLst>
            <pc:docMk/>
            <pc:sldMk cId="1513836502" sldId="257"/>
            <ac:spMk id="27" creationId="{E5365B10-B19F-EB22-7AF3-F278D3361946}"/>
          </ac:spMkLst>
        </pc:spChg>
        <pc:spChg chg="add mod">
          <ac:chgData name="Jurre Kamphorst" userId="ea5a6d19-7a1a-404d-92c1-711466574960" providerId="ADAL" clId="{B6032C60-F28A-4293-8B55-FA83C5CA6942}" dt="2024-03-14T19:24:08.144" v="419" actId="1076"/>
          <ac:spMkLst>
            <pc:docMk/>
            <pc:sldMk cId="1513836502" sldId="257"/>
            <ac:spMk id="28" creationId="{F160C26A-389B-D034-A5E8-8B13A79F4A17}"/>
          </ac:spMkLst>
        </pc:spChg>
        <pc:spChg chg="add mod">
          <ac:chgData name="Jurre Kamphorst" userId="ea5a6d19-7a1a-404d-92c1-711466574960" providerId="ADAL" clId="{B6032C60-F28A-4293-8B55-FA83C5CA6942}" dt="2024-03-14T19:24:08.144" v="419" actId="1076"/>
          <ac:spMkLst>
            <pc:docMk/>
            <pc:sldMk cId="1513836502" sldId="257"/>
            <ac:spMk id="29" creationId="{1A6EA7AD-F480-7C11-11BB-E91B3626149D}"/>
          </ac:spMkLst>
        </pc:spChg>
        <pc:spChg chg="add mod">
          <ac:chgData name="Jurre Kamphorst" userId="ea5a6d19-7a1a-404d-92c1-711466574960" providerId="ADAL" clId="{B6032C60-F28A-4293-8B55-FA83C5CA6942}" dt="2024-03-14T19:29:20.607" v="516" actId="1076"/>
          <ac:spMkLst>
            <pc:docMk/>
            <pc:sldMk cId="1513836502" sldId="257"/>
            <ac:spMk id="30" creationId="{7E17D839-3216-58AA-F928-C4B4254C2313}"/>
          </ac:spMkLst>
        </pc:spChg>
        <pc:spChg chg="add mod">
          <ac:chgData name="Jurre Kamphorst" userId="ea5a6d19-7a1a-404d-92c1-711466574960" providerId="ADAL" clId="{B6032C60-F28A-4293-8B55-FA83C5CA6942}" dt="2024-03-14T19:27:40.670" v="473" actId="14100"/>
          <ac:spMkLst>
            <pc:docMk/>
            <pc:sldMk cId="1513836502" sldId="257"/>
            <ac:spMk id="31" creationId="{CBCDD704-3512-11B0-0E89-6B24DE0EF0CB}"/>
          </ac:spMkLst>
        </pc:spChg>
        <pc:spChg chg="add mod">
          <ac:chgData name="Jurre Kamphorst" userId="ea5a6d19-7a1a-404d-92c1-711466574960" providerId="ADAL" clId="{B6032C60-F28A-4293-8B55-FA83C5CA6942}" dt="2024-03-14T19:25:10.853" v="436" actId="1076"/>
          <ac:spMkLst>
            <pc:docMk/>
            <pc:sldMk cId="1513836502" sldId="257"/>
            <ac:spMk id="32" creationId="{5CC48951-609F-0355-F717-D83AA823E981}"/>
          </ac:spMkLst>
        </pc:spChg>
        <pc:spChg chg="add mod">
          <ac:chgData name="Jurre Kamphorst" userId="ea5a6d19-7a1a-404d-92c1-711466574960" providerId="ADAL" clId="{B6032C60-F28A-4293-8B55-FA83C5CA6942}" dt="2024-03-14T19:25:26.893" v="441" actId="1076"/>
          <ac:spMkLst>
            <pc:docMk/>
            <pc:sldMk cId="1513836502" sldId="257"/>
            <ac:spMk id="33" creationId="{3E4AA37B-335F-D581-968E-44EDD695E211}"/>
          </ac:spMkLst>
        </pc:spChg>
        <pc:spChg chg="add mod">
          <ac:chgData name="Jurre Kamphorst" userId="ea5a6d19-7a1a-404d-92c1-711466574960" providerId="ADAL" clId="{B6032C60-F28A-4293-8B55-FA83C5CA6942}" dt="2024-03-14T19:25:37.839" v="444" actId="20577"/>
          <ac:spMkLst>
            <pc:docMk/>
            <pc:sldMk cId="1513836502" sldId="257"/>
            <ac:spMk id="34" creationId="{0B5A5E84-121C-878D-4FBD-01C56E9FB6C5}"/>
          </ac:spMkLst>
        </pc:spChg>
        <pc:spChg chg="add mod">
          <ac:chgData name="Jurre Kamphorst" userId="ea5a6d19-7a1a-404d-92c1-711466574960" providerId="ADAL" clId="{B6032C60-F28A-4293-8B55-FA83C5CA6942}" dt="2024-03-14T19:25:47.470" v="447" actId="20577"/>
          <ac:spMkLst>
            <pc:docMk/>
            <pc:sldMk cId="1513836502" sldId="257"/>
            <ac:spMk id="35" creationId="{2C8DA58C-1FEB-46E6-33BB-0527ECCF1B3B}"/>
          </ac:spMkLst>
        </pc:spChg>
        <pc:spChg chg="add mod">
          <ac:chgData name="Jurre Kamphorst" userId="ea5a6d19-7a1a-404d-92c1-711466574960" providerId="ADAL" clId="{B6032C60-F28A-4293-8B55-FA83C5CA6942}" dt="2024-03-14T19:25:56.325" v="450" actId="20577"/>
          <ac:spMkLst>
            <pc:docMk/>
            <pc:sldMk cId="1513836502" sldId="257"/>
            <ac:spMk id="36" creationId="{9D536413-47A7-40F6-9E6B-3E19BA6C44AC}"/>
          </ac:spMkLst>
        </pc:spChg>
        <pc:spChg chg="add mod">
          <ac:chgData name="Jurre Kamphorst" userId="ea5a6d19-7a1a-404d-92c1-711466574960" providerId="ADAL" clId="{B6032C60-F28A-4293-8B55-FA83C5CA6942}" dt="2024-03-14T19:27:25.874" v="471" actId="1076"/>
          <ac:spMkLst>
            <pc:docMk/>
            <pc:sldMk cId="1513836502" sldId="257"/>
            <ac:spMk id="37" creationId="{C37DC5DE-3C58-D922-17B0-C0D15B906CDC}"/>
          </ac:spMkLst>
        </pc:spChg>
        <pc:spChg chg="add mod">
          <ac:chgData name="Jurre Kamphorst" userId="ea5a6d19-7a1a-404d-92c1-711466574960" providerId="ADAL" clId="{B6032C60-F28A-4293-8B55-FA83C5CA6942}" dt="2024-03-14T19:27:16.858" v="470" actId="1076"/>
          <ac:spMkLst>
            <pc:docMk/>
            <pc:sldMk cId="1513836502" sldId="257"/>
            <ac:spMk id="38" creationId="{6886DF27-9E5D-B687-792C-872E2ED6CBB9}"/>
          </ac:spMkLst>
        </pc:spChg>
        <pc:spChg chg="add mod">
          <ac:chgData name="Jurre Kamphorst" userId="ea5a6d19-7a1a-404d-92c1-711466574960" providerId="ADAL" clId="{B6032C60-F28A-4293-8B55-FA83C5CA6942}" dt="2024-03-14T19:27:11.017" v="469" actId="1076"/>
          <ac:spMkLst>
            <pc:docMk/>
            <pc:sldMk cId="1513836502" sldId="257"/>
            <ac:spMk id="39" creationId="{F84C9252-40E9-D4EC-AB78-2510F2ECA93F}"/>
          </ac:spMkLst>
        </pc:spChg>
        <pc:spChg chg="add mod">
          <ac:chgData name="Jurre Kamphorst" userId="ea5a6d19-7a1a-404d-92c1-711466574960" providerId="ADAL" clId="{B6032C60-F28A-4293-8B55-FA83C5CA6942}" dt="2024-03-14T19:27:03.997" v="468" actId="1076"/>
          <ac:spMkLst>
            <pc:docMk/>
            <pc:sldMk cId="1513836502" sldId="257"/>
            <ac:spMk id="40" creationId="{1CC3B4FC-150B-AE9F-36A2-D6E4F07380C8}"/>
          </ac:spMkLst>
        </pc:spChg>
        <pc:spChg chg="add mod">
          <ac:chgData name="Jurre Kamphorst" userId="ea5a6d19-7a1a-404d-92c1-711466574960" providerId="ADAL" clId="{B6032C60-F28A-4293-8B55-FA83C5CA6942}" dt="2024-03-14T19:26:51.303" v="467" actId="20577"/>
          <ac:spMkLst>
            <pc:docMk/>
            <pc:sldMk cId="1513836502" sldId="257"/>
            <ac:spMk id="41" creationId="{B6ECD60F-9FB1-334A-26ED-85E4D42FDEEA}"/>
          </ac:spMkLst>
        </pc:spChg>
        <pc:spChg chg="add mod">
          <ac:chgData name="Jurre Kamphorst" userId="ea5a6d19-7a1a-404d-92c1-711466574960" providerId="ADAL" clId="{B6032C60-F28A-4293-8B55-FA83C5CA6942}" dt="2024-03-14T19:29:38.063" v="517" actId="1076"/>
          <ac:spMkLst>
            <pc:docMk/>
            <pc:sldMk cId="1513836502" sldId="257"/>
            <ac:spMk id="42" creationId="{C6182264-ACA9-9FE7-E092-96E3038FFA4B}"/>
          </ac:spMkLst>
        </pc:spChg>
        <pc:spChg chg="add mod">
          <ac:chgData name="Jurre Kamphorst" userId="ea5a6d19-7a1a-404d-92c1-711466574960" providerId="ADAL" clId="{B6032C60-F28A-4293-8B55-FA83C5CA6942}" dt="2024-03-14T19:27:55.080" v="477" actId="1076"/>
          <ac:spMkLst>
            <pc:docMk/>
            <pc:sldMk cId="1513836502" sldId="257"/>
            <ac:spMk id="43" creationId="{67AA7E1B-DD5F-3D1F-4986-5BB01A9DCCB6}"/>
          </ac:spMkLst>
        </pc:spChg>
        <pc:spChg chg="add mod">
          <ac:chgData name="Jurre Kamphorst" userId="ea5a6d19-7a1a-404d-92c1-711466574960" providerId="ADAL" clId="{B6032C60-F28A-4293-8B55-FA83C5CA6942}" dt="2024-03-14T19:28:04.014" v="482" actId="1076"/>
          <ac:spMkLst>
            <pc:docMk/>
            <pc:sldMk cId="1513836502" sldId="257"/>
            <ac:spMk id="44" creationId="{BB9F9508-D1C0-228A-6900-3A62E9B34746}"/>
          </ac:spMkLst>
        </pc:spChg>
        <pc:spChg chg="add mod">
          <ac:chgData name="Jurre Kamphorst" userId="ea5a6d19-7a1a-404d-92c1-711466574960" providerId="ADAL" clId="{B6032C60-F28A-4293-8B55-FA83C5CA6942}" dt="2024-03-14T19:28:27.078" v="489" actId="1076"/>
          <ac:spMkLst>
            <pc:docMk/>
            <pc:sldMk cId="1513836502" sldId="257"/>
            <ac:spMk id="45" creationId="{9FB3F477-B8B5-4862-0969-6D60FD77BD35}"/>
          </ac:spMkLst>
        </pc:spChg>
        <pc:spChg chg="add mod">
          <ac:chgData name="Jurre Kamphorst" userId="ea5a6d19-7a1a-404d-92c1-711466574960" providerId="ADAL" clId="{B6032C60-F28A-4293-8B55-FA83C5CA6942}" dt="2024-03-14T19:28:35.943" v="491" actId="1076"/>
          <ac:spMkLst>
            <pc:docMk/>
            <pc:sldMk cId="1513836502" sldId="257"/>
            <ac:spMk id="46" creationId="{17DA22EE-2898-393E-6A96-54F92CAE588B}"/>
          </ac:spMkLst>
        </pc:spChg>
        <pc:spChg chg="add mod">
          <ac:chgData name="Jurre Kamphorst" userId="ea5a6d19-7a1a-404d-92c1-711466574960" providerId="ADAL" clId="{B6032C60-F28A-4293-8B55-FA83C5CA6942}" dt="2024-03-14T19:28:48.662" v="495" actId="20577"/>
          <ac:spMkLst>
            <pc:docMk/>
            <pc:sldMk cId="1513836502" sldId="257"/>
            <ac:spMk id="47" creationId="{95E1A0AF-2B01-DB92-2743-EB8744AA60C5}"/>
          </ac:spMkLst>
        </pc:spChg>
        <pc:spChg chg="add mod">
          <ac:chgData name="Jurre Kamphorst" userId="ea5a6d19-7a1a-404d-92c1-711466574960" providerId="ADAL" clId="{B6032C60-F28A-4293-8B55-FA83C5CA6942}" dt="2024-03-14T19:28:57.430" v="498" actId="20577"/>
          <ac:spMkLst>
            <pc:docMk/>
            <pc:sldMk cId="1513836502" sldId="257"/>
            <ac:spMk id="48" creationId="{06FF1907-F78C-29A8-EFF8-B366E4EA7805}"/>
          </ac:spMkLst>
        </pc:spChg>
        <pc:spChg chg="add mod">
          <ac:chgData name="Jurre Kamphorst" userId="ea5a6d19-7a1a-404d-92c1-711466574960" providerId="ADAL" clId="{B6032C60-F28A-4293-8B55-FA83C5CA6942}" dt="2024-03-14T19:29:06.702" v="504" actId="20577"/>
          <ac:spMkLst>
            <pc:docMk/>
            <pc:sldMk cId="1513836502" sldId="257"/>
            <ac:spMk id="49" creationId="{C281BE37-5B8C-3843-F9B1-F0A7ACD60698}"/>
          </ac:spMkLst>
        </pc:spChg>
        <pc:spChg chg="add mod">
          <ac:chgData name="Jurre Kamphorst" userId="ea5a6d19-7a1a-404d-92c1-711466574960" providerId="ADAL" clId="{B6032C60-F28A-4293-8B55-FA83C5CA6942}" dt="2024-03-14T19:30:00.879" v="519" actId="1076"/>
          <ac:spMkLst>
            <pc:docMk/>
            <pc:sldMk cId="1513836502" sldId="257"/>
            <ac:spMk id="50" creationId="{38AD9FFB-DC61-09B8-B182-5550C0F08BBD}"/>
          </ac:spMkLst>
        </pc:spChg>
        <pc:picChg chg="add mod">
          <ac:chgData name="Jurre Kamphorst" userId="ea5a6d19-7a1a-404d-92c1-711466574960" providerId="ADAL" clId="{B6032C60-F28A-4293-8B55-FA83C5CA6942}" dt="2024-03-12T12:31:38.048" v="280" actId="1076"/>
          <ac:picMkLst>
            <pc:docMk/>
            <pc:sldMk cId="1513836502" sldId="257"/>
            <ac:picMk id="5" creationId="{FA30103A-E334-8615-2957-23F12B710D7E}"/>
          </ac:picMkLst>
        </pc:picChg>
        <pc:picChg chg="add mod">
          <ac:chgData name="Jurre Kamphorst" userId="ea5a6d19-7a1a-404d-92c1-711466574960" providerId="ADAL" clId="{B6032C60-F28A-4293-8B55-FA83C5CA6942}" dt="2024-03-12T12:35:32.541" v="368" actId="1076"/>
          <ac:picMkLst>
            <pc:docMk/>
            <pc:sldMk cId="1513836502" sldId="257"/>
            <ac:picMk id="9" creationId="{44CC0774-80FF-3536-F886-04E7BE147407}"/>
          </ac:picMkLst>
        </pc:picChg>
        <pc:picChg chg="add mod">
          <ac:chgData name="Jurre Kamphorst" userId="ea5a6d19-7a1a-404d-92c1-711466574960" providerId="ADAL" clId="{B6032C60-F28A-4293-8B55-FA83C5CA6942}" dt="2024-03-12T12:35:32.541" v="368" actId="1076"/>
          <ac:picMkLst>
            <pc:docMk/>
            <pc:sldMk cId="1513836502" sldId="257"/>
            <ac:picMk id="10" creationId="{E0DF2F7C-8369-9D76-C6FE-899597A3FECD}"/>
          </ac:picMkLst>
        </pc:picChg>
      </pc:sldChg>
      <pc:sldChg chg="addSp delSp modSp new mod">
        <pc:chgData name="Jurre Kamphorst" userId="ea5a6d19-7a1a-404d-92c1-711466574960" providerId="ADAL" clId="{B6032C60-F28A-4293-8B55-FA83C5CA6942}" dt="2024-03-21T18:02:06.551" v="704" actId="1076"/>
        <pc:sldMkLst>
          <pc:docMk/>
          <pc:sldMk cId="1558932368" sldId="258"/>
        </pc:sldMkLst>
        <pc:spChg chg="add mod">
          <ac:chgData name="Jurre Kamphorst" userId="ea5a6d19-7a1a-404d-92c1-711466574960" providerId="ADAL" clId="{B6032C60-F28A-4293-8B55-FA83C5CA6942}" dt="2024-03-21T18:02:06.551" v="704" actId="1076"/>
          <ac:spMkLst>
            <pc:docMk/>
            <pc:sldMk cId="1558932368" sldId="258"/>
            <ac:spMk id="2" creationId="{C3D943B9-5C70-16E8-FDB1-53B6DA96A743}"/>
          </ac:spMkLst>
        </pc:spChg>
        <pc:spChg chg="del">
          <ac:chgData name="Jurre Kamphorst" userId="ea5a6d19-7a1a-404d-92c1-711466574960" providerId="ADAL" clId="{B6032C60-F28A-4293-8B55-FA83C5CA6942}" dt="2024-03-20T14:38:19.640" v="649" actId="478"/>
          <ac:spMkLst>
            <pc:docMk/>
            <pc:sldMk cId="1558932368" sldId="258"/>
            <ac:spMk id="2" creationId="{D98C9A0C-2B3A-65BD-E35F-4F135832A27C}"/>
          </ac:spMkLst>
        </pc:spChg>
        <pc:spChg chg="del">
          <ac:chgData name="Jurre Kamphorst" userId="ea5a6d19-7a1a-404d-92c1-711466574960" providerId="ADAL" clId="{B6032C60-F28A-4293-8B55-FA83C5CA6942}" dt="2024-03-20T14:38:20.956" v="650" actId="478"/>
          <ac:spMkLst>
            <pc:docMk/>
            <pc:sldMk cId="1558932368" sldId="258"/>
            <ac:spMk id="3" creationId="{757D9F47-43AA-BBCD-93C2-DA4E98CAD042}"/>
          </ac:spMkLst>
        </pc:spChg>
        <pc:spChg chg="add mod">
          <ac:chgData name="Jurre Kamphorst" userId="ea5a6d19-7a1a-404d-92c1-711466574960" providerId="ADAL" clId="{B6032C60-F28A-4293-8B55-FA83C5CA6942}" dt="2024-03-20T14:38:28.786" v="652" actId="20577"/>
          <ac:spMkLst>
            <pc:docMk/>
            <pc:sldMk cId="1558932368" sldId="258"/>
            <ac:spMk id="4" creationId="{D96AF1ED-85D6-5B62-F40A-E3A2582E20AC}"/>
          </ac:spMkLst>
        </pc:spChg>
        <pc:picChg chg="add mod">
          <ac:chgData name="Jurre Kamphorst" userId="ea5a6d19-7a1a-404d-92c1-711466574960" providerId="ADAL" clId="{B6032C60-F28A-4293-8B55-FA83C5CA6942}" dt="2024-03-20T14:42:24.843" v="657" actId="1076"/>
          <ac:picMkLst>
            <pc:docMk/>
            <pc:sldMk cId="1558932368" sldId="258"/>
            <ac:picMk id="6" creationId="{18A5B968-9AAA-512E-3EEF-9BC5A07BF5CA}"/>
          </ac:picMkLst>
        </pc:picChg>
      </pc:sldChg>
    </pc:docChg>
  </pc:docChgLst>
  <pc:docChgLst>
    <pc:chgData name="Jurre Kamphorst" userId="ea5a6d19-7a1a-404d-92c1-711466574960" providerId="ADAL" clId="{D1279864-D82F-434A-8001-0CE0918F1AA5}"/>
    <pc:docChg chg="modSld">
      <pc:chgData name="Jurre Kamphorst" userId="ea5a6d19-7a1a-404d-92c1-711466574960" providerId="ADAL" clId="{D1279864-D82F-434A-8001-0CE0918F1AA5}" dt="2024-04-27T19:05:37.490" v="550" actId="20577"/>
      <pc:docMkLst>
        <pc:docMk/>
      </pc:docMkLst>
      <pc:sldChg chg="addSp modSp mod">
        <pc:chgData name="Jurre Kamphorst" userId="ea5a6d19-7a1a-404d-92c1-711466574960" providerId="ADAL" clId="{D1279864-D82F-434A-8001-0CE0918F1AA5}" dt="2024-04-27T19:05:37.490" v="550" actId="20577"/>
        <pc:sldMkLst>
          <pc:docMk/>
          <pc:sldMk cId="1558932368" sldId="258"/>
        </pc:sldMkLst>
        <pc:spChg chg="add mod">
          <ac:chgData name="Jurre Kamphorst" userId="ea5a6d19-7a1a-404d-92c1-711466574960" providerId="ADAL" clId="{D1279864-D82F-434A-8001-0CE0918F1AA5}" dt="2024-04-27T19:02:46.266" v="480" actId="1076"/>
          <ac:spMkLst>
            <pc:docMk/>
            <pc:sldMk cId="1558932368" sldId="258"/>
            <ac:spMk id="5" creationId="{1AD1843E-78C2-717E-46C9-2090D89968C2}"/>
          </ac:spMkLst>
        </pc:spChg>
        <pc:graphicFrameChg chg="add mod modGraphic">
          <ac:chgData name="Jurre Kamphorst" userId="ea5a6d19-7a1a-404d-92c1-711466574960" providerId="ADAL" clId="{D1279864-D82F-434A-8001-0CE0918F1AA5}" dt="2024-04-27T19:05:37.490" v="550" actId="20577"/>
          <ac:graphicFrameMkLst>
            <pc:docMk/>
            <pc:sldMk cId="1558932368" sldId="258"/>
            <ac:graphicFrameMk id="3" creationId="{E5240DA8-BD9D-A1EC-FA81-4F4863242403}"/>
          </ac:graphicFrameMkLst>
        </pc:graphicFrameChg>
      </pc:sldChg>
    </pc:docChg>
  </pc:docChgLst>
  <pc:docChgLst>
    <pc:chgData name="Masoumeh Dorrani" userId="f1b866bf-7ec0-415e-ae95-1f794ec63dbe" providerId="ADAL" clId="{467A78D3-1F29-44AD-A554-8D53A9FD615D}"/>
    <pc:docChg chg="undo custSel modSld">
      <pc:chgData name="Masoumeh Dorrani" userId="f1b866bf-7ec0-415e-ae95-1f794ec63dbe" providerId="ADAL" clId="{467A78D3-1F29-44AD-A554-8D53A9FD615D}" dt="2024-04-01T15:50:14.772" v="160" actId="20577"/>
      <pc:docMkLst>
        <pc:docMk/>
      </pc:docMkLst>
      <pc:sldChg chg="addSp modSp mod">
        <pc:chgData name="Masoumeh Dorrani" userId="f1b866bf-7ec0-415e-ae95-1f794ec63dbe" providerId="ADAL" clId="{467A78D3-1F29-44AD-A554-8D53A9FD615D}" dt="2024-04-01T15:50:14.772" v="160" actId="20577"/>
        <pc:sldMkLst>
          <pc:docMk/>
          <pc:sldMk cId="1513836502" sldId="257"/>
        </pc:sldMkLst>
        <pc:spChg chg="mod">
          <ac:chgData name="Masoumeh Dorrani" userId="f1b866bf-7ec0-415e-ae95-1f794ec63dbe" providerId="ADAL" clId="{467A78D3-1F29-44AD-A554-8D53A9FD615D}" dt="2024-04-01T15:48:17.047" v="140" actId="1036"/>
          <ac:spMkLst>
            <pc:docMk/>
            <pc:sldMk cId="1513836502" sldId="257"/>
            <ac:spMk id="2" creationId="{23178C4D-B3E8-0972-3C3E-97795B3FAE5A}"/>
          </ac:spMkLst>
        </pc:spChg>
        <pc:spChg chg="mod">
          <ac:chgData name="Masoumeh Dorrani" userId="f1b866bf-7ec0-415e-ae95-1f794ec63dbe" providerId="ADAL" clId="{467A78D3-1F29-44AD-A554-8D53A9FD615D}" dt="2024-04-01T15:48:17.047" v="140" actId="1036"/>
          <ac:spMkLst>
            <pc:docMk/>
            <pc:sldMk cId="1513836502" sldId="257"/>
            <ac:spMk id="3" creationId="{6663A3A0-76F2-0D7C-2966-64BE4EB0C795}"/>
          </ac:spMkLst>
        </pc:spChg>
        <pc:spChg chg="mod">
          <ac:chgData name="Masoumeh Dorrani" userId="f1b866bf-7ec0-415e-ae95-1f794ec63dbe" providerId="ADAL" clId="{467A78D3-1F29-44AD-A554-8D53A9FD615D}" dt="2024-04-01T15:48:17.047" v="140" actId="1036"/>
          <ac:spMkLst>
            <pc:docMk/>
            <pc:sldMk cId="1513836502" sldId="257"/>
            <ac:spMk id="4" creationId="{05D71F9E-B5D0-675D-A974-D7FBFCF97FC6}"/>
          </ac:spMkLst>
        </pc:spChg>
        <pc:spChg chg="mod">
          <ac:chgData name="Masoumeh Dorrani" userId="f1b866bf-7ec0-415e-ae95-1f794ec63dbe" providerId="ADAL" clId="{467A78D3-1F29-44AD-A554-8D53A9FD615D}" dt="2024-04-01T15:48:27.583" v="142" actId="1076"/>
          <ac:spMkLst>
            <pc:docMk/>
            <pc:sldMk cId="1513836502" sldId="257"/>
            <ac:spMk id="7" creationId="{AA57A387-6A37-29F1-FA89-A2EC284EFBB3}"/>
          </ac:spMkLst>
        </pc:spChg>
        <pc:spChg chg="mod">
          <ac:chgData name="Masoumeh Dorrani" userId="f1b866bf-7ec0-415e-ae95-1f794ec63dbe" providerId="ADAL" clId="{467A78D3-1F29-44AD-A554-8D53A9FD615D}" dt="2024-04-01T15:48:22.799" v="141" actId="1076"/>
          <ac:spMkLst>
            <pc:docMk/>
            <pc:sldMk cId="1513836502" sldId="257"/>
            <ac:spMk id="11" creationId="{707FA75D-51F5-4DA9-13BA-6D49DE9EDC59}"/>
          </ac:spMkLst>
        </pc:spChg>
        <pc:spChg chg="mod">
          <ac:chgData name="Masoumeh Dorrani" userId="f1b866bf-7ec0-415e-ae95-1f794ec63dbe" providerId="ADAL" clId="{467A78D3-1F29-44AD-A554-8D53A9FD615D}" dt="2024-04-01T15:48:17.047" v="140" actId="1036"/>
          <ac:spMkLst>
            <pc:docMk/>
            <pc:sldMk cId="1513836502" sldId="257"/>
            <ac:spMk id="12" creationId="{795E2299-F25A-524C-20B4-04281C9922DE}"/>
          </ac:spMkLst>
        </pc:spChg>
        <pc:spChg chg="mod">
          <ac:chgData name="Masoumeh Dorrani" userId="f1b866bf-7ec0-415e-ae95-1f794ec63dbe" providerId="ADAL" clId="{467A78D3-1F29-44AD-A554-8D53A9FD615D}" dt="2024-04-01T15:50:08.774" v="158" actId="1037"/>
          <ac:spMkLst>
            <pc:docMk/>
            <pc:sldMk cId="1513836502" sldId="257"/>
            <ac:spMk id="13" creationId="{0976A6DC-434F-ABDF-B33E-93437D308A97}"/>
          </ac:spMkLst>
        </pc:spChg>
        <pc:spChg chg="mod">
          <ac:chgData name="Masoumeh Dorrani" userId="f1b866bf-7ec0-415e-ae95-1f794ec63dbe" providerId="ADAL" clId="{467A78D3-1F29-44AD-A554-8D53A9FD615D}" dt="2024-04-01T15:48:17.047" v="140" actId="1036"/>
          <ac:spMkLst>
            <pc:docMk/>
            <pc:sldMk cId="1513836502" sldId="257"/>
            <ac:spMk id="14" creationId="{8372945B-B951-EB93-B514-376187D7AFC7}"/>
          </ac:spMkLst>
        </pc:spChg>
        <pc:spChg chg="mod">
          <ac:chgData name="Masoumeh Dorrani" userId="f1b866bf-7ec0-415e-ae95-1f794ec63dbe" providerId="ADAL" clId="{467A78D3-1F29-44AD-A554-8D53A9FD615D}" dt="2024-04-01T15:50:14.772" v="160" actId="20577"/>
          <ac:spMkLst>
            <pc:docMk/>
            <pc:sldMk cId="1513836502" sldId="257"/>
            <ac:spMk id="15" creationId="{FEDC7601-69C5-C220-8BDB-3D333F257196}"/>
          </ac:spMkLst>
        </pc:spChg>
        <pc:spChg chg="mod">
          <ac:chgData name="Masoumeh Dorrani" userId="f1b866bf-7ec0-415e-ae95-1f794ec63dbe" providerId="ADAL" clId="{467A78D3-1F29-44AD-A554-8D53A9FD615D}" dt="2024-04-01T15:48:17.047" v="140" actId="1036"/>
          <ac:spMkLst>
            <pc:docMk/>
            <pc:sldMk cId="1513836502" sldId="257"/>
            <ac:spMk id="16" creationId="{FBB68053-39C8-EC22-174B-71DDDCE5E02F}"/>
          </ac:spMkLst>
        </pc:spChg>
        <pc:spChg chg="mod">
          <ac:chgData name="Masoumeh Dorrani" userId="f1b866bf-7ec0-415e-ae95-1f794ec63dbe" providerId="ADAL" clId="{467A78D3-1F29-44AD-A554-8D53A9FD615D}" dt="2024-04-01T15:48:17.047" v="140" actId="1036"/>
          <ac:spMkLst>
            <pc:docMk/>
            <pc:sldMk cId="1513836502" sldId="257"/>
            <ac:spMk id="17" creationId="{112571CC-5B9A-83EB-5C2F-98A17578FB4D}"/>
          </ac:spMkLst>
        </pc:spChg>
        <pc:spChg chg="mod">
          <ac:chgData name="Masoumeh Dorrani" userId="f1b866bf-7ec0-415e-ae95-1f794ec63dbe" providerId="ADAL" clId="{467A78D3-1F29-44AD-A554-8D53A9FD615D}" dt="2024-04-01T15:48:17.047" v="140" actId="1036"/>
          <ac:spMkLst>
            <pc:docMk/>
            <pc:sldMk cId="1513836502" sldId="257"/>
            <ac:spMk id="18" creationId="{7AC47DDF-5484-8915-5478-6C7E91F0D8E3}"/>
          </ac:spMkLst>
        </pc:spChg>
        <pc:spChg chg="mod">
          <ac:chgData name="Masoumeh Dorrani" userId="f1b866bf-7ec0-415e-ae95-1f794ec63dbe" providerId="ADAL" clId="{467A78D3-1F29-44AD-A554-8D53A9FD615D}" dt="2024-04-01T15:48:17.047" v="140" actId="1036"/>
          <ac:spMkLst>
            <pc:docMk/>
            <pc:sldMk cId="1513836502" sldId="257"/>
            <ac:spMk id="19" creationId="{56B0C2D8-0896-4A4D-40DF-97DEE22C7C69}"/>
          </ac:spMkLst>
        </pc:spChg>
        <pc:spChg chg="mod">
          <ac:chgData name="Masoumeh Dorrani" userId="f1b866bf-7ec0-415e-ae95-1f794ec63dbe" providerId="ADAL" clId="{467A78D3-1F29-44AD-A554-8D53A9FD615D}" dt="2024-04-01T15:48:17.047" v="140" actId="1036"/>
          <ac:spMkLst>
            <pc:docMk/>
            <pc:sldMk cId="1513836502" sldId="257"/>
            <ac:spMk id="20" creationId="{2206C8CF-63CC-DD81-F21D-E4652D3B8719}"/>
          </ac:spMkLst>
        </pc:spChg>
        <pc:spChg chg="mod">
          <ac:chgData name="Masoumeh Dorrani" userId="f1b866bf-7ec0-415e-ae95-1f794ec63dbe" providerId="ADAL" clId="{467A78D3-1F29-44AD-A554-8D53A9FD615D}" dt="2024-04-01T15:48:17.047" v="140" actId="1036"/>
          <ac:spMkLst>
            <pc:docMk/>
            <pc:sldMk cId="1513836502" sldId="257"/>
            <ac:spMk id="21" creationId="{25824043-C488-F444-2EDF-CDFC8E5F2E2E}"/>
          </ac:spMkLst>
        </pc:spChg>
        <pc:spChg chg="mod">
          <ac:chgData name="Masoumeh Dorrani" userId="f1b866bf-7ec0-415e-ae95-1f794ec63dbe" providerId="ADAL" clId="{467A78D3-1F29-44AD-A554-8D53A9FD615D}" dt="2024-04-01T15:48:17.047" v="140" actId="1036"/>
          <ac:spMkLst>
            <pc:docMk/>
            <pc:sldMk cId="1513836502" sldId="257"/>
            <ac:spMk id="22" creationId="{9C92F6D7-A62B-302D-3378-4DC04F3A4E4A}"/>
          </ac:spMkLst>
        </pc:spChg>
        <pc:spChg chg="mod">
          <ac:chgData name="Masoumeh Dorrani" userId="f1b866bf-7ec0-415e-ae95-1f794ec63dbe" providerId="ADAL" clId="{467A78D3-1F29-44AD-A554-8D53A9FD615D}" dt="2024-04-01T15:48:17.047" v="140" actId="1036"/>
          <ac:spMkLst>
            <pc:docMk/>
            <pc:sldMk cId="1513836502" sldId="257"/>
            <ac:spMk id="23" creationId="{76B8971D-809F-9B22-8E20-C7B637848CF0}"/>
          </ac:spMkLst>
        </pc:spChg>
        <pc:spChg chg="mod">
          <ac:chgData name="Masoumeh Dorrani" userId="f1b866bf-7ec0-415e-ae95-1f794ec63dbe" providerId="ADAL" clId="{467A78D3-1F29-44AD-A554-8D53A9FD615D}" dt="2024-04-01T15:48:17.047" v="140" actId="1036"/>
          <ac:spMkLst>
            <pc:docMk/>
            <pc:sldMk cId="1513836502" sldId="257"/>
            <ac:spMk id="24" creationId="{AC3A98BB-AD6A-FE79-1956-01195F27C969}"/>
          </ac:spMkLst>
        </pc:spChg>
        <pc:spChg chg="mod">
          <ac:chgData name="Masoumeh Dorrani" userId="f1b866bf-7ec0-415e-ae95-1f794ec63dbe" providerId="ADAL" clId="{467A78D3-1F29-44AD-A554-8D53A9FD615D}" dt="2024-04-01T15:48:17.047" v="140" actId="1036"/>
          <ac:spMkLst>
            <pc:docMk/>
            <pc:sldMk cId="1513836502" sldId="257"/>
            <ac:spMk id="25" creationId="{8DDDC64A-B184-8DBA-7081-961B56236075}"/>
          </ac:spMkLst>
        </pc:spChg>
        <pc:spChg chg="mod">
          <ac:chgData name="Masoumeh Dorrani" userId="f1b866bf-7ec0-415e-ae95-1f794ec63dbe" providerId="ADAL" clId="{467A78D3-1F29-44AD-A554-8D53A9FD615D}" dt="2024-04-01T15:48:17.047" v="140" actId="1036"/>
          <ac:spMkLst>
            <pc:docMk/>
            <pc:sldMk cId="1513836502" sldId="257"/>
            <ac:spMk id="26" creationId="{371D19EE-1274-C98E-F470-99C29AD29DDF}"/>
          </ac:spMkLst>
        </pc:spChg>
        <pc:spChg chg="mod">
          <ac:chgData name="Masoumeh Dorrani" userId="f1b866bf-7ec0-415e-ae95-1f794ec63dbe" providerId="ADAL" clId="{467A78D3-1F29-44AD-A554-8D53A9FD615D}" dt="2024-04-01T15:48:17.047" v="140" actId="1036"/>
          <ac:spMkLst>
            <pc:docMk/>
            <pc:sldMk cId="1513836502" sldId="257"/>
            <ac:spMk id="27" creationId="{E5365B10-B19F-EB22-7AF3-F278D3361946}"/>
          </ac:spMkLst>
        </pc:spChg>
        <pc:spChg chg="mod">
          <ac:chgData name="Masoumeh Dorrani" userId="f1b866bf-7ec0-415e-ae95-1f794ec63dbe" providerId="ADAL" clId="{467A78D3-1F29-44AD-A554-8D53A9FD615D}" dt="2024-04-01T15:48:17.047" v="140" actId="1036"/>
          <ac:spMkLst>
            <pc:docMk/>
            <pc:sldMk cId="1513836502" sldId="257"/>
            <ac:spMk id="28" creationId="{F160C26A-389B-D034-A5E8-8B13A79F4A17}"/>
          </ac:spMkLst>
        </pc:spChg>
        <pc:spChg chg="mod">
          <ac:chgData name="Masoumeh Dorrani" userId="f1b866bf-7ec0-415e-ae95-1f794ec63dbe" providerId="ADAL" clId="{467A78D3-1F29-44AD-A554-8D53A9FD615D}" dt="2024-04-01T15:48:17.047" v="140" actId="1036"/>
          <ac:spMkLst>
            <pc:docMk/>
            <pc:sldMk cId="1513836502" sldId="257"/>
            <ac:spMk id="29" creationId="{1A6EA7AD-F480-7C11-11BB-E91B3626149D}"/>
          </ac:spMkLst>
        </pc:spChg>
        <pc:spChg chg="mod">
          <ac:chgData name="Masoumeh Dorrani" userId="f1b866bf-7ec0-415e-ae95-1f794ec63dbe" providerId="ADAL" clId="{467A78D3-1F29-44AD-A554-8D53A9FD615D}" dt="2024-04-01T15:48:17.047" v="140" actId="1036"/>
          <ac:spMkLst>
            <pc:docMk/>
            <pc:sldMk cId="1513836502" sldId="257"/>
            <ac:spMk id="30" creationId="{7E17D839-3216-58AA-F928-C4B4254C2313}"/>
          </ac:spMkLst>
        </pc:spChg>
        <pc:spChg chg="mod">
          <ac:chgData name="Masoumeh Dorrani" userId="f1b866bf-7ec0-415e-ae95-1f794ec63dbe" providerId="ADAL" clId="{467A78D3-1F29-44AD-A554-8D53A9FD615D}" dt="2024-04-01T15:48:17.047" v="140" actId="1036"/>
          <ac:spMkLst>
            <pc:docMk/>
            <pc:sldMk cId="1513836502" sldId="257"/>
            <ac:spMk id="31" creationId="{CBCDD704-3512-11B0-0E89-6B24DE0EF0CB}"/>
          </ac:spMkLst>
        </pc:spChg>
        <pc:spChg chg="mod">
          <ac:chgData name="Masoumeh Dorrani" userId="f1b866bf-7ec0-415e-ae95-1f794ec63dbe" providerId="ADAL" clId="{467A78D3-1F29-44AD-A554-8D53A9FD615D}" dt="2024-04-01T15:48:17.047" v="140" actId="1036"/>
          <ac:spMkLst>
            <pc:docMk/>
            <pc:sldMk cId="1513836502" sldId="257"/>
            <ac:spMk id="32" creationId="{5CC48951-609F-0355-F717-D83AA823E981}"/>
          </ac:spMkLst>
        </pc:spChg>
        <pc:spChg chg="mod">
          <ac:chgData name="Masoumeh Dorrani" userId="f1b866bf-7ec0-415e-ae95-1f794ec63dbe" providerId="ADAL" clId="{467A78D3-1F29-44AD-A554-8D53A9FD615D}" dt="2024-04-01T15:48:17.047" v="140" actId="1036"/>
          <ac:spMkLst>
            <pc:docMk/>
            <pc:sldMk cId="1513836502" sldId="257"/>
            <ac:spMk id="33" creationId="{3E4AA37B-335F-D581-968E-44EDD695E211}"/>
          </ac:spMkLst>
        </pc:spChg>
        <pc:spChg chg="mod">
          <ac:chgData name="Masoumeh Dorrani" userId="f1b866bf-7ec0-415e-ae95-1f794ec63dbe" providerId="ADAL" clId="{467A78D3-1F29-44AD-A554-8D53A9FD615D}" dt="2024-04-01T15:48:17.047" v="140" actId="1036"/>
          <ac:spMkLst>
            <pc:docMk/>
            <pc:sldMk cId="1513836502" sldId="257"/>
            <ac:spMk id="34" creationId="{0B5A5E84-121C-878D-4FBD-01C56E9FB6C5}"/>
          </ac:spMkLst>
        </pc:spChg>
        <pc:spChg chg="mod">
          <ac:chgData name="Masoumeh Dorrani" userId="f1b866bf-7ec0-415e-ae95-1f794ec63dbe" providerId="ADAL" clId="{467A78D3-1F29-44AD-A554-8D53A9FD615D}" dt="2024-04-01T15:48:17.047" v="140" actId="1036"/>
          <ac:spMkLst>
            <pc:docMk/>
            <pc:sldMk cId="1513836502" sldId="257"/>
            <ac:spMk id="35" creationId="{2C8DA58C-1FEB-46E6-33BB-0527ECCF1B3B}"/>
          </ac:spMkLst>
        </pc:spChg>
        <pc:spChg chg="mod">
          <ac:chgData name="Masoumeh Dorrani" userId="f1b866bf-7ec0-415e-ae95-1f794ec63dbe" providerId="ADAL" clId="{467A78D3-1F29-44AD-A554-8D53A9FD615D}" dt="2024-04-01T15:48:17.047" v="140" actId="1036"/>
          <ac:spMkLst>
            <pc:docMk/>
            <pc:sldMk cId="1513836502" sldId="257"/>
            <ac:spMk id="36" creationId="{9D536413-47A7-40F6-9E6B-3E19BA6C44AC}"/>
          </ac:spMkLst>
        </pc:spChg>
        <pc:spChg chg="mod">
          <ac:chgData name="Masoumeh Dorrani" userId="f1b866bf-7ec0-415e-ae95-1f794ec63dbe" providerId="ADAL" clId="{467A78D3-1F29-44AD-A554-8D53A9FD615D}" dt="2024-04-01T15:48:17.047" v="140" actId="1036"/>
          <ac:spMkLst>
            <pc:docMk/>
            <pc:sldMk cId="1513836502" sldId="257"/>
            <ac:spMk id="37" creationId="{C37DC5DE-3C58-D922-17B0-C0D15B906CDC}"/>
          </ac:spMkLst>
        </pc:spChg>
        <pc:spChg chg="mod">
          <ac:chgData name="Masoumeh Dorrani" userId="f1b866bf-7ec0-415e-ae95-1f794ec63dbe" providerId="ADAL" clId="{467A78D3-1F29-44AD-A554-8D53A9FD615D}" dt="2024-04-01T15:48:17.047" v="140" actId="1036"/>
          <ac:spMkLst>
            <pc:docMk/>
            <pc:sldMk cId="1513836502" sldId="257"/>
            <ac:spMk id="38" creationId="{6886DF27-9E5D-B687-792C-872E2ED6CBB9}"/>
          </ac:spMkLst>
        </pc:spChg>
        <pc:spChg chg="mod">
          <ac:chgData name="Masoumeh Dorrani" userId="f1b866bf-7ec0-415e-ae95-1f794ec63dbe" providerId="ADAL" clId="{467A78D3-1F29-44AD-A554-8D53A9FD615D}" dt="2024-04-01T15:48:17.047" v="140" actId="1036"/>
          <ac:spMkLst>
            <pc:docMk/>
            <pc:sldMk cId="1513836502" sldId="257"/>
            <ac:spMk id="39" creationId="{F84C9252-40E9-D4EC-AB78-2510F2ECA93F}"/>
          </ac:spMkLst>
        </pc:spChg>
        <pc:spChg chg="mod">
          <ac:chgData name="Masoumeh Dorrani" userId="f1b866bf-7ec0-415e-ae95-1f794ec63dbe" providerId="ADAL" clId="{467A78D3-1F29-44AD-A554-8D53A9FD615D}" dt="2024-04-01T15:48:17.047" v="140" actId="1036"/>
          <ac:spMkLst>
            <pc:docMk/>
            <pc:sldMk cId="1513836502" sldId="257"/>
            <ac:spMk id="40" creationId="{1CC3B4FC-150B-AE9F-36A2-D6E4F07380C8}"/>
          </ac:spMkLst>
        </pc:spChg>
        <pc:spChg chg="mod">
          <ac:chgData name="Masoumeh Dorrani" userId="f1b866bf-7ec0-415e-ae95-1f794ec63dbe" providerId="ADAL" clId="{467A78D3-1F29-44AD-A554-8D53A9FD615D}" dt="2024-04-01T15:48:17.047" v="140" actId="1036"/>
          <ac:spMkLst>
            <pc:docMk/>
            <pc:sldMk cId="1513836502" sldId="257"/>
            <ac:spMk id="41" creationId="{B6ECD60F-9FB1-334A-26ED-85E4D42FDEEA}"/>
          </ac:spMkLst>
        </pc:spChg>
        <pc:spChg chg="mod">
          <ac:chgData name="Masoumeh Dorrani" userId="f1b866bf-7ec0-415e-ae95-1f794ec63dbe" providerId="ADAL" clId="{467A78D3-1F29-44AD-A554-8D53A9FD615D}" dt="2024-04-01T15:48:17.047" v="140" actId="1036"/>
          <ac:spMkLst>
            <pc:docMk/>
            <pc:sldMk cId="1513836502" sldId="257"/>
            <ac:spMk id="42" creationId="{C6182264-ACA9-9FE7-E092-96E3038FFA4B}"/>
          </ac:spMkLst>
        </pc:spChg>
        <pc:spChg chg="mod">
          <ac:chgData name="Masoumeh Dorrani" userId="f1b866bf-7ec0-415e-ae95-1f794ec63dbe" providerId="ADAL" clId="{467A78D3-1F29-44AD-A554-8D53A9FD615D}" dt="2024-04-01T15:48:17.047" v="140" actId="1036"/>
          <ac:spMkLst>
            <pc:docMk/>
            <pc:sldMk cId="1513836502" sldId="257"/>
            <ac:spMk id="43" creationId="{67AA7E1B-DD5F-3D1F-4986-5BB01A9DCCB6}"/>
          </ac:spMkLst>
        </pc:spChg>
        <pc:spChg chg="mod">
          <ac:chgData name="Masoumeh Dorrani" userId="f1b866bf-7ec0-415e-ae95-1f794ec63dbe" providerId="ADAL" clId="{467A78D3-1F29-44AD-A554-8D53A9FD615D}" dt="2024-04-01T15:48:17.047" v="140" actId="1036"/>
          <ac:spMkLst>
            <pc:docMk/>
            <pc:sldMk cId="1513836502" sldId="257"/>
            <ac:spMk id="44" creationId="{BB9F9508-D1C0-228A-6900-3A62E9B34746}"/>
          </ac:spMkLst>
        </pc:spChg>
        <pc:spChg chg="mod">
          <ac:chgData name="Masoumeh Dorrani" userId="f1b866bf-7ec0-415e-ae95-1f794ec63dbe" providerId="ADAL" clId="{467A78D3-1F29-44AD-A554-8D53A9FD615D}" dt="2024-04-01T15:48:17.047" v="140" actId="1036"/>
          <ac:spMkLst>
            <pc:docMk/>
            <pc:sldMk cId="1513836502" sldId="257"/>
            <ac:spMk id="45" creationId="{9FB3F477-B8B5-4862-0969-6D60FD77BD35}"/>
          </ac:spMkLst>
        </pc:spChg>
        <pc:spChg chg="mod">
          <ac:chgData name="Masoumeh Dorrani" userId="f1b866bf-7ec0-415e-ae95-1f794ec63dbe" providerId="ADAL" clId="{467A78D3-1F29-44AD-A554-8D53A9FD615D}" dt="2024-04-01T15:48:17.047" v="140" actId="1036"/>
          <ac:spMkLst>
            <pc:docMk/>
            <pc:sldMk cId="1513836502" sldId="257"/>
            <ac:spMk id="46" creationId="{17DA22EE-2898-393E-6A96-54F92CAE588B}"/>
          </ac:spMkLst>
        </pc:spChg>
        <pc:spChg chg="mod">
          <ac:chgData name="Masoumeh Dorrani" userId="f1b866bf-7ec0-415e-ae95-1f794ec63dbe" providerId="ADAL" clId="{467A78D3-1F29-44AD-A554-8D53A9FD615D}" dt="2024-04-01T15:48:17.047" v="140" actId="1036"/>
          <ac:spMkLst>
            <pc:docMk/>
            <pc:sldMk cId="1513836502" sldId="257"/>
            <ac:spMk id="47" creationId="{95E1A0AF-2B01-DB92-2743-EB8744AA60C5}"/>
          </ac:spMkLst>
        </pc:spChg>
        <pc:spChg chg="mod">
          <ac:chgData name="Masoumeh Dorrani" userId="f1b866bf-7ec0-415e-ae95-1f794ec63dbe" providerId="ADAL" clId="{467A78D3-1F29-44AD-A554-8D53A9FD615D}" dt="2024-04-01T15:48:17.047" v="140" actId="1036"/>
          <ac:spMkLst>
            <pc:docMk/>
            <pc:sldMk cId="1513836502" sldId="257"/>
            <ac:spMk id="48" creationId="{06FF1907-F78C-29A8-EFF8-B366E4EA7805}"/>
          </ac:spMkLst>
        </pc:spChg>
        <pc:spChg chg="mod">
          <ac:chgData name="Masoumeh Dorrani" userId="f1b866bf-7ec0-415e-ae95-1f794ec63dbe" providerId="ADAL" clId="{467A78D3-1F29-44AD-A554-8D53A9FD615D}" dt="2024-04-01T15:48:17.047" v="140" actId="1036"/>
          <ac:spMkLst>
            <pc:docMk/>
            <pc:sldMk cId="1513836502" sldId="257"/>
            <ac:spMk id="49" creationId="{C281BE37-5B8C-3843-F9B1-F0A7ACD60698}"/>
          </ac:spMkLst>
        </pc:spChg>
        <pc:spChg chg="mod">
          <ac:chgData name="Masoumeh Dorrani" userId="f1b866bf-7ec0-415e-ae95-1f794ec63dbe" providerId="ADAL" clId="{467A78D3-1F29-44AD-A554-8D53A9FD615D}" dt="2024-04-01T15:48:17.047" v="140" actId="1036"/>
          <ac:spMkLst>
            <pc:docMk/>
            <pc:sldMk cId="1513836502" sldId="257"/>
            <ac:spMk id="50" creationId="{38AD9FFB-DC61-09B8-B182-5550C0F08BBD}"/>
          </ac:spMkLst>
        </pc:spChg>
        <pc:spChg chg="add mod">
          <ac:chgData name="Masoumeh Dorrani" userId="f1b866bf-7ec0-415e-ae95-1f794ec63dbe" providerId="ADAL" clId="{467A78D3-1F29-44AD-A554-8D53A9FD615D}" dt="2024-04-01T15:49:55.171" v="151" actId="1076"/>
          <ac:spMkLst>
            <pc:docMk/>
            <pc:sldMk cId="1513836502" sldId="257"/>
            <ac:spMk id="51" creationId="{B4F956EC-92E9-EBB1-04BF-C1112D014113}"/>
          </ac:spMkLst>
        </pc:spChg>
        <pc:picChg chg="mod">
          <ac:chgData name="Masoumeh Dorrani" userId="f1b866bf-7ec0-415e-ae95-1f794ec63dbe" providerId="ADAL" clId="{467A78D3-1F29-44AD-A554-8D53A9FD615D}" dt="2024-04-01T15:49:03.994" v="145" actId="1076"/>
          <ac:picMkLst>
            <pc:docMk/>
            <pc:sldMk cId="1513836502" sldId="257"/>
            <ac:picMk id="9" creationId="{44CC0774-80FF-3536-F886-04E7BE147407}"/>
          </ac:picMkLst>
        </pc:picChg>
        <pc:picChg chg="mod">
          <ac:chgData name="Masoumeh Dorrani" userId="f1b866bf-7ec0-415e-ae95-1f794ec63dbe" providerId="ADAL" clId="{467A78D3-1F29-44AD-A554-8D53A9FD615D}" dt="2024-04-01T15:48:17.047" v="140" actId="1036"/>
          <ac:picMkLst>
            <pc:docMk/>
            <pc:sldMk cId="1513836502" sldId="257"/>
            <ac:picMk id="10" creationId="{E0DF2F7C-8369-9D76-C6FE-899597A3FECD}"/>
          </ac:picMkLst>
        </pc:pic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myolaris.sharepoint.com/sites/OlarisFiles/Shared%20Documents/Science/MS_Metabolomics/MS_HILIC_Global_Panel/Global%20method%20validation/specific%20gravity%20and%20PH%20trials/SG_Evaluation_for_ASMS_Poster_JK_51523.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myolaris.sharepoint.com/sites/OlarisFiles/Shared%20Documents/Science/MS_Metabolomics/MS_HILIC_Global_Panel/Global%20method%20validation/specific%20gravity%20and%20PH%20trials/SG_Evaluation_for_ASMS_Poster_JK_51523.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https://myolaris.sharepoint.com/sites/OlarisFiles/Shared%20Documents/Science/MS_Metabolomics/MS_HILIC_Global_Panel/Global%20method%20validation/specific%20gravity%20and%20PH%20trials/SG_Evaluation_for_ASMS_Poster_JK_51523.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https://myolaris.sharepoint.com/sites/OlarisFiles/Shared%20Documents/Science/MS_Metabolomics/MS_HILIC_Global_Panel/Global%20method%20validation/specific%20gravity%20and%20PH%20trials/SG_Evaluation_for_ASMS_Poster_JK_51523.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https://myolaris.sharepoint.com/sites/OlarisFiles/Shared%20Documents/Communications/Pub%20Planning/MetabolitesSpecialIssue/MS%20Paper/Figures/Figure2_Data/13C_internal%20standards_Pie%20chart.xlsx" TargetMode="External"/><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AB$181</c:f>
              <c:strCache>
                <c:ptCount val="1"/>
                <c:pt idx="0">
                  <c:v>AVG Ratio</c:v>
                </c:pt>
              </c:strCache>
            </c:strRef>
          </c:tx>
          <c:spPr>
            <a:ln w="25400" cap="rnd">
              <a:noFill/>
              <a:round/>
            </a:ln>
            <a:effectLst/>
          </c:spPr>
          <c:marker>
            <c:symbol val="circle"/>
            <c:size val="5"/>
            <c:spPr>
              <a:solidFill>
                <a:srgbClr val="00B050"/>
              </a:solidFill>
              <a:ln w="19050">
                <a:solidFill>
                  <a:srgbClr val="00B050"/>
                </a:solidFill>
              </a:ln>
              <a:effectLst/>
            </c:spPr>
          </c:marker>
          <c:trendline>
            <c:spPr>
              <a:ln w="19050" cap="rnd">
                <a:solidFill>
                  <a:srgbClr val="00B050"/>
                </a:solidFill>
                <a:prstDash val="sysDot"/>
              </a:ln>
              <a:effectLst/>
            </c:spPr>
            <c:trendlineType val="linear"/>
            <c:dispRSqr val="1"/>
            <c:dispEq val="0"/>
            <c:trendlineLbl>
              <c:layout>
                <c:manualLayout>
                  <c:x val="2.5224051684449345E-2"/>
                  <c:y val="-0.12000236130043254"/>
                </c:manualLayout>
              </c:layout>
              <c:numFmt formatCode="General" sourceLinked="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trendlineLbl>
          </c:trendline>
          <c:errBars>
            <c:errDir val="y"/>
            <c:errBarType val="both"/>
            <c:errValType val="cust"/>
            <c:noEndCap val="0"/>
            <c:plus>
              <c:numRef>
                <c:f>Sheet1!$AC$182:$AC$187</c:f>
                <c:numCache>
                  <c:formatCode>General</c:formatCode>
                  <c:ptCount val="6"/>
                  <c:pt idx="0">
                    <c:v>1.7161420339572245E-2</c:v>
                  </c:pt>
                  <c:pt idx="1">
                    <c:v>2.7553148407618869E-2</c:v>
                  </c:pt>
                  <c:pt idx="2">
                    <c:v>1.7270703057147133E-2</c:v>
                  </c:pt>
                  <c:pt idx="3">
                    <c:v>0.14497640172696097</c:v>
                  </c:pt>
                  <c:pt idx="4">
                    <c:v>7.7562282974826804E-3</c:v>
                  </c:pt>
                  <c:pt idx="5">
                    <c:v>0.24359740281735573</c:v>
                  </c:pt>
                </c:numCache>
              </c:numRef>
            </c:plus>
            <c:minus>
              <c:numRef>
                <c:f>Sheet1!$AC$182:$AC$187</c:f>
                <c:numCache>
                  <c:formatCode>General</c:formatCode>
                  <c:ptCount val="6"/>
                  <c:pt idx="0">
                    <c:v>1.7161420339572245E-2</c:v>
                  </c:pt>
                  <c:pt idx="1">
                    <c:v>2.7553148407618869E-2</c:v>
                  </c:pt>
                  <c:pt idx="2">
                    <c:v>1.7270703057147133E-2</c:v>
                  </c:pt>
                  <c:pt idx="3">
                    <c:v>0.14497640172696097</c:v>
                  </c:pt>
                  <c:pt idx="4">
                    <c:v>7.7562282974826804E-3</c:v>
                  </c:pt>
                  <c:pt idx="5">
                    <c:v>0.24359740281735573</c:v>
                  </c:pt>
                </c:numCache>
              </c:numRef>
            </c:minus>
            <c:spPr>
              <a:noFill/>
              <a:ln w="12700" cap="flat" cmpd="sng" algn="ctr">
                <a:solidFill>
                  <a:schemeClr val="tx1"/>
                </a:solidFill>
                <a:round/>
              </a:ln>
              <a:effectLst/>
            </c:spPr>
          </c:errBars>
          <c:xVal>
            <c:numRef>
              <c:f>Sheet1!$AA$182:$AA$187</c:f>
              <c:numCache>
                <c:formatCode>General</c:formatCode>
                <c:ptCount val="6"/>
                <c:pt idx="0">
                  <c:v>0.2</c:v>
                </c:pt>
                <c:pt idx="1">
                  <c:v>0.5</c:v>
                </c:pt>
                <c:pt idx="2">
                  <c:v>1</c:v>
                </c:pt>
                <c:pt idx="3">
                  <c:v>2</c:v>
                </c:pt>
                <c:pt idx="4">
                  <c:v>4</c:v>
                </c:pt>
                <c:pt idx="5">
                  <c:v>6</c:v>
                </c:pt>
              </c:numCache>
            </c:numRef>
          </c:xVal>
          <c:yVal>
            <c:numRef>
              <c:f>Sheet1!$AB$182:$AB$187</c:f>
              <c:numCache>
                <c:formatCode>General</c:formatCode>
                <c:ptCount val="6"/>
                <c:pt idx="0">
                  <c:v>0.11204661174536061</c:v>
                </c:pt>
                <c:pt idx="1">
                  <c:v>0.33932742535731891</c:v>
                </c:pt>
                <c:pt idx="2">
                  <c:v>0.62888266233914447</c:v>
                </c:pt>
                <c:pt idx="3">
                  <c:v>1.346638684526873</c:v>
                </c:pt>
                <c:pt idx="4">
                  <c:v>2.3510224933037409</c:v>
                </c:pt>
                <c:pt idx="5">
                  <c:v>3.4825647513350781</c:v>
                </c:pt>
              </c:numCache>
            </c:numRef>
          </c:yVal>
          <c:smooth val="0"/>
          <c:extLst>
            <c:ext xmlns:c16="http://schemas.microsoft.com/office/drawing/2014/chart" uri="{C3380CC4-5D6E-409C-BE32-E72D297353CC}">
              <c16:uniqueId val="{00000001-0616-4801-851E-A13223A7615D}"/>
            </c:ext>
          </c:extLst>
        </c:ser>
        <c:dLbls>
          <c:showLegendKey val="0"/>
          <c:showVal val="0"/>
          <c:showCatName val="0"/>
          <c:showSerName val="0"/>
          <c:showPercent val="0"/>
          <c:showBubbleSize val="0"/>
        </c:dLbls>
        <c:axId val="1229519663"/>
        <c:axId val="1229535983"/>
      </c:scatterChart>
      <c:valAx>
        <c:axId val="1229519663"/>
        <c:scaling>
          <c:orientation val="minMax"/>
          <c:max val="6"/>
        </c:scaling>
        <c:delete val="0"/>
        <c:axPos val="b"/>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29535983"/>
        <c:crosses val="autoZero"/>
        <c:crossBetween val="midCat"/>
        <c:majorUnit val="1"/>
      </c:valAx>
      <c:valAx>
        <c:axId val="1229535983"/>
        <c:scaling>
          <c:orientation val="minMax"/>
          <c:max val="4"/>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29519663"/>
        <c:crosses val="autoZero"/>
        <c:crossBetween val="midCat"/>
        <c:majorUnit val="1"/>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25400" cap="rnd">
              <a:noFill/>
              <a:round/>
            </a:ln>
            <a:effectLst/>
          </c:spPr>
          <c:marker>
            <c:symbol val="circle"/>
            <c:size val="5"/>
            <c:spPr>
              <a:solidFill>
                <a:srgbClr val="FF0000"/>
              </a:solidFill>
              <a:ln w="19050">
                <a:solidFill>
                  <a:srgbClr val="FF0000"/>
                </a:solidFill>
              </a:ln>
              <a:effectLst/>
            </c:spPr>
          </c:marker>
          <c:errBars>
            <c:errDir val="y"/>
            <c:errBarType val="both"/>
            <c:errValType val="cust"/>
            <c:noEndCap val="0"/>
            <c:plus>
              <c:numRef>
                <c:f>Sheet1!$Q$182:$Q$187</c:f>
                <c:numCache>
                  <c:formatCode>General</c:formatCode>
                  <c:ptCount val="6"/>
                  <c:pt idx="0">
                    <c:v>3735.5013704790463</c:v>
                  </c:pt>
                  <c:pt idx="1">
                    <c:v>3597.3182087074365</c:v>
                  </c:pt>
                  <c:pt idx="2">
                    <c:v>3520.2492519071106</c:v>
                  </c:pt>
                  <c:pt idx="3">
                    <c:v>21863.257256945548</c:v>
                  </c:pt>
                  <c:pt idx="4">
                    <c:v>6044.4850842664237</c:v>
                  </c:pt>
                  <c:pt idx="5">
                    <c:v>150280.02867204932</c:v>
                  </c:pt>
                </c:numCache>
              </c:numRef>
            </c:plus>
            <c:minus>
              <c:numRef>
                <c:f>Sheet1!$Q$182:$Q$187</c:f>
                <c:numCache>
                  <c:formatCode>General</c:formatCode>
                  <c:ptCount val="6"/>
                  <c:pt idx="0">
                    <c:v>3735.5013704790463</c:v>
                  </c:pt>
                  <c:pt idx="1">
                    <c:v>3597.3182087074365</c:v>
                  </c:pt>
                  <c:pt idx="2">
                    <c:v>3520.2492519071106</c:v>
                  </c:pt>
                  <c:pt idx="3">
                    <c:v>21863.257256945548</c:v>
                  </c:pt>
                  <c:pt idx="4">
                    <c:v>6044.4850842664237</c:v>
                  </c:pt>
                  <c:pt idx="5">
                    <c:v>150280.02867204932</c:v>
                  </c:pt>
                </c:numCache>
              </c:numRef>
            </c:minus>
            <c:spPr>
              <a:noFill/>
              <a:ln w="9525" cap="flat" cmpd="sng" algn="ctr">
                <a:solidFill>
                  <a:schemeClr val="tx1">
                    <a:lumMod val="65000"/>
                    <a:lumOff val="35000"/>
                  </a:schemeClr>
                </a:solidFill>
                <a:round/>
              </a:ln>
              <a:effectLst/>
            </c:spPr>
          </c:errBars>
          <c:xVal>
            <c:numRef>
              <c:f>Sheet1!$AA$174:$AA$179</c:f>
              <c:numCache>
                <c:formatCode>General</c:formatCode>
                <c:ptCount val="6"/>
                <c:pt idx="0">
                  <c:v>0.2</c:v>
                </c:pt>
                <c:pt idx="1">
                  <c:v>0.5</c:v>
                </c:pt>
                <c:pt idx="2">
                  <c:v>1</c:v>
                </c:pt>
                <c:pt idx="3">
                  <c:v>2</c:v>
                </c:pt>
                <c:pt idx="4">
                  <c:v>4</c:v>
                </c:pt>
                <c:pt idx="5">
                  <c:v>6</c:v>
                </c:pt>
              </c:numCache>
            </c:numRef>
          </c:xVal>
          <c:yVal>
            <c:numRef>
              <c:f>Sheet1!$AB$174:$AB$179</c:f>
              <c:numCache>
                <c:formatCode>General</c:formatCode>
                <c:ptCount val="6"/>
                <c:pt idx="0">
                  <c:v>27099.451822916668</c:v>
                </c:pt>
                <c:pt idx="1">
                  <c:v>65469.299479166664</c:v>
                </c:pt>
                <c:pt idx="2">
                  <c:v>108625.04947916667</c:v>
                </c:pt>
                <c:pt idx="3">
                  <c:v>203174.02604166666</c:v>
                </c:pt>
                <c:pt idx="4">
                  <c:v>311683.01041666669</c:v>
                </c:pt>
                <c:pt idx="5">
                  <c:v>324708.38020833331</c:v>
                </c:pt>
              </c:numCache>
            </c:numRef>
          </c:yVal>
          <c:smooth val="0"/>
          <c:extLst>
            <c:ext xmlns:c16="http://schemas.microsoft.com/office/drawing/2014/chart" uri="{C3380CC4-5D6E-409C-BE32-E72D297353CC}">
              <c16:uniqueId val="{00000000-2F40-4677-BD77-AE086B730BC4}"/>
            </c:ext>
          </c:extLst>
        </c:ser>
        <c:dLbls>
          <c:showLegendKey val="0"/>
          <c:showVal val="0"/>
          <c:showCatName val="0"/>
          <c:showSerName val="0"/>
          <c:showPercent val="0"/>
          <c:showBubbleSize val="0"/>
        </c:dLbls>
        <c:axId val="1229544143"/>
        <c:axId val="1229544623"/>
      </c:scatterChart>
      <c:valAx>
        <c:axId val="1229544143"/>
        <c:scaling>
          <c:orientation val="minMax"/>
          <c:max val="6"/>
        </c:scaling>
        <c:delete val="0"/>
        <c:axPos val="b"/>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29544623"/>
        <c:crosses val="autoZero"/>
        <c:crossBetween val="midCat"/>
        <c:majorUnit val="1"/>
      </c:valAx>
      <c:valAx>
        <c:axId val="1229544623"/>
        <c:scaling>
          <c:orientation val="minMax"/>
          <c:max val="400000"/>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29544143"/>
        <c:crosses val="autoZero"/>
        <c:crossBetween val="midCat"/>
        <c:majorUnit val="100000"/>
        <c:dispUnits>
          <c:builtInUnit val="hundredThousands"/>
          <c:dispUnitsLbl>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dispUnitsLbl>
        </c:dispUnits>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AB$231</c:f>
              <c:strCache>
                <c:ptCount val="1"/>
                <c:pt idx="0">
                  <c:v>AVG Ratio</c:v>
                </c:pt>
              </c:strCache>
            </c:strRef>
          </c:tx>
          <c:spPr>
            <a:ln w="25400" cap="rnd">
              <a:noFill/>
              <a:round/>
            </a:ln>
            <a:effectLst/>
          </c:spPr>
          <c:marker>
            <c:symbol val="circle"/>
            <c:size val="5"/>
            <c:spPr>
              <a:solidFill>
                <a:srgbClr val="00B050"/>
              </a:solidFill>
              <a:ln w="19050">
                <a:solidFill>
                  <a:srgbClr val="00B050"/>
                </a:solidFill>
              </a:ln>
              <a:effectLst/>
            </c:spPr>
          </c:marker>
          <c:trendline>
            <c:spPr>
              <a:ln w="19050" cap="rnd">
                <a:solidFill>
                  <a:srgbClr val="00B050"/>
                </a:solidFill>
                <a:prstDash val="sysDot"/>
              </a:ln>
              <a:effectLst/>
            </c:spPr>
            <c:trendlineType val="linear"/>
            <c:dispRSqr val="1"/>
            <c:dispEq val="0"/>
            <c:trendlineLbl>
              <c:layout>
                <c:manualLayout>
                  <c:x val="5.295263898439858E-2"/>
                  <c:y val="-0.12973889230476723"/>
                </c:manualLayout>
              </c:layout>
              <c:numFmt formatCode="General" sourceLinked="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trendlineLbl>
          </c:trendline>
          <c:errBars>
            <c:errDir val="y"/>
            <c:errBarType val="both"/>
            <c:errValType val="cust"/>
            <c:noEndCap val="0"/>
            <c:plus>
              <c:numRef>
                <c:f>Sheet1!$AC$232:$AC$237</c:f>
                <c:numCache>
                  <c:formatCode>General</c:formatCode>
                  <c:ptCount val="6"/>
                  <c:pt idx="0">
                    <c:v>1.3625538304654586E-3</c:v>
                  </c:pt>
                  <c:pt idx="1">
                    <c:v>2.6354864639586092E-3</c:v>
                  </c:pt>
                  <c:pt idx="2">
                    <c:v>2.1767865620290839E-3</c:v>
                  </c:pt>
                  <c:pt idx="3">
                    <c:v>7.5198325820610215E-3</c:v>
                  </c:pt>
                  <c:pt idx="4">
                    <c:v>9.3819740233285279E-3</c:v>
                  </c:pt>
                  <c:pt idx="5">
                    <c:v>8.1718488737882559E-3</c:v>
                  </c:pt>
                </c:numCache>
              </c:numRef>
            </c:plus>
            <c:minus>
              <c:numRef>
                <c:f>Sheet1!$AC$232:$AC$237</c:f>
                <c:numCache>
                  <c:formatCode>General</c:formatCode>
                  <c:ptCount val="6"/>
                  <c:pt idx="0">
                    <c:v>1.3625538304654586E-3</c:v>
                  </c:pt>
                  <c:pt idx="1">
                    <c:v>2.6354864639586092E-3</c:v>
                  </c:pt>
                  <c:pt idx="2">
                    <c:v>2.1767865620290839E-3</c:v>
                  </c:pt>
                  <c:pt idx="3">
                    <c:v>7.5198325820610215E-3</c:v>
                  </c:pt>
                  <c:pt idx="4">
                    <c:v>9.3819740233285279E-3</c:v>
                  </c:pt>
                  <c:pt idx="5">
                    <c:v>8.1718488737882559E-3</c:v>
                  </c:pt>
                </c:numCache>
              </c:numRef>
            </c:minus>
            <c:spPr>
              <a:noFill/>
              <a:ln w="12700" cap="flat" cmpd="sng" algn="ctr">
                <a:solidFill>
                  <a:schemeClr val="tx1"/>
                </a:solidFill>
                <a:round/>
              </a:ln>
              <a:effectLst/>
            </c:spPr>
          </c:errBars>
          <c:xVal>
            <c:numRef>
              <c:f>Sheet1!$AA$232:$AA$237</c:f>
              <c:numCache>
                <c:formatCode>General</c:formatCode>
                <c:ptCount val="6"/>
                <c:pt idx="0">
                  <c:v>0.2</c:v>
                </c:pt>
                <c:pt idx="1">
                  <c:v>0.5</c:v>
                </c:pt>
                <c:pt idx="2">
                  <c:v>1</c:v>
                </c:pt>
                <c:pt idx="3">
                  <c:v>2</c:v>
                </c:pt>
                <c:pt idx="4">
                  <c:v>4</c:v>
                </c:pt>
                <c:pt idx="5">
                  <c:v>6</c:v>
                </c:pt>
              </c:numCache>
            </c:numRef>
          </c:xVal>
          <c:yVal>
            <c:numRef>
              <c:f>Sheet1!$AB$232:$AB$237</c:f>
              <c:numCache>
                <c:formatCode>General</c:formatCode>
                <c:ptCount val="6"/>
                <c:pt idx="0">
                  <c:v>1.4543985415168749E-2</c:v>
                </c:pt>
                <c:pt idx="1">
                  <c:v>4.7486135760389743E-2</c:v>
                </c:pt>
                <c:pt idx="2">
                  <c:v>8.3774500843558364E-2</c:v>
                </c:pt>
                <c:pt idx="3">
                  <c:v>0.15740948297081914</c:v>
                </c:pt>
                <c:pt idx="4">
                  <c:v>0.27048936811126784</c:v>
                </c:pt>
                <c:pt idx="5">
                  <c:v>0.38446301164674118</c:v>
                </c:pt>
              </c:numCache>
            </c:numRef>
          </c:yVal>
          <c:smooth val="0"/>
          <c:extLst>
            <c:ext xmlns:c16="http://schemas.microsoft.com/office/drawing/2014/chart" uri="{C3380CC4-5D6E-409C-BE32-E72D297353CC}">
              <c16:uniqueId val="{00000001-CB4D-4505-AF9F-09C4664847AD}"/>
            </c:ext>
          </c:extLst>
        </c:ser>
        <c:dLbls>
          <c:showLegendKey val="0"/>
          <c:showVal val="0"/>
          <c:showCatName val="0"/>
          <c:showSerName val="0"/>
          <c:showPercent val="0"/>
          <c:showBubbleSize val="0"/>
        </c:dLbls>
        <c:axId val="1229519663"/>
        <c:axId val="1229535983"/>
      </c:scatterChart>
      <c:valAx>
        <c:axId val="1229519663"/>
        <c:scaling>
          <c:orientation val="minMax"/>
          <c:max val="6"/>
        </c:scaling>
        <c:delete val="0"/>
        <c:axPos val="b"/>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29535983"/>
        <c:crosses val="autoZero"/>
        <c:crossBetween val="midCat"/>
        <c:majorUnit val="1"/>
      </c:valAx>
      <c:valAx>
        <c:axId val="1229535983"/>
        <c:scaling>
          <c:orientation val="minMax"/>
          <c:max val="0.4"/>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29519663"/>
        <c:crosses val="autoZero"/>
        <c:crossBetween val="midCat"/>
        <c:majorUnit val="0.1"/>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25400" cap="rnd">
              <a:noFill/>
              <a:round/>
            </a:ln>
            <a:effectLst/>
          </c:spPr>
          <c:marker>
            <c:symbol val="circle"/>
            <c:size val="5"/>
            <c:spPr>
              <a:solidFill>
                <a:srgbClr val="FF0000"/>
              </a:solidFill>
              <a:ln w="19050">
                <a:solidFill>
                  <a:srgbClr val="FF0000"/>
                </a:solidFill>
              </a:ln>
              <a:effectLst/>
            </c:spPr>
          </c:marker>
          <c:errBars>
            <c:errDir val="y"/>
            <c:errBarType val="both"/>
            <c:errValType val="cust"/>
            <c:noEndCap val="0"/>
            <c:plus>
              <c:numRef>
                <c:f>Sheet1!$Q$232:$Q$237</c:f>
                <c:numCache>
                  <c:formatCode>General</c:formatCode>
                  <c:ptCount val="6"/>
                  <c:pt idx="0">
                    <c:v>11772.37395566425</c:v>
                  </c:pt>
                  <c:pt idx="1">
                    <c:v>13528.618257675618</c:v>
                  </c:pt>
                  <c:pt idx="2">
                    <c:v>16069.989564734542</c:v>
                  </c:pt>
                  <c:pt idx="3">
                    <c:v>62102.089746986036</c:v>
                  </c:pt>
                  <c:pt idx="4">
                    <c:v>26067.936560472779</c:v>
                  </c:pt>
                  <c:pt idx="5">
                    <c:v>928502.38762988406</c:v>
                  </c:pt>
                </c:numCache>
              </c:numRef>
            </c:plus>
            <c:minus>
              <c:numRef>
                <c:f>Sheet1!$Q$232:$Q$237</c:f>
                <c:numCache>
                  <c:formatCode>General</c:formatCode>
                  <c:ptCount val="6"/>
                  <c:pt idx="0">
                    <c:v>11772.37395566425</c:v>
                  </c:pt>
                  <c:pt idx="1">
                    <c:v>13528.618257675618</c:v>
                  </c:pt>
                  <c:pt idx="2">
                    <c:v>16069.989564734542</c:v>
                  </c:pt>
                  <c:pt idx="3">
                    <c:v>62102.089746986036</c:v>
                  </c:pt>
                  <c:pt idx="4">
                    <c:v>26067.936560472779</c:v>
                  </c:pt>
                  <c:pt idx="5">
                    <c:v>928502.38762988406</c:v>
                  </c:pt>
                </c:numCache>
              </c:numRef>
            </c:minus>
            <c:spPr>
              <a:noFill/>
              <a:ln w="9525" cap="flat" cmpd="sng" algn="ctr">
                <a:solidFill>
                  <a:schemeClr val="tx1">
                    <a:lumMod val="65000"/>
                    <a:lumOff val="35000"/>
                  </a:schemeClr>
                </a:solidFill>
                <a:round/>
              </a:ln>
              <a:effectLst/>
            </c:spPr>
          </c:errBars>
          <c:xVal>
            <c:numRef>
              <c:f>Sheet1!$AA$224:$AA$229</c:f>
              <c:numCache>
                <c:formatCode>General</c:formatCode>
                <c:ptCount val="6"/>
                <c:pt idx="0">
                  <c:v>0.2</c:v>
                </c:pt>
                <c:pt idx="1">
                  <c:v>0.5</c:v>
                </c:pt>
                <c:pt idx="2">
                  <c:v>1</c:v>
                </c:pt>
                <c:pt idx="3">
                  <c:v>2</c:v>
                </c:pt>
                <c:pt idx="4">
                  <c:v>4</c:v>
                </c:pt>
                <c:pt idx="5">
                  <c:v>6</c:v>
                </c:pt>
              </c:numCache>
            </c:numRef>
          </c:xVal>
          <c:yVal>
            <c:numRef>
              <c:f>Sheet1!$AB$224:$AB$229</c:f>
              <c:numCache>
                <c:formatCode>General</c:formatCode>
                <c:ptCount val="6"/>
                <c:pt idx="0">
                  <c:v>145751.84375</c:v>
                </c:pt>
                <c:pt idx="1">
                  <c:v>450801.40625</c:v>
                </c:pt>
                <c:pt idx="2">
                  <c:v>775991.39583333337</c:v>
                </c:pt>
                <c:pt idx="3">
                  <c:v>1352042.0833333333</c:v>
                </c:pt>
                <c:pt idx="4">
                  <c:v>2180740.9166666665</c:v>
                </c:pt>
                <c:pt idx="5">
                  <c:v>2261537.0833333335</c:v>
                </c:pt>
              </c:numCache>
            </c:numRef>
          </c:yVal>
          <c:smooth val="0"/>
          <c:extLst>
            <c:ext xmlns:c16="http://schemas.microsoft.com/office/drawing/2014/chart" uri="{C3380CC4-5D6E-409C-BE32-E72D297353CC}">
              <c16:uniqueId val="{00000000-C62C-47E9-B10A-8B013EF2D6B7}"/>
            </c:ext>
          </c:extLst>
        </c:ser>
        <c:dLbls>
          <c:showLegendKey val="0"/>
          <c:showVal val="0"/>
          <c:showCatName val="0"/>
          <c:showSerName val="0"/>
          <c:showPercent val="0"/>
          <c:showBubbleSize val="0"/>
        </c:dLbls>
        <c:axId val="1229544143"/>
        <c:axId val="1229544623"/>
      </c:scatterChart>
      <c:valAx>
        <c:axId val="1229544143"/>
        <c:scaling>
          <c:orientation val="minMax"/>
          <c:max val="6"/>
        </c:scaling>
        <c:delete val="0"/>
        <c:axPos val="b"/>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29544623"/>
        <c:crosses val="autoZero"/>
        <c:crossBetween val="midCat"/>
        <c:majorUnit val="1"/>
      </c:valAx>
      <c:valAx>
        <c:axId val="1229544623"/>
        <c:scaling>
          <c:orientation val="minMax"/>
          <c:max val="2500000"/>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29544143"/>
        <c:crosses val="autoZero"/>
        <c:crossBetween val="midCat"/>
        <c:dispUnits>
          <c:builtInUnit val="hundredThousands"/>
          <c:dispUnitsLbl>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dispUnitsLbl>
        </c:dispUnits>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dPt>
            <c:idx val="0"/>
            <c:bubble3D val="0"/>
            <c:spPr>
              <a:solidFill>
                <a:schemeClr val="accent1"/>
              </a:solidFill>
              <a:ln w="19050">
                <a:solidFill>
                  <a:schemeClr val="lt1"/>
                </a:solidFill>
              </a:ln>
              <a:effectLst/>
            </c:spPr>
            <c:extLst>
              <c:ext xmlns:c16="http://schemas.microsoft.com/office/drawing/2014/chart" uri="{C3380CC4-5D6E-409C-BE32-E72D297353CC}">
                <c16:uniqueId val="{00000001-442F-4F98-93C8-76384FF2FBA8}"/>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442F-4F98-93C8-76384FF2FBA8}"/>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442F-4F98-93C8-76384FF2FBA8}"/>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442F-4F98-93C8-76384FF2FBA8}"/>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442F-4F98-93C8-76384FF2FBA8}"/>
              </c:ext>
            </c:extLst>
          </c:dPt>
          <c:dPt>
            <c:idx val="5"/>
            <c:bubble3D val="0"/>
            <c:spPr>
              <a:solidFill>
                <a:schemeClr val="accent6"/>
              </a:solidFill>
              <a:ln w="19050">
                <a:solidFill>
                  <a:schemeClr val="lt1"/>
                </a:solidFill>
              </a:ln>
              <a:effectLst/>
            </c:spPr>
            <c:extLst>
              <c:ext xmlns:c16="http://schemas.microsoft.com/office/drawing/2014/chart" uri="{C3380CC4-5D6E-409C-BE32-E72D297353CC}">
                <c16:uniqueId val="{0000000B-442F-4F98-93C8-76384FF2FBA8}"/>
              </c:ext>
            </c:extLst>
          </c:dPt>
          <c:dPt>
            <c:idx val="6"/>
            <c:bubble3D val="0"/>
            <c:spPr>
              <a:solidFill>
                <a:schemeClr val="accent1">
                  <a:lumMod val="60000"/>
                </a:schemeClr>
              </a:solidFill>
              <a:ln w="19050">
                <a:solidFill>
                  <a:schemeClr val="lt1"/>
                </a:solidFill>
              </a:ln>
              <a:effectLst/>
            </c:spPr>
            <c:extLst>
              <c:ext xmlns:c16="http://schemas.microsoft.com/office/drawing/2014/chart" uri="{C3380CC4-5D6E-409C-BE32-E72D297353CC}">
                <c16:uniqueId val="{0000000D-442F-4F98-93C8-76384FF2FBA8}"/>
              </c:ext>
            </c:extLst>
          </c:dPt>
          <c:dPt>
            <c:idx val="7"/>
            <c:bubble3D val="0"/>
            <c:spPr>
              <a:solidFill>
                <a:schemeClr val="accent2">
                  <a:lumMod val="60000"/>
                </a:schemeClr>
              </a:solidFill>
              <a:ln w="19050">
                <a:solidFill>
                  <a:schemeClr val="lt1"/>
                </a:solidFill>
              </a:ln>
              <a:effectLst/>
            </c:spPr>
            <c:extLst>
              <c:ext xmlns:c16="http://schemas.microsoft.com/office/drawing/2014/chart" uri="{C3380CC4-5D6E-409C-BE32-E72D297353CC}">
                <c16:uniqueId val="{0000000F-442F-4F98-93C8-76384FF2FBA8}"/>
              </c:ext>
            </c:extLst>
          </c:dPt>
          <c:dPt>
            <c:idx val="8"/>
            <c:bubble3D val="0"/>
            <c:spPr>
              <a:solidFill>
                <a:schemeClr val="accent3">
                  <a:lumMod val="60000"/>
                </a:schemeClr>
              </a:solidFill>
              <a:ln w="19050">
                <a:solidFill>
                  <a:schemeClr val="lt1"/>
                </a:solidFill>
              </a:ln>
              <a:effectLst/>
            </c:spPr>
            <c:extLst>
              <c:ext xmlns:c16="http://schemas.microsoft.com/office/drawing/2014/chart" uri="{C3380CC4-5D6E-409C-BE32-E72D297353CC}">
                <c16:uniqueId val="{00000011-442F-4F98-93C8-76384FF2FBA8}"/>
              </c:ext>
            </c:extLst>
          </c:dPt>
          <c:dPt>
            <c:idx val="9"/>
            <c:bubble3D val="0"/>
            <c:spPr>
              <a:solidFill>
                <a:schemeClr val="accent4">
                  <a:lumMod val="60000"/>
                </a:schemeClr>
              </a:solidFill>
              <a:ln w="19050">
                <a:solidFill>
                  <a:schemeClr val="lt1"/>
                </a:solidFill>
              </a:ln>
              <a:effectLst/>
            </c:spPr>
            <c:extLst>
              <c:ext xmlns:c16="http://schemas.microsoft.com/office/drawing/2014/chart" uri="{C3380CC4-5D6E-409C-BE32-E72D297353CC}">
                <c16:uniqueId val="{00000013-442F-4F98-93C8-76384FF2FBA8}"/>
              </c:ext>
            </c:extLst>
          </c:dPt>
          <c:dPt>
            <c:idx val="10"/>
            <c:bubble3D val="0"/>
            <c:spPr>
              <a:solidFill>
                <a:schemeClr val="accent5">
                  <a:lumMod val="60000"/>
                </a:schemeClr>
              </a:solidFill>
              <a:ln w="19050">
                <a:solidFill>
                  <a:schemeClr val="lt1"/>
                </a:solidFill>
              </a:ln>
              <a:effectLst/>
            </c:spPr>
            <c:extLst>
              <c:ext xmlns:c16="http://schemas.microsoft.com/office/drawing/2014/chart" uri="{C3380CC4-5D6E-409C-BE32-E72D297353CC}">
                <c16:uniqueId val="{00000015-442F-4F98-93C8-76384FF2FBA8}"/>
              </c:ext>
            </c:extLst>
          </c:dPt>
          <c:dPt>
            <c:idx val="11"/>
            <c:bubble3D val="0"/>
            <c:spPr>
              <a:solidFill>
                <a:schemeClr val="accent6">
                  <a:lumMod val="60000"/>
                </a:schemeClr>
              </a:solidFill>
              <a:ln w="19050">
                <a:solidFill>
                  <a:schemeClr val="lt1"/>
                </a:solidFill>
              </a:ln>
              <a:effectLst/>
            </c:spPr>
            <c:extLst>
              <c:ext xmlns:c16="http://schemas.microsoft.com/office/drawing/2014/chart" uri="{C3380CC4-5D6E-409C-BE32-E72D297353CC}">
                <c16:uniqueId val="{00000017-442F-4F98-93C8-76384FF2FBA8}"/>
              </c:ext>
            </c:extLst>
          </c:dPt>
          <c:dPt>
            <c:idx val="12"/>
            <c:bubble3D val="0"/>
            <c:spPr>
              <a:solidFill>
                <a:schemeClr val="accent1">
                  <a:lumMod val="80000"/>
                  <a:lumOff val="20000"/>
                </a:schemeClr>
              </a:solidFill>
              <a:ln w="19050">
                <a:solidFill>
                  <a:schemeClr val="lt1"/>
                </a:solidFill>
              </a:ln>
              <a:effectLst/>
            </c:spPr>
            <c:extLst>
              <c:ext xmlns:c16="http://schemas.microsoft.com/office/drawing/2014/chart" uri="{C3380CC4-5D6E-409C-BE32-E72D297353CC}">
                <c16:uniqueId val="{00000019-442F-4F98-93C8-76384FF2FBA8}"/>
              </c:ext>
            </c:extLst>
          </c:dPt>
          <c:dPt>
            <c:idx val="13"/>
            <c:bubble3D val="0"/>
            <c:spPr>
              <a:solidFill>
                <a:schemeClr val="accent2">
                  <a:lumMod val="80000"/>
                  <a:lumOff val="20000"/>
                </a:schemeClr>
              </a:solidFill>
              <a:ln w="19050">
                <a:solidFill>
                  <a:schemeClr val="lt1"/>
                </a:solidFill>
              </a:ln>
              <a:effectLst/>
            </c:spPr>
            <c:extLst>
              <c:ext xmlns:c16="http://schemas.microsoft.com/office/drawing/2014/chart" uri="{C3380CC4-5D6E-409C-BE32-E72D297353CC}">
                <c16:uniqueId val="{0000001B-442F-4F98-93C8-76384FF2FBA8}"/>
              </c:ext>
            </c:extLst>
          </c:dPt>
          <c:dPt>
            <c:idx val="14"/>
            <c:bubble3D val="0"/>
            <c:spPr>
              <a:solidFill>
                <a:schemeClr val="accent3">
                  <a:lumMod val="80000"/>
                  <a:lumOff val="20000"/>
                </a:schemeClr>
              </a:solidFill>
              <a:ln w="19050">
                <a:solidFill>
                  <a:schemeClr val="lt1"/>
                </a:solidFill>
              </a:ln>
              <a:effectLst/>
            </c:spPr>
            <c:extLst>
              <c:ext xmlns:c16="http://schemas.microsoft.com/office/drawing/2014/chart" uri="{C3380CC4-5D6E-409C-BE32-E72D297353CC}">
                <c16:uniqueId val="{0000001D-442F-4F98-93C8-76384FF2FBA8}"/>
              </c:ext>
            </c:extLst>
          </c:dPt>
          <c:dPt>
            <c:idx val="15"/>
            <c:bubble3D val="0"/>
            <c:spPr>
              <a:solidFill>
                <a:schemeClr val="accent4">
                  <a:lumMod val="80000"/>
                  <a:lumOff val="20000"/>
                </a:schemeClr>
              </a:solidFill>
              <a:ln w="19050">
                <a:solidFill>
                  <a:schemeClr val="lt1"/>
                </a:solidFill>
              </a:ln>
              <a:effectLst/>
            </c:spPr>
            <c:extLst>
              <c:ext xmlns:c16="http://schemas.microsoft.com/office/drawing/2014/chart" uri="{C3380CC4-5D6E-409C-BE32-E72D297353CC}">
                <c16:uniqueId val="{0000001F-442F-4F98-93C8-76384FF2FBA8}"/>
              </c:ext>
            </c:extLst>
          </c:dPt>
          <c:dPt>
            <c:idx val="16"/>
            <c:bubble3D val="0"/>
            <c:spPr>
              <a:solidFill>
                <a:schemeClr val="accent5">
                  <a:lumMod val="80000"/>
                  <a:lumOff val="20000"/>
                </a:schemeClr>
              </a:solidFill>
              <a:ln w="19050">
                <a:solidFill>
                  <a:schemeClr val="lt1"/>
                </a:solidFill>
              </a:ln>
              <a:effectLst/>
            </c:spPr>
            <c:extLst>
              <c:ext xmlns:c16="http://schemas.microsoft.com/office/drawing/2014/chart" uri="{C3380CC4-5D6E-409C-BE32-E72D297353CC}">
                <c16:uniqueId val="{00000021-442F-4F98-93C8-76384FF2FBA8}"/>
              </c:ext>
            </c:extLst>
          </c:dPt>
          <c:dPt>
            <c:idx val="17"/>
            <c:bubble3D val="0"/>
            <c:spPr>
              <a:solidFill>
                <a:schemeClr val="accent6">
                  <a:lumMod val="80000"/>
                  <a:lumOff val="20000"/>
                </a:schemeClr>
              </a:solidFill>
              <a:ln w="19050">
                <a:solidFill>
                  <a:schemeClr val="lt1"/>
                </a:solidFill>
              </a:ln>
              <a:effectLst/>
            </c:spPr>
            <c:extLst>
              <c:ext xmlns:c16="http://schemas.microsoft.com/office/drawing/2014/chart" uri="{C3380CC4-5D6E-409C-BE32-E72D297353CC}">
                <c16:uniqueId val="{00000023-442F-4F98-93C8-76384FF2FBA8}"/>
              </c:ext>
            </c:extLst>
          </c:dPt>
          <c:dPt>
            <c:idx val="18"/>
            <c:bubble3D val="0"/>
            <c:spPr>
              <a:solidFill>
                <a:schemeClr val="accent1">
                  <a:lumMod val="80000"/>
                </a:schemeClr>
              </a:solidFill>
              <a:ln w="19050">
                <a:solidFill>
                  <a:schemeClr val="lt1"/>
                </a:solidFill>
              </a:ln>
              <a:effectLst/>
            </c:spPr>
            <c:extLst>
              <c:ext xmlns:c16="http://schemas.microsoft.com/office/drawing/2014/chart" uri="{C3380CC4-5D6E-409C-BE32-E72D297353CC}">
                <c16:uniqueId val="{00000025-442F-4F98-93C8-76384FF2FBA8}"/>
              </c:ext>
            </c:extLst>
          </c:dPt>
          <c:dPt>
            <c:idx val="19"/>
            <c:bubble3D val="0"/>
            <c:spPr>
              <a:solidFill>
                <a:schemeClr val="accent2">
                  <a:lumMod val="80000"/>
                </a:schemeClr>
              </a:solidFill>
              <a:ln w="19050">
                <a:solidFill>
                  <a:schemeClr val="lt1"/>
                </a:solidFill>
              </a:ln>
              <a:effectLst/>
            </c:spPr>
            <c:extLst>
              <c:ext xmlns:c16="http://schemas.microsoft.com/office/drawing/2014/chart" uri="{C3380CC4-5D6E-409C-BE32-E72D297353CC}">
                <c16:uniqueId val="{00000027-442F-4F98-93C8-76384FF2FBA8}"/>
              </c:ext>
            </c:extLst>
          </c:dPt>
          <c:dPt>
            <c:idx val="20"/>
            <c:bubble3D val="0"/>
            <c:spPr>
              <a:solidFill>
                <a:schemeClr val="accent3">
                  <a:lumMod val="80000"/>
                </a:schemeClr>
              </a:solidFill>
              <a:ln w="19050">
                <a:solidFill>
                  <a:schemeClr val="lt1"/>
                </a:solidFill>
              </a:ln>
              <a:effectLst/>
            </c:spPr>
            <c:extLst>
              <c:ext xmlns:c16="http://schemas.microsoft.com/office/drawing/2014/chart" uri="{C3380CC4-5D6E-409C-BE32-E72D297353CC}">
                <c16:uniqueId val="{00000029-442F-4F98-93C8-76384FF2FBA8}"/>
              </c:ext>
            </c:extLst>
          </c:dPt>
          <c:dPt>
            <c:idx val="21"/>
            <c:bubble3D val="0"/>
            <c:spPr>
              <a:solidFill>
                <a:schemeClr val="accent4">
                  <a:lumMod val="80000"/>
                </a:schemeClr>
              </a:solidFill>
              <a:ln w="19050">
                <a:solidFill>
                  <a:schemeClr val="lt1"/>
                </a:solidFill>
              </a:ln>
              <a:effectLst/>
            </c:spPr>
            <c:extLst>
              <c:ext xmlns:c16="http://schemas.microsoft.com/office/drawing/2014/chart" uri="{C3380CC4-5D6E-409C-BE32-E72D297353CC}">
                <c16:uniqueId val="{0000002B-442F-4F98-93C8-76384FF2FBA8}"/>
              </c:ext>
            </c:extLst>
          </c:dPt>
          <c:dPt>
            <c:idx val="22"/>
            <c:bubble3D val="0"/>
            <c:spPr>
              <a:solidFill>
                <a:schemeClr val="accent5">
                  <a:lumMod val="80000"/>
                </a:schemeClr>
              </a:solidFill>
              <a:ln w="19050">
                <a:solidFill>
                  <a:schemeClr val="lt1"/>
                </a:solidFill>
              </a:ln>
              <a:effectLst/>
            </c:spPr>
            <c:extLst>
              <c:ext xmlns:c16="http://schemas.microsoft.com/office/drawing/2014/chart" uri="{C3380CC4-5D6E-409C-BE32-E72D297353CC}">
                <c16:uniqueId val="{0000002D-442F-4F98-93C8-76384FF2FBA8}"/>
              </c:ext>
            </c:extLst>
          </c:dPt>
          <c:dPt>
            <c:idx val="23"/>
            <c:bubble3D val="0"/>
            <c:spPr>
              <a:solidFill>
                <a:schemeClr val="accent6">
                  <a:lumMod val="80000"/>
                </a:schemeClr>
              </a:solidFill>
              <a:ln w="19050">
                <a:solidFill>
                  <a:schemeClr val="lt1"/>
                </a:solidFill>
              </a:ln>
              <a:effectLst/>
            </c:spPr>
            <c:extLst>
              <c:ext xmlns:c16="http://schemas.microsoft.com/office/drawing/2014/chart" uri="{C3380CC4-5D6E-409C-BE32-E72D297353CC}">
                <c16:uniqueId val="{0000002F-442F-4F98-93C8-76384FF2FBA8}"/>
              </c:ext>
            </c:extLst>
          </c:dPt>
          <c:dPt>
            <c:idx val="24"/>
            <c:bubble3D val="0"/>
            <c:spPr>
              <a:solidFill>
                <a:schemeClr val="accent1">
                  <a:lumMod val="60000"/>
                  <a:lumOff val="40000"/>
                </a:schemeClr>
              </a:solidFill>
              <a:ln w="19050">
                <a:solidFill>
                  <a:schemeClr val="lt1"/>
                </a:solidFill>
              </a:ln>
              <a:effectLst/>
            </c:spPr>
            <c:extLst>
              <c:ext xmlns:c16="http://schemas.microsoft.com/office/drawing/2014/chart" uri="{C3380CC4-5D6E-409C-BE32-E72D297353CC}">
                <c16:uniqueId val="{00000031-442F-4F98-93C8-76384FF2FBA8}"/>
              </c:ext>
            </c:extLst>
          </c:dPt>
          <c:dPt>
            <c:idx val="25"/>
            <c:bubble3D val="0"/>
            <c:spPr>
              <a:solidFill>
                <a:schemeClr val="accent2">
                  <a:lumMod val="60000"/>
                  <a:lumOff val="40000"/>
                </a:schemeClr>
              </a:solidFill>
              <a:ln w="19050">
                <a:solidFill>
                  <a:schemeClr val="lt1"/>
                </a:solidFill>
              </a:ln>
              <a:effectLst/>
            </c:spPr>
            <c:extLst>
              <c:ext xmlns:c16="http://schemas.microsoft.com/office/drawing/2014/chart" uri="{C3380CC4-5D6E-409C-BE32-E72D297353CC}">
                <c16:uniqueId val="{00000033-442F-4F98-93C8-76384FF2FBA8}"/>
              </c:ext>
            </c:extLst>
          </c:dPt>
          <c:dPt>
            <c:idx val="26"/>
            <c:bubble3D val="0"/>
            <c:spPr>
              <a:solidFill>
                <a:schemeClr val="accent3">
                  <a:lumMod val="60000"/>
                  <a:lumOff val="40000"/>
                </a:schemeClr>
              </a:solidFill>
              <a:ln w="19050">
                <a:solidFill>
                  <a:schemeClr val="lt1"/>
                </a:solidFill>
              </a:ln>
              <a:effectLst/>
            </c:spPr>
            <c:extLst>
              <c:ext xmlns:c16="http://schemas.microsoft.com/office/drawing/2014/chart" uri="{C3380CC4-5D6E-409C-BE32-E72D297353CC}">
                <c16:uniqueId val="{00000035-442F-4F98-93C8-76384FF2FBA8}"/>
              </c:ext>
            </c:extLst>
          </c:dPt>
          <c:dPt>
            <c:idx val="27"/>
            <c:bubble3D val="0"/>
            <c:spPr>
              <a:solidFill>
                <a:schemeClr val="accent4">
                  <a:lumMod val="60000"/>
                  <a:lumOff val="40000"/>
                </a:schemeClr>
              </a:solidFill>
              <a:ln w="19050">
                <a:solidFill>
                  <a:schemeClr val="lt1"/>
                </a:solidFill>
              </a:ln>
              <a:effectLst/>
            </c:spPr>
            <c:extLst>
              <c:ext xmlns:c16="http://schemas.microsoft.com/office/drawing/2014/chart" uri="{C3380CC4-5D6E-409C-BE32-E72D297353CC}">
                <c16:uniqueId val="{00000037-442F-4F98-93C8-76384FF2FBA8}"/>
              </c:ext>
            </c:extLst>
          </c:dPt>
          <c:dPt>
            <c:idx val="28"/>
            <c:bubble3D val="0"/>
            <c:spPr>
              <a:solidFill>
                <a:schemeClr val="accent5">
                  <a:lumMod val="60000"/>
                  <a:lumOff val="40000"/>
                </a:schemeClr>
              </a:solidFill>
              <a:ln w="19050">
                <a:solidFill>
                  <a:schemeClr val="lt1"/>
                </a:solidFill>
              </a:ln>
              <a:effectLst/>
            </c:spPr>
            <c:extLst>
              <c:ext xmlns:c16="http://schemas.microsoft.com/office/drawing/2014/chart" uri="{C3380CC4-5D6E-409C-BE32-E72D297353CC}">
                <c16:uniqueId val="{00000039-442F-4F98-93C8-76384FF2FBA8}"/>
              </c:ext>
            </c:extLst>
          </c:dPt>
          <c:dPt>
            <c:idx val="29"/>
            <c:bubble3D val="0"/>
            <c:spPr>
              <a:solidFill>
                <a:schemeClr val="accent6">
                  <a:lumMod val="60000"/>
                  <a:lumOff val="40000"/>
                </a:schemeClr>
              </a:solidFill>
              <a:ln w="19050">
                <a:solidFill>
                  <a:schemeClr val="lt1"/>
                </a:solidFill>
              </a:ln>
              <a:effectLst/>
            </c:spPr>
            <c:extLst>
              <c:ext xmlns:c16="http://schemas.microsoft.com/office/drawing/2014/chart" uri="{C3380CC4-5D6E-409C-BE32-E72D297353CC}">
                <c16:uniqueId val="{0000003B-442F-4F98-93C8-76384FF2FBA8}"/>
              </c:ext>
            </c:extLst>
          </c:dPt>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0"/>
            <c:showCatName val="0"/>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13C_internal standards_Pie chart.xlsx]78 13C whole pie chart'!$A$2:$A$31</c:f>
              <c:strCache>
                <c:ptCount val="30"/>
                <c:pt idx="0">
                  <c:v>Alcohols and polyols</c:v>
                </c:pt>
                <c:pt idx="1">
                  <c:v>Alpha hydroxy acids and derivatives</c:v>
                </c:pt>
                <c:pt idx="2">
                  <c:v>Alpha-keto acids and derivatives</c:v>
                </c:pt>
                <c:pt idx="3">
                  <c:v>Amines</c:v>
                </c:pt>
                <c:pt idx="4">
                  <c:v>Amino acids, peptides, and analogues</c:v>
                </c:pt>
                <c:pt idx="5">
                  <c:v>Beta hydroxy acids and derivatives</c:v>
                </c:pt>
                <c:pt idx="6">
                  <c:v>Carbohydrates and carbohydrate conjugates</c:v>
                </c:pt>
                <c:pt idx="7">
                  <c:v>Carbonyl compounds</c:v>
                </c:pt>
                <c:pt idx="8">
                  <c:v>Dicarboxylic acids and derivatives</c:v>
                </c:pt>
                <c:pt idx="9">
                  <c:v>Fatty acid esters</c:v>
                </c:pt>
                <c:pt idx="10">
                  <c:v>Fatty acids and conjugates</c:v>
                </c:pt>
                <c:pt idx="11">
                  <c:v>Gamma butyrolactones</c:v>
                </c:pt>
                <c:pt idx="12">
                  <c:v>Gamma-keto acids and derivatives</c:v>
                </c:pt>
                <c:pt idx="13">
                  <c:v>Guanidines</c:v>
                </c:pt>
                <c:pt idx="14">
                  <c:v>Indolyl carboxylic acids and derivatives</c:v>
                </c:pt>
                <c:pt idx="15">
                  <c:v>Organosulfonic acids and derivatives</c:v>
                </c:pt>
                <c:pt idx="16">
                  <c:v>Phenylpyruvic acid derivatives</c:v>
                </c:pt>
                <c:pt idx="17">
                  <c:v>Purine nucleosides</c:v>
                </c:pt>
                <c:pt idx="18">
                  <c:v>Purine ribonucleotides</c:v>
                </c:pt>
                <c:pt idx="19">
                  <c:v>Purines and purine derivatives</c:v>
                </c:pt>
                <c:pt idx="20">
                  <c:v>Pyridinecarboxylic acids and derivatives</c:v>
                </c:pt>
                <c:pt idx="21">
                  <c:v>Pyrimidine 2'-deoxyribonucleosides</c:v>
                </c:pt>
                <c:pt idx="22">
                  <c:v>Pyrimidine nucleosides</c:v>
                </c:pt>
                <c:pt idx="23">
                  <c:v>Pyrimidine nucleotide sugars</c:v>
                </c:pt>
                <c:pt idx="24">
                  <c:v>Pyrimidine ribonucleotides</c:v>
                </c:pt>
                <c:pt idx="25">
                  <c:v>Pyrimidines and pyrimidine derivatives</c:v>
                </c:pt>
                <c:pt idx="26">
                  <c:v>Quaternary ammonium salts</c:v>
                </c:pt>
                <c:pt idx="27">
                  <c:v>Quinoline carboxylic acids</c:v>
                </c:pt>
                <c:pt idx="28">
                  <c:v>Short-chain hydroxy acids and derivatives</c:v>
                </c:pt>
                <c:pt idx="29">
                  <c:v>Short-chain keto acids and derivatives</c:v>
                </c:pt>
              </c:strCache>
            </c:strRef>
          </c:cat>
          <c:val>
            <c:numRef>
              <c:f>'[13C_internal standards_Pie chart.xlsx]78 13C whole pie chart'!$B$2:$B$31</c:f>
              <c:numCache>
                <c:formatCode>General</c:formatCode>
                <c:ptCount val="30"/>
                <c:pt idx="0">
                  <c:v>1</c:v>
                </c:pt>
                <c:pt idx="1">
                  <c:v>1</c:v>
                </c:pt>
                <c:pt idx="2">
                  <c:v>1</c:v>
                </c:pt>
                <c:pt idx="3">
                  <c:v>1</c:v>
                </c:pt>
                <c:pt idx="4">
                  <c:v>29</c:v>
                </c:pt>
                <c:pt idx="5">
                  <c:v>1</c:v>
                </c:pt>
                <c:pt idx="6">
                  <c:v>4</c:v>
                </c:pt>
                <c:pt idx="7">
                  <c:v>2</c:v>
                </c:pt>
                <c:pt idx="8">
                  <c:v>4</c:v>
                </c:pt>
                <c:pt idx="9">
                  <c:v>1</c:v>
                </c:pt>
                <c:pt idx="10">
                  <c:v>4</c:v>
                </c:pt>
                <c:pt idx="11">
                  <c:v>1</c:v>
                </c:pt>
                <c:pt idx="12">
                  <c:v>1</c:v>
                </c:pt>
                <c:pt idx="13">
                  <c:v>2</c:v>
                </c:pt>
                <c:pt idx="14">
                  <c:v>1</c:v>
                </c:pt>
                <c:pt idx="15">
                  <c:v>1</c:v>
                </c:pt>
                <c:pt idx="16">
                  <c:v>1</c:v>
                </c:pt>
                <c:pt idx="17">
                  <c:v>4</c:v>
                </c:pt>
                <c:pt idx="18">
                  <c:v>2</c:v>
                </c:pt>
                <c:pt idx="19">
                  <c:v>2</c:v>
                </c:pt>
                <c:pt idx="20">
                  <c:v>1</c:v>
                </c:pt>
                <c:pt idx="21">
                  <c:v>1</c:v>
                </c:pt>
                <c:pt idx="22">
                  <c:v>2</c:v>
                </c:pt>
                <c:pt idx="23">
                  <c:v>1</c:v>
                </c:pt>
                <c:pt idx="24">
                  <c:v>2</c:v>
                </c:pt>
                <c:pt idx="25">
                  <c:v>2</c:v>
                </c:pt>
                <c:pt idx="26">
                  <c:v>2</c:v>
                </c:pt>
                <c:pt idx="27">
                  <c:v>1</c:v>
                </c:pt>
                <c:pt idx="28">
                  <c:v>1</c:v>
                </c:pt>
                <c:pt idx="29">
                  <c:v>1</c:v>
                </c:pt>
              </c:numCache>
            </c:numRef>
          </c:val>
          <c:extLst>
            <c:ext xmlns:c16="http://schemas.microsoft.com/office/drawing/2014/chart" uri="{C3380CC4-5D6E-409C-BE32-E72D297353CC}">
              <c16:uniqueId val="{0000003C-442F-4F98-93C8-76384FF2FBA8}"/>
            </c:ext>
          </c:extLst>
        </c:ser>
        <c:dLbls>
          <c:showLegendKey val="0"/>
          <c:showVal val="0"/>
          <c:showCatName val="0"/>
          <c:showSerName val="0"/>
          <c:showPercent val="0"/>
          <c:showBubbleSize val="0"/>
          <c:showLeaderLines val="1"/>
        </c:dLbls>
        <c:firstSliceAng val="0"/>
      </c:pieChart>
      <c:spPr>
        <a:noFill/>
        <a:ln>
          <a:noFill/>
        </a:ln>
        <a:effectLst/>
      </c:spPr>
    </c:plotArea>
    <c:legend>
      <c:legendPos val="l"/>
      <c:layout>
        <c:manualLayout>
          <c:xMode val="edge"/>
          <c:yMode val="edge"/>
          <c:x val="1.053239457722664E-2"/>
          <c:y val="4.9514899263208602E-3"/>
          <c:w val="0.42073419359868147"/>
          <c:h val="0.99504851007367912"/>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7214" y="1749275"/>
            <a:ext cx="6428423" cy="3721230"/>
          </a:xfrm>
        </p:spPr>
        <p:txBody>
          <a:bodyPr anchor="b"/>
          <a:lstStyle>
            <a:lvl1pPr algn="ctr">
              <a:defRPr sz="4963"/>
            </a:lvl1pPr>
          </a:lstStyle>
          <a:p>
            <a:r>
              <a:rPr lang="en-US"/>
              <a:t>Click to edit Master title style</a:t>
            </a:r>
            <a:endParaRPr lang="en-US" dirty="0"/>
          </a:p>
        </p:txBody>
      </p:sp>
      <p:sp>
        <p:nvSpPr>
          <p:cNvPr id="3" name="Subtitle 2"/>
          <p:cNvSpPr>
            <a:spLocks noGrp="1"/>
          </p:cNvSpPr>
          <p:nvPr>
            <p:ph type="subTitle" idx="1"/>
          </p:nvPr>
        </p:nvSpPr>
        <p:spPr>
          <a:xfrm>
            <a:off x="945356" y="5614010"/>
            <a:ext cx="5672138" cy="2580613"/>
          </a:xfrm>
        </p:spPr>
        <p:txBody>
          <a:bodyPr/>
          <a:lstStyle>
            <a:lvl1pPr marL="0" indent="0" algn="ctr">
              <a:buNone/>
              <a:defRPr sz="1985"/>
            </a:lvl1pPr>
            <a:lvl2pPr marL="378150" indent="0" algn="ctr">
              <a:buNone/>
              <a:defRPr sz="1654"/>
            </a:lvl2pPr>
            <a:lvl3pPr marL="756300" indent="0" algn="ctr">
              <a:buNone/>
              <a:defRPr sz="1489"/>
            </a:lvl3pPr>
            <a:lvl4pPr marL="1134450" indent="0" algn="ctr">
              <a:buNone/>
              <a:defRPr sz="1323"/>
            </a:lvl4pPr>
            <a:lvl5pPr marL="1512600" indent="0" algn="ctr">
              <a:buNone/>
              <a:defRPr sz="1323"/>
            </a:lvl5pPr>
            <a:lvl6pPr marL="1890751" indent="0" algn="ctr">
              <a:buNone/>
              <a:defRPr sz="1323"/>
            </a:lvl6pPr>
            <a:lvl7pPr marL="2268901" indent="0" algn="ctr">
              <a:buNone/>
              <a:defRPr sz="1323"/>
            </a:lvl7pPr>
            <a:lvl8pPr marL="2647051" indent="0" algn="ctr">
              <a:buNone/>
              <a:defRPr sz="1323"/>
            </a:lvl8pPr>
            <a:lvl9pPr marL="3025201" indent="0" algn="ctr">
              <a:buNone/>
              <a:defRPr sz="132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20744AC-B2B4-40A3-932B-6CF6AE4C2734}" type="datetimeFigureOut">
              <a:rPr lang="en-US" smtClean="0"/>
              <a:t>5/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37043018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0744AC-B2B4-40A3-932B-6CF6AE4C2734}" type="datetimeFigureOut">
              <a:rPr lang="en-US" smtClean="0"/>
              <a:t>5/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5818774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12165" y="569071"/>
            <a:ext cx="1630740" cy="905812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19946" y="569071"/>
            <a:ext cx="4797683" cy="905812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0744AC-B2B4-40A3-932B-6CF6AE4C2734}" type="datetimeFigureOut">
              <a:rPr lang="en-US" smtClean="0"/>
              <a:t>5/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32387782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0744AC-B2B4-40A3-932B-6CF6AE4C2734}" type="datetimeFigureOut">
              <a:rPr lang="en-US" smtClean="0"/>
              <a:t>5/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35621373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6007" y="2664740"/>
            <a:ext cx="6522958" cy="4446176"/>
          </a:xfrm>
        </p:spPr>
        <p:txBody>
          <a:bodyPr anchor="b"/>
          <a:lstStyle>
            <a:lvl1pPr>
              <a:defRPr sz="4963"/>
            </a:lvl1pPr>
          </a:lstStyle>
          <a:p>
            <a:r>
              <a:rPr lang="en-US"/>
              <a:t>Click to edit Master title style</a:t>
            </a:r>
            <a:endParaRPr lang="en-US" dirty="0"/>
          </a:p>
        </p:txBody>
      </p:sp>
      <p:sp>
        <p:nvSpPr>
          <p:cNvPr id="3" name="Text Placeholder 2"/>
          <p:cNvSpPr>
            <a:spLocks noGrp="1"/>
          </p:cNvSpPr>
          <p:nvPr>
            <p:ph type="body" idx="1"/>
          </p:nvPr>
        </p:nvSpPr>
        <p:spPr>
          <a:xfrm>
            <a:off x="516007" y="7152978"/>
            <a:ext cx="6522958" cy="2338139"/>
          </a:xfrm>
        </p:spPr>
        <p:txBody>
          <a:bodyPr/>
          <a:lstStyle>
            <a:lvl1pPr marL="0" indent="0">
              <a:buNone/>
              <a:defRPr sz="1985">
                <a:solidFill>
                  <a:schemeClr val="tx1">
                    <a:tint val="82000"/>
                  </a:schemeClr>
                </a:solidFill>
              </a:defRPr>
            </a:lvl1pPr>
            <a:lvl2pPr marL="378150" indent="0">
              <a:buNone/>
              <a:defRPr sz="1654">
                <a:solidFill>
                  <a:schemeClr val="tx1">
                    <a:tint val="82000"/>
                  </a:schemeClr>
                </a:solidFill>
              </a:defRPr>
            </a:lvl2pPr>
            <a:lvl3pPr marL="756300" indent="0">
              <a:buNone/>
              <a:defRPr sz="1489">
                <a:solidFill>
                  <a:schemeClr val="tx1">
                    <a:tint val="82000"/>
                  </a:schemeClr>
                </a:solidFill>
              </a:defRPr>
            </a:lvl3pPr>
            <a:lvl4pPr marL="1134450" indent="0">
              <a:buNone/>
              <a:defRPr sz="1323">
                <a:solidFill>
                  <a:schemeClr val="tx1">
                    <a:tint val="82000"/>
                  </a:schemeClr>
                </a:solidFill>
              </a:defRPr>
            </a:lvl4pPr>
            <a:lvl5pPr marL="1512600" indent="0">
              <a:buNone/>
              <a:defRPr sz="1323">
                <a:solidFill>
                  <a:schemeClr val="tx1">
                    <a:tint val="82000"/>
                  </a:schemeClr>
                </a:solidFill>
              </a:defRPr>
            </a:lvl5pPr>
            <a:lvl6pPr marL="1890751" indent="0">
              <a:buNone/>
              <a:defRPr sz="1323">
                <a:solidFill>
                  <a:schemeClr val="tx1">
                    <a:tint val="82000"/>
                  </a:schemeClr>
                </a:solidFill>
              </a:defRPr>
            </a:lvl6pPr>
            <a:lvl7pPr marL="2268901" indent="0">
              <a:buNone/>
              <a:defRPr sz="1323">
                <a:solidFill>
                  <a:schemeClr val="tx1">
                    <a:tint val="82000"/>
                  </a:schemeClr>
                </a:solidFill>
              </a:defRPr>
            </a:lvl7pPr>
            <a:lvl8pPr marL="2647051" indent="0">
              <a:buNone/>
              <a:defRPr sz="1323">
                <a:solidFill>
                  <a:schemeClr val="tx1">
                    <a:tint val="82000"/>
                  </a:schemeClr>
                </a:solidFill>
              </a:defRPr>
            </a:lvl8pPr>
            <a:lvl9pPr marL="3025201" indent="0">
              <a:buNone/>
              <a:defRPr sz="1323">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20744AC-B2B4-40A3-932B-6CF6AE4C2734}" type="datetimeFigureOut">
              <a:rPr lang="en-US" smtClean="0"/>
              <a:t>5/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28771189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19946" y="2845355"/>
            <a:ext cx="3214211" cy="678184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828693" y="2845355"/>
            <a:ext cx="3214211" cy="678184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20744AC-B2B4-40A3-932B-6CF6AE4C2734}" type="datetimeFigureOut">
              <a:rPr lang="en-US" smtClean="0"/>
              <a:t>5/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3673829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20931" y="569073"/>
            <a:ext cx="6522958" cy="20659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520932" y="2620202"/>
            <a:ext cx="3199440" cy="1284120"/>
          </a:xfrm>
        </p:spPr>
        <p:txBody>
          <a:bodyPr anchor="b"/>
          <a:lstStyle>
            <a:lvl1pPr marL="0" indent="0">
              <a:buNone/>
              <a:defRPr sz="1985" b="1"/>
            </a:lvl1pPr>
            <a:lvl2pPr marL="378150" indent="0">
              <a:buNone/>
              <a:defRPr sz="1654" b="1"/>
            </a:lvl2pPr>
            <a:lvl3pPr marL="756300" indent="0">
              <a:buNone/>
              <a:defRPr sz="1489" b="1"/>
            </a:lvl3pPr>
            <a:lvl4pPr marL="1134450" indent="0">
              <a:buNone/>
              <a:defRPr sz="1323" b="1"/>
            </a:lvl4pPr>
            <a:lvl5pPr marL="1512600" indent="0">
              <a:buNone/>
              <a:defRPr sz="1323" b="1"/>
            </a:lvl5pPr>
            <a:lvl6pPr marL="1890751" indent="0">
              <a:buNone/>
              <a:defRPr sz="1323" b="1"/>
            </a:lvl6pPr>
            <a:lvl7pPr marL="2268901" indent="0">
              <a:buNone/>
              <a:defRPr sz="1323" b="1"/>
            </a:lvl7pPr>
            <a:lvl8pPr marL="2647051" indent="0">
              <a:buNone/>
              <a:defRPr sz="1323" b="1"/>
            </a:lvl8pPr>
            <a:lvl9pPr marL="3025201" indent="0">
              <a:buNone/>
              <a:defRPr sz="1323" b="1"/>
            </a:lvl9pPr>
          </a:lstStyle>
          <a:p>
            <a:pPr lvl="0"/>
            <a:r>
              <a:rPr lang="en-US"/>
              <a:t>Click to edit Master text styles</a:t>
            </a:r>
          </a:p>
        </p:txBody>
      </p:sp>
      <p:sp>
        <p:nvSpPr>
          <p:cNvPr id="4" name="Content Placeholder 3"/>
          <p:cNvSpPr>
            <a:spLocks noGrp="1"/>
          </p:cNvSpPr>
          <p:nvPr>
            <p:ph sz="half" idx="2"/>
          </p:nvPr>
        </p:nvSpPr>
        <p:spPr>
          <a:xfrm>
            <a:off x="520932" y="3904322"/>
            <a:ext cx="3199440" cy="57426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828693" y="2620202"/>
            <a:ext cx="3215196" cy="1284120"/>
          </a:xfrm>
        </p:spPr>
        <p:txBody>
          <a:bodyPr anchor="b"/>
          <a:lstStyle>
            <a:lvl1pPr marL="0" indent="0">
              <a:buNone/>
              <a:defRPr sz="1985" b="1"/>
            </a:lvl1pPr>
            <a:lvl2pPr marL="378150" indent="0">
              <a:buNone/>
              <a:defRPr sz="1654" b="1"/>
            </a:lvl2pPr>
            <a:lvl3pPr marL="756300" indent="0">
              <a:buNone/>
              <a:defRPr sz="1489" b="1"/>
            </a:lvl3pPr>
            <a:lvl4pPr marL="1134450" indent="0">
              <a:buNone/>
              <a:defRPr sz="1323" b="1"/>
            </a:lvl4pPr>
            <a:lvl5pPr marL="1512600" indent="0">
              <a:buNone/>
              <a:defRPr sz="1323" b="1"/>
            </a:lvl5pPr>
            <a:lvl6pPr marL="1890751" indent="0">
              <a:buNone/>
              <a:defRPr sz="1323" b="1"/>
            </a:lvl6pPr>
            <a:lvl7pPr marL="2268901" indent="0">
              <a:buNone/>
              <a:defRPr sz="1323" b="1"/>
            </a:lvl7pPr>
            <a:lvl8pPr marL="2647051" indent="0">
              <a:buNone/>
              <a:defRPr sz="1323" b="1"/>
            </a:lvl8pPr>
            <a:lvl9pPr marL="3025201" indent="0">
              <a:buNone/>
              <a:defRPr sz="1323" b="1"/>
            </a:lvl9pPr>
          </a:lstStyle>
          <a:p>
            <a:pPr lvl="0"/>
            <a:r>
              <a:rPr lang="en-US"/>
              <a:t>Click to edit Master text styles</a:t>
            </a:r>
          </a:p>
        </p:txBody>
      </p:sp>
      <p:sp>
        <p:nvSpPr>
          <p:cNvPr id="6" name="Content Placeholder 5"/>
          <p:cNvSpPr>
            <a:spLocks noGrp="1"/>
          </p:cNvSpPr>
          <p:nvPr>
            <p:ph sz="quarter" idx="4"/>
          </p:nvPr>
        </p:nvSpPr>
        <p:spPr>
          <a:xfrm>
            <a:off x="3828693" y="3904322"/>
            <a:ext cx="3215196" cy="57426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20744AC-B2B4-40A3-932B-6CF6AE4C2734}" type="datetimeFigureOut">
              <a:rPr lang="en-US" smtClean="0"/>
              <a:t>5/9/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2067351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20744AC-B2B4-40A3-932B-6CF6AE4C2734}" type="datetimeFigureOut">
              <a:rPr lang="en-US" smtClean="0"/>
              <a:t>5/9/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20364437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20744AC-B2B4-40A3-932B-6CF6AE4C2734}" type="datetimeFigureOut">
              <a:rPr lang="en-US" smtClean="0"/>
              <a:t>5/9/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13740535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931" y="712576"/>
            <a:ext cx="2439216" cy="2494016"/>
          </a:xfrm>
        </p:spPr>
        <p:txBody>
          <a:bodyPr anchor="b"/>
          <a:lstStyle>
            <a:lvl1pPr>
              <a:defRPr sz="2647"/>
            </a:lvl1pPr>
          </a:lstStyle>
          <a:p>
            <a:r>
              <a:rPr lang="en-US"/>
              <a:t>Click to edit Master title style</a:t>
            </a:r>
            <a:endParaRPr lang="en-US" dirty="0"/>
          </a:p>
        </p:txBody>
      </p:sp>
      <p:sp>
        <p:nvSpPr>
          <p:cNvPr id="3" name="Content Placeholder 2"/>
          <p:cNvSpPr>
            <a:spLocks noGrp="1"/>
          </p:cNvSpPr>
          <p:nvPr>
            <p:ph idx="1"/>
          </p:nvPr>
        </p:nvSpPr>
        <p:spPr>
          <a:xfrm>
            <a:off x="3215196" y="1538968"/>
            <a:ext cx="3828693" cy="7595861"/>
          </a:xfrm>
        </p:spPr>
        <p:txBody>
          <a:bodyPr/>
          <a:lstStyle>
            <a:lvl1pPr>
              <a:defRPr sz="2647"/>
            </a:lvl1pPr>
            <a:lvl2pPr>
              <a:defRPr sz="2316"/>
            </a:lvl2pPr>
            <a:lvl3pPr>
              <a:defRPr sz="1985"/>
            </a:lvl3pPr>
            <a:lvl4pPr>
              <a:defRPr sz="1654"/>
            </a:lvl4pPr>
            <a:lvl5pPr>
              <a:defRPr sz="1654"/>
            </a:lvl5pPr>
            <a:lvl6pPr>
              <a:defRPr sz="1654"/>
            </a:lvl6pPr>
            <a:lvl7pPr>
              <a:defRPr sz="1654"/>
            </a:lvl7pPr>
            <a:lvl8pPr>
              <a:defRPr sz="1654"/>
            </a:lvl8pPr>
            <a:lvl9pPr>
              <a:defRPr sz="1654"/>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20931" y="3206592"/>
            <a:ext cx="2439216" cy="5940607"/>
          </a:xfrm>
        </p:spPr>
        <p:txBody>
          <a:bodyPr/>
          <a:lstStyle>
            <a:lvl1pPr marL="0" indent="0">
              <a:buNone/>
              <a:defRPr sz="1323"/>
            </a:lvl1pPr>
            <a:lvl2pPr marL="378150" indent="0">
              <a:buNone/>
              <a:defRPr sz="1158"/>
            </a:lvl2pPr>
            <a:lvl3pPr marL="756300" indent="0">
              <a:buNone/>
              <a:defRPr sz="993"/>
            </a:lvl3pPr>
            <a:lvl4pPr marL="1134450" indent="0">
              <a:buNone/>
              <a:defRPr sz="827"/>
            </a:lvl4pPr>
            <a:lvl5pPr marL="1512600" indent="0">
              <a:buNone/>
              <a:defRPr sz="827"/>
            </a:lvl5pPr>
            <a:lvl6pPr marL="1890751" indent="0">
              <a:buNone/>
              <a:defRPr sz="827"/>
            </a:lvl6pPr>
            <a:lvl7pPr marL="2268901" indent="0">
              <a:buNone/>
              <a:defRPr sz="827"/>
            </a:lvl7pPr>
            <a:lvl8pPr marL="2647051" indent="0">
              <a:buNone/>
              <a:defRPr sz="827"/>
            </a:lvl8pPr>
            <a:lvl9pPr marL="3025201" indent="0">
              <a:buNone/>
              <a:defRPr sz="827"/>
            </a:lvl9pPr>
          </a:lstStyle>
          <a:p>
            <a:pPr lvl="0"/>
            <a:r>
              <a:rPr lang="en-US"/>
              <a:t>Click to edit Master text styles</a:t>
            </a:r>
          </a:p>
        </p:txBody>
      </p:sp>
      <p:sp>
        <p:nvSpPr>
          <p:cNvPr id="5" name="Date Placeholder 4"/>
          <p:cNvSpPr>
            <a:spLocks noGrp="1"/>
          </p:cNvSpPr>
          <p:nvPr>
            <p:ph type="dt" sz="half" idx="10"/>
          </p:nvPr>
        </p:nvSpPr>
        <p:spPr/>
        <p:txBody>
          <a:bodyPr/>
          <a:lstStyle/>
          <a:p>
            <a:fld id="{E20744AC-B2B4-40A3-932B-6CF6AE4C2734}" type="datetimeFigureOut">
              <a:rPr lang="en-US" smtClean="0"/>
              <a:t>5/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1546836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931" y="712576"/>
            <a:ext cx="2439216" cy="2494016"/>
          </a:xfrm>
        </p:spPr>
        <p:txBody>
          <a:bodyPr anchor="b"/>
          <a:lstStyle>
            <a:lvl1pPr>
              <a:defRPr sz="2647"/>
            </a:lvl1pPr>
          </a:lstStyle>
          <a:p>
            <a:r>
              <a:rPr lang="en-US"/>
              <a:t>Click to edit Master title style</a:t>
            </a:r>
            <a:endParaRPr lang="en-US" dirty="0"/>
          </a:p>
        </p:txBody>
      </p:sp>
      <p:sp>
        <p:nvSpPr>
          <p:cNvPr id="3" name="Picture Placeholder 2"/>
          <p:cNvSpPr>
            <a:spLocks noGrp="1" noChangeAspect="1"/>
          </p:cNvSpPr>
          <p:nvPr>
            <p:ph type="pic" idx="1"/>
          </p:nvPr>
        </p:nvSpPr>
        <p:spPr>
          <a:xfrm>
            <a:off x="3215196" y="1538968"/>
            <a:ext cx="3828693" cy="7595861"/>
          </a:xfrm>
        </p:spPr>
        <p:txBody>
          <a:bodyPr anchor="t"/>
          <a:lstStyle>
            <a:lvl1pPr marL="0" indent="0">
              <a:buNone/>
              <a:defRPr sz="2647"/>
            </a:lvl1pPr>
            <a:lvl2pPr marL="378150" indent="0">
              <a:buNone/>
              <a:defRPr sz="2316"/>
            </a:lvl2pPr>
            <a:lvl3pPr marL="756300" indent="0">
              <a:buNone/>
              <a:defRPr sz="1985"/>
            </a:lvl3pPr>
            <a:lvl4pPr marL="1134450" indent="0">
              <a:buNone/>
              <a:defRPr sz="1654"/>
            </a:lvl4pPr>
            <a:lvl5pPr marL="1512600" indent="0">
              <a:buNone/>
              <a:defRPr sz="1654"/>
            </a:lvl5pPr>
            <a:lvl6pPr marL="1890751" indent="0">
              <a:buNone/>
              <a:defRPr sz="1654"/>
            </a:lvl6pPr>
            <a:lvl7pPr marL="2268901" indent="0">
              <a:buNone/>
              <a:defRPr sz="1654"/>
            </a:lvl7pPr>
            <a:lvl8pPr marL="2647051" indent="0">
              <a:buNone/>
              <a:defRPr sz="1654"/>
            </a:lvl8pPr>
            <a:lvl9pPr marL="3025201" indent="0">
              <a:buNone/>
              <a:defRPr sz="1654"/>
            </a:lvl9pPr>
          </a:lstStyle>
          <a:p>
            <a:r>
              <a:rPr lang="en-US"/>
              <a:t>Click icon to add picture</a:t>
            </a:r>
            <a:endParaRPr lang="en-US" dirty="0"/>
          </a:p>
        </p:txBody>
      </p:sp>
      <p:sp>
        <p:nvSpPr>
          <p:cNvPr id="4" name="Text Placeholder 3"/>
          <p:cNvSpPr>
            <a:spLocks noGrp="1"/>
          </p:cNvSpPr>
          <p:nvPr>
            <p:ph type="body" sz="half" idx="2"/>
          </p:nvPr>
        </p:nvSpPr>
        <p:spPr>
          <a:xfrm>
            <a:off x="520931" y="3206592"/>
            <a:ext cx="2439216" cy="5940607"/>
          </a:xfrm>
        </p:spPr>
        <p:txBody>
          <a:bodyPr/>
          <a:lstStyle>
            <a:lvl1pPr marL="0" indent="0">
              <a:buNone/>
              <a:defRPr sz="1323"/>
            </a:lvl1pPr>
            <a:lvl2pPr marL="378150" indent="0">
              <a:buNone/>
              <a:defRPr sz="1158"/>
            </a:lvl2pPr>
            <a:lvl3pPr marL="756300" indent="0">
              <a:buNone/>
              <a:defRPr sz="993"/>
            </a:lvl3pPr>
            <a:lvl4pPr marL="1134450" indent="0">
              <a:buNone/>
              <a:defRPr sz="827"/>
            </a:lvl4pPr>
            <a:lvl5pPr marL="1512600" indent="0">
              <a:buNone/>
              <a:defRPr sz="827"/>
            </a:lvl5pPr>
            <a:lvl6pPr marL="1890751" indent="0">
              <a:buNone/>
              <a:defRPr sz="827"/>
            </a:lvl6pPr>
            <a:lvl7pPr marL="2268901" indent="0">
              <a:buNone/>
              <a:defRPr sz="827"/>
            </a:lvl7pPr>
            <a:lvl8pPr marL="2647051" indent="0">
              <a:buNone/>
              <a:defRPr sz="827"/>
            </a:lvl8pPr>
            <a:lvl9pPr marL="3025201" indent="0">
              <a:buNone/>
              <a:defRPr sz="827"/>
            </a:lvl9pPr>
          </a:lstStyle>
          <a:p>
            <a:pPr lvl="0"/>
            <a:r>
              <a:rPr lang="en-US"/>
              <a:t>Click to edit Master text styles</a:t>
            </a:r>
          </a:p>
        </p:txBody>
      </p:sp>
      <p:sp>
        <p:nvSpPr>
          <p:cNvPr id="5" name="Date Placeholder 4"/>
          <p:cNvSpPr>
            <a:spLocks noGrp="1"/>
          </p:cNvSpPr>
          <p:nvPr>
            <p:ph type="dt" sz="half" idx="10"/>
          </p:nvPr>
        </p:nvSpPr>
        <p:spPr/>
        <p:txBody>
          <a:bodyPr/>
          <a:lstStyle/>
          <a:p>
            <a:fld id="{E20744AC-B2B4-40A3-932B-6CF6AE4C2734}" type="datetimeFigureOut">
              <a:rPr lang="en-US" smtClean="0"/>
              <a:t>5/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384EE76-5F11-4611-BBF7-9988FE141921}" type="slidenum">
              <a:rPr lang="en-US" smtClean="0"/>
              <a:t>‹#›</a:t>
            </a:fld>
            <a:endParaRPr lang="en-US"/>
          </a:p>
        </p:txBody>
      </p:sp>
    </p:spTree>
    <p:extLst>
      <p:ext uri="{BB962C8B-B14F-4D97-AF65-F5344CB8AC3E}">
        <p14:creationId xmlns:p14="http://schemas.microsoft.com/office/powerpoint/2010/main" val="19118992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946" y="569073"/>
            <a:ext cx="6522958" cy="20659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19946" y="2845355"/>
            <a:ext cx="6522958" cy="678184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19946" y="9906786"/>
            <a:ext cx="1701641" cy="569071"/>
          </a:xfrm>
          <a:prstGeom prst="rect">
            <a:avLst/>
          </a:prstGeom>
        </p:spPr>
        <p:txBody>
          <a:bodyPr vert="horz" lIns="91440" tIns="45720" rIns="91440" bIns="45720" rtlCol="0" anchor="ctr"/>
          <a:lstStyle>
            <a:lvl1pPr algn="l">
              <a:defRPr sz="993">
                <a:solidFill>
                  <a:schemeClr val="tx1">
                    <a:tint val="82000"/>
                  </a:schemeClr>
                </a:solidFill>
              </a:defRPr>
            </a:lvl1pPr>
          </a:lstStyle>
          <a:p>
            <a:fld id="{E20744AC-B2B4-40A3-932B-6CF6AE4C2734}" type="datetimeFigureOut">
              <a:rPr lang="en-US" smtClean="0"/>
              <a:t>5/9/2024</a:t>
            </a:fld>
            <a:endParaRPr lang="en-US"/>
          </a:p>
        </p:txBody>
      </p:sp>
      <p:sp>
        <p:nvSpPr>
          <p:cNvPr id="5" name="Footer Placeholder 4"/>
          <p:cNvSpPr>
            <a:spLocks noGrp="1"/>
          </p:cNvSpPr>
          <p:nvPr>
            <p:ph type="ftr" sz="quarter" idx="3"/>
          </p:nvPr>
        </p:nvSpPr>
        <p:spPr>
          <a:xfrm>
            <a:off x="2505194" y="9906786"/>
            <a:ext cx="2552462" cy="569071"/>
          </a:xfrm>
          <a:prstGeom prst="rect">
            <a:avLst/>
          </a:prstGeom>
        </p:spPr>
        <p:txBody>
          <a:bodyPr vert="horz" lIns="91440" tIns="45720" rIns="91440" bIns="45720" rtlCol="0" anchor="ctr"/>
          <a:lstStyle>
            <a:lvl1pPr algn="ctr">
              <a:defRPr sz="993">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5341263" y="9906786"/>
            <a:ext cx="1701641" cy="569071"/>
          </a:xfrm>
          <a:prstGeom prst="rect">
            <a:avLst/>
          </a:prstGeom>
        </p:spPr>
        <p:txBody>
          <a:bodyPr vert="horz" lIns="91440" tIns="45720" rIns="91440" bIns="45720" rtlCol="0" anchor="ctr"/>
          <a:lstStyle>
            <a:lvl1pPr algn="r">
              <a:defRPr sz="993">
                <a:solidFill>
                  <a:schemeClr val="tx1">
                    <a:tint val="82000"/>
                  </a:schemeClr>
                </a:solidFill>
              </a:defRPr>
            </a:lvl1pPr>
          </a:lstStyle>
          <a:p>
            <a:fld id="{2384EE76-5F11-4611-BBF7-9988FE141921}" type="slidenum">
              <a:rPr lang="en-US" smtClean="0"/>
              <a:t>‹#›</a:t>
            </a:fld>
            <a:endParaRPr lang="en-US"/>
          </a:p>
        </p:txBody>
      </p:sp>
    </p:spTree>
    <p:extLst>
      <p:ext uri="{BB962C8B-B14F-4D97-AF65-F5344CB8AC3E}">
        <p14:creationId xmlns:p14="http://schemas.microsoft.com/office/powerpoint/2010/main" val="132029538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6300" rtl="0" eaLnBrk="1" latinLnBrk="0" hangingPunct="1">
        <a:lnSpc>
          <a:spcPct val="90000"/>
        </a:lnSpc>
        <a:spcBef>
          <a:spcPct val="0"/>
        </a:spcBef>
        <a:buNone/>
        <a:defRPr sz="3639" kern="1200">
          <a:solidFill>
            <a:schemeClr val="tx1"/>
          </a:solidFill>
          <a:latin typeface="+mj-lt"/>
          <a:ea typeface="+mj-ea"/>
          <a:cs typeface="+mj-cs"/>
        </a:defRPr>
      </a:lvl1pPr>
    </p:titleStyle>
    <p:bodyStyle>
      <a:lvl1pPr marL="189075" indent="-189075" algn="l" defTabSz="756300" rtl="0" eaLnBrk="1" latinLnBrk="0" hangingPunct="1">
        <a:lnSpc>
          <a:spcPct val="90000"/>
        </a:lnSpc>
        <a:spcBef>
          <a:spcPts val="827"/>
        </a:spcBef>
        <a:buFont typeface="Arial" panose="020B0604020202020204" pitchFamily="34" charset="0"/>
        <a:buChar char="•"/>
        <a:defRPr sz="2316" kern="1200">
          <a:solidFill>
            <a:schemeClr val="tx1"/>
          </a:solidFill>
          <a:latin typeface="+mn-lt"/>
          <a:ea typeface="+mn-ea"/>
          <a:cs typeface="+mn-cs"/>
        </a:defRPr>
      </a:lvl1pPr>
      <a:lvl2pPr marL="567225" indent="-189075" algn="l" defTabSz="756300" rtl="0" eaLnBrk="1" latinLnBrk="0" hangingPunct="1">
        <a:lnSpc>
          <a:spcPct val="90000"/>
        </a:lnSpc>
        <a:spcBef>
          <a:spcPts val="414"/>
        </a:spcBef>
        <a:buFont typeface="Arial" panose="020B0604020202020204" pitchFamily="34" charset="0"/>
        <a:buChar char="•"/>
        <a:defRPr sz="1985" kern="1200">
          <a:solidFill>
            <a:schemeClr val="tx1"/>
          </a:solidFill>
          <a:latin typeface="+mn-lt"/>
          <a:ea typeface="+mn-ea"/>
          <a:cs typeface="+mn-cs"/>
        </a:defRPr>
      </a:lvl2pPr>
      <a:lvl3pPr marL="945375" indent="-189075" algn="l" defTabSz="756300" rtl="0" eaLnBrk="1" latinLnBrk="0" hangingPunct="1">
        <a:lnSpc>
          <a:spcPct val="90000"/>
        </a:lnSpc>
        <a:spcBef>
          <a:spcPts val="414"/>
        </a:spcBef>
        <a:buFont typeface="Arial" panose="020B0604020202020204" pitchFamily="34" charset="0"/>
        <a:buChar char="•"/>
        <a:defRPr sz="1654" kern="1200">
          <a:solidFill>
            <a:schemeClr val="tx1"/>
          </a:solidFill>
          <a:latin typeface="+mn-lt"/>
          <a:ea typeface="+mn-ea"/>
          <a:cs typeface="+mn-cs"/>
        </a:defRPr>
      </a:lvl3pPr>
      <a:lvl4pPr marL="1323525" indent="-189075" algn="l" defTabSz="756300" rtl="0" eaLnBrk="1" latinLnBrk="0" hangingPunct="1">
        <a:lnSpc>
          <a:spcPct val="90000"/>
        </a:lnSpc>
        <a:spcBef>
          <a:spcPts val="414"/>
        </a:spcBef>
        <a:buFont typeface="Arial" panose="020B0604020202020204" pitchFamily="34" charset="0"/>
        <a:buChar char="•"/>
        <a:defRPr sz="1489" kern="1200">
          <a:solidFill>
            <a:schemeClr val="tx1"/>
          </a:solidFill>
          <a:latin typeface="+mn-lt"/>
          <a:ea typeface="+mn-ea"/>
          <a:cs typeface="+mn-cs"/>
        </a:defRPr>
      </a:lvl4pPr>
      <a:lvl5pPr marL="1701676" indent="-189075" algn="l" defTabSz="756300" rtl="0" eaLnBrk="1" latinLnBrk="0" hangingPunct="1">
        <a:lnSpc>
          <a:spcPct val="90000"/>
        </a:lnSpc>
        <a:spcBef>
          <a:spcPts val="414"/>
        </a:spcBef>
        <a:buFont typeface="Arial" panose="020B0604020202020204" pitchFamily="34" charset="0"/>
        <a:buChar char="•"/>
        <a:defRPr sz="1489" kern="1200">
          <a:solidFill>
            <a:schemeClr val="tx1"/>
          </a:solidFill>
          <a:latin typeface="+mn-lt"/>
          <a:ea typeface="+mn-ea"/>
          <a:cs typeface="+mn-cs"/>
        </a:defRPr>
      </a:lvl5pPr>
      <a:lvl6pPr marL="2079826" indent="-189075" algn="l" defTabSz="756300" rtl="0" eaLnBrk="1" latinLnBrk="0" hangingPunct="1">
        <a:lnSpc>
          <a:spcPct val="90000"/>
        </a:lnSpc>
        <a:spcBef>
          <a:spcPts val="414"/>
        </a:spcBef>
        <a:buFont typeface="Arial" panose="020B0604020202020204" pitchFamily="34" charset="0"/>
        <a:buChar char="•"/>
        <a:defRPr sz="1489" kern="1200">
          <a:solidFill>
            <a:schemeClr val="tx1"/>
          </a:solidFill>
          <a:latin typeface="+mn-lt"/>
          <a:ea typeface="+mn-ea"/>
          <a:cs typeface="+mn-cs"/>
        </a:defRPr>
      </a:lvl6pPr>
      <a:lvl7pPr marL="2457976" indent="-189075" algn="l" defTabSz="756300" rtl="0" eaLnBrk="1" latinLnBrk="0" hangingPunct="1">
        <a:lnSpc>
          <a:spcPct val="90000"/>
        </a:lnSpc>
        <a:spcBef>
          <a:spcPts val="414"/>
        </a:spcBef>
        <a:buFont typeface="Arial" panose="020B0604020202020204" pitchFamily="34" charset="0"/>
        <a:buChar char="•"/>
        <a:defRPr sz="1489" kern="1200">
          <a:solidFill>
            <a:schemeClr val="tx1"/>
          </a:solidFill>
          <a:latin typeface="+mn-lt"/>
          <a:ea typeface="+mn-ea"/>
          <a:cs typeface="+mn-cs"/>
        </a:defRPr>
      </a:lvl7pPr>
      <a:lvl8pPr marL="2836126" indent="-189075" algn="l" defTabSz="756300" rtl="0" eaLnBrk="1" latinLnBrk="0" hangingPunct="1">
        <a:lnSpc>
          <a:spcPct val="90000"/>
        </a:lnSpc>
        <a:spcBef>
          <a:spcPts val="414"/>
        </a:spcBef>
        <a:buFont typeface="Arial" panose="020B0604020202020204" pitchFamily="34" charset="0"/>
        <a:buChar char="•"/>
        <a:defRPr sz="1489" kern="1200">
          <a:solidFill>
            <a:schemeClr val="tx1"/>
          </a:solidFill>
          <a:latin typeface="+mn-lt"/>
          <a:ea typeface="+mn-ea"/>
          <a:cs typeface="+mn-cs"/>
        </a:defRPr>
      </a:lvl8pPr>
      <a:lvl9pPr marL="3214276" indent="-189075" algn="l" defTabSz="756300" rtl="0" eaLnBrk="1" latinLnBrk="0" hangingPunct="1">
        <a:lnSpc>
          <a:spcPct val="90000"/>
        </a:lnSpc>
        <a:spcBef>
          <a:spcPts val="414"/>
        </a:spcBef>
        <a:buFont typeface="Arial" panose="020B0604020202020204" pitchFamily="34" charset="0"/>
        <a:buChar char="•"/>
        <a:defRPr sz="1489" kern="1200">
          <a:solidFill>
            <a:schemeClr val="tx1"/>
          </a:solidFill>
          <a:latin typeface="+mn-lt"/>
          <a:ea typeface="+mn-ea"/>
          <a:cs typeface="+mn-cs"/>
        </a:defRPr>
      </a:lvl9pPr>
    </p:bodyStyle>
    <p:otherStyle>
      <a:defPPr>
        <a:defRPr lang="en-US"/>
      </a:defPPr>
      <a:lvl1pPr marL="0" algn="l" defTabSz="756300" rtl="0" eaLnBrk="1" latinLnBrk="0" hangingPunct="1">
        <a:defRPr sz="1489" kern="1200">
          <a:solidFill>
            <a:schemeClr val="tx1"/>
          </a:solidFill>
          <a:latin typeface="+mn-lt"/>
          <a:ea typeface="+mn-ea"/>
          <a:cs typeface="+mn-cs"/>
        </a:defRPr>
      </a:lvl1pPr>
      <a:lvl2pPr marL="378150" algn="l" defTabSz="756300" rtl="0" eaLnBrk="1" latinLnBrk="0" hangingPunct="1">
        <a:defRPr sz="1489" kern="1200">
          <a:solidFill>
            <a:schemeClr val="tx1"/>
          </a:solidFill>
          <a:latin typeface="+mn-lt"/>
          <a:ea typeface="+mn-ea"/>
          <a:cs typeface="+mn-cs"/>
        </a:defRPr>
      </a:lvl2pPr>
      <a:lvl3pPr marL="756300" algn="l" defTabSz="756300" rtl="0" eaLnBrk="1" latinLnBrk="0" hangingPunct="1">
        <a:defRPr sz="1489" kern="1200">
          <a:solidFill>
            <a:schemeClr val="tx1"/>
          </a:solidFill>
          <a:latin typeface="+mn-lt"/>
          <a:ea typeface="+mn-ea"/>
          <a:cs typeface="+mn-cs"/>
        </a:defRPr>
      </a:lvl3pPr>
      <a:lvl4pPr marL="1134450" algn="l" defTabSz="756300" rtl="0" eaLnBrk="1" latinLnBrk="0" hangingPunct="1">
        <a:defRPr sz="1489" kern="1200">
          <a:solidFill>
            <a:schemeClr val="tx1"/>
          </a:solidFill>
          <a:latin typeface="+mn-lt"/>
          <a:ea typeface="+mn-ea"/>
          <a:cs typeface="+mn-cs"/>
        </a:defRPr>
      </a:lvl4pPr>
      <a:lvl5pPr marL="1512600" algn="l" defTabSz="756300" rtl="0" eaLnBrk="1" latinLnBrk="0" hangingPunct="1">
        <a:defRPr sz="1489" kern="1200">
          <a:solidFill>
            <a:schemeClr val="tx1"/>
          </a:solidFill>
          <a:latin typeface="+mn-lt"/>
          <a:ea typeface="+mn-ea"/>
          <a:cs typeface="+mn-cs"/>
        </a:defRPr>
      </a:lvl5pPr>
      <a:lvl6pPr marL="1890751" algn="l" defTabSz="756300" rtl="0" eaLnBrk="1" latinLnBrk="0" hangingPunct="1">
        <a:defRPr sz="1489" kern="1200">
          <a:solidFill>
            <a:schemeClr val="tx1"/>
          </a:solidFill>
          <a:latin typeface="+mn-lt"/>
          <a:ea typeface="+mn-ea"/>
          <a:cs typeface="+mn-cs"/>
        </a:defRPr>
      </a:lvl6pPr>
      <a:lvl7pPr marL="2268901" algn="l" defTabSz="756300" rtl="0" eaLnBrk="1" latinLnBrk="0" hangingPunct="1">
        <a:defRPr sz="1489" kern="1200">
          <a:solidFill>
            <a:schemeClr val="tx1"/>
          </a:solidFill>
          <a:latin typeface="+mn-lt"/>
          <a:ea typeface="+mn-ea"/>
          <a:cs typeface="+mn-cs"/>
        </a:defRPr>
      </a:lvl7pPr>
      <a:lvl8pPr marL="2647051" algn="l" defTabSz="756300" rtl="0" eaLnBrk="1" latinLnBrk="0" hangingPunct="1">
        <a:defRPr sz="1489" kern="1200">
          <a:solidFill>
            <a:schemeClr val="tx1"/>
          </a:solidFill>
          <a:latin typeface="+mn-lt"/>
          <a:ea typeface="+mn-ea"/>
          <a:cs typeface="+mn-cs"/>
        </a:defRPr>
      </a:lvl8pPr>
      <a:lvl9pPr marL="3025201" algn="l" defTabSz="756300" rtl="0" eaLnBrk="1" latinLnBrk="0" hangingPunct="1">
        <a:defRPr sz="148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7" Type="http://schemas.openxmlformats.org/officeDocument/2006/relationships/chart" Target="../charts/chart5.xml"/><Relationship Id="rId2" Type="http://schemas.openxmlformats.org/officeDocument/2006/relationships/image" Target="../media/image4.png"/><Relationship Id="rId1" Type="http://schemas.openxmlformats.org/officeDocument/2006/relationships/slideLayout" Target="../slideLayouts/slideLayout1.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A30103A-E334-8615-2957-23F12B710D7E}"/>
              </a:ext>
            </a:extLst>
          </p:cNvPr>
          <p:cNvPicPr>
            <a:picLocks noChangeAspect="1"/>
          </p:cNvPicPr>
          <p:nvPr/>
        </p:nvPicPr>
        <p:blipFill>
          <a:blip r:embed="rId2"/>
          <a:stretch>
            <a:fillRect/>
          </a:stretch>
        </p:blipFill>
        <p:spPr>
          <a:xfrm>
            <a:off x="566167" y="361975"/>
            <a:ext cx="6430515" cy="3546348"/>
          </a:xfrm>
          <a:prstGeom prst="rect">
            <a:avLst/>
          </a:prstGeom>
        </p:spPr>
      </p:pic>
      <p:sp>
        <p:nvSpPr>
          <p:cNvPr id="6" name="Rectangle 5">
            <a:extLst>
              <a:ext uri="{FF2B5EF4-FFF2-40B4-BE49-F238E27FC236}">
                <a16:creationId xmlns:a16="http://schemas.microsoft.com/office/drawing/2014/main" id="{40415617-B006-C5C7-5F93-086A22478F3B}"/>
              </a:ext>
            </a:extLst>
          </p:cNvPr>
          <p:cNvSpPr/>
          <p:nvPr/>
        </p:nvSpPr>
        <p:spPr>
          <a:xfrm>
            <a:off x="696036" y="361975"/>
            <a:ext cx="1651379" cy="68890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AA57A387-6A37-29F1-FA89-A2EC284EFBB3}"/>
              </a:ext>
            </a:extLst>
          </p:cNvPr>
          <p:cNvSpPr txBox="1"/>
          <p:nvPr/>
        </p:nvSpPr>
        <p:spPr>
          <a:xfrm>
            <a:off x="124420" y="26851"/>
            <a:ext cx="574196" cy="369332"/>
          </a:xfrm>
          <a:prstGeom prst="rect">
            <a:avLst/>
          </a:prstGeom>
          <a:noFill/>
        </p:spPr>
        <p:txBody>
          <a:bodyPr wrap="none" rtlCol="0">
            <a:spAutoFit/>
          </a:bodyPr>
          <a:lstStyle/>
          <a:p>
            <a:r>
              <a:rPr lang="en-US" dirty="0"/>
              <a:t>S1A</a:t>
            </a:r>
          </a:p>
        </p:txBody>
      </p:sp>
      <p:sp>
        <p:nvSpPr>
          <p:cNvPr id="8" name="TextBox 7">
            <a:extLst>
              <a:ext uri="{FF2B5EF4-FFF2-40B4-BE49-F238E27FC236}">
                <a16:creationId xmlns:a16="http://schemas.microsoft.com/office/drawing/2014/main" id="{ACC323F5-02D5-7E9C-687D-931D061DC64C}"/>
              </a:ext>
            </a:extLst>
          </p:cNvPr>
          <p:cNvSpPr txBox="1"/>
          <p:nvPr/>
        </p:nvSpPr>
        <p:spPr>
          <a:xfrm>
            <a:off x="117406" y="3696714"/>
            <a:ext cx="7441461" cy="369332"/>
          </a:xfrm>
          <a:prstGeom prst="rect">
            <a:avLst/>
          </a:prstGeom>
          <a:noFill/>
        </p:spPr>
        <p:txBody>
          <a:bodyPr wrap="none" rtlCol="0">
            <a:spAutoFit/>
          </a:bodyPr>
          <a:lstStyle/>
          <a:p>
            <a:r>
              <a:rPr lang="en-US" dirty="0"/>
              <a:t>The number of SRM transitions occurring during each measurement cycle</a:t>
            </a:r>
          </a:p>
        </p:txBody>
      </p:sp>
      <p:pic>
        <p:nvPicPr>
          <p:cNvPr id="9" name="Picture 8">
            <a:extLst>
              <a:ext uri="{FF2B5EF4-FFF2-40B4-BE49-F238E27FC236}">
                <a16:creationId xmlns:a16="http://schemas.microsoft.com/office/drawing/2014/main" id="{44CC0774-80FF-3536-F886-04E7BE147407}"/>
              </a:ext>
            </a:extLst>
          </p:cNvPr>
          <p:cNvPicPr>
            <a:picLocks noChangeAspect="1"/>
          </p:cNvPicPr>
          <p:nvPr/>
        </p:nvPicPr>
        <p:blipFill>
          <a:blip r:embed="rId3"/>
          <a:stretch>
            <a:fillRect/>
          </a:stretch>
        </p:blipFill>
        <p:spPr>
          <a:xfrm>
            <a:off x="593195" y="5935172"/>
            <a:ext cx="2891674" cy="3135659"/>
          </a:xfrm>
          <a:prstGeom prst="rect">
            <a:avLst/>
          </a:prstGeom>
        </p:spPr>
      </p:pic>
      <p:pic>
        <p:nvPicPr>
          <p:cNvPr id="10" name="Picture 9">
            <a:extLst>
              <a:ext uri="{FF2B5EF4-FFF2-40B4-BE49-F238E27FC236}">
                <a16:creationId xmlns:a16="http://schemas.microsoft.com/office/drawing/2014/main" id="{E0DF2F7C-8369-9D76-C6FE-899597A3FECD}"/>
              </a:ext>
            </a:extLst>
          </p:cNvPr>
          <p:cNvPicPr>
            <a:picLocks noChangeAspect="1"/>
          </p:cNvPicPr>
          <p:nvPr/>
        </p:nvPicPr>
        <p:blipFill>
          <a:blip r:embed="rId4"/>
          <a:stretch>
            <a:fillRect/>
          </a:stretch>
        </p:blipFill>
        <p:spPr>
          <a:xfrm>
            <a:off x="4201077" y="5935171"/>
            <a:ext cx="2891674" cy="3135659"/>
          </a:xfrm>
          <a:prstGeom prst="rect">
            <a:avLst/>
          </a:prstGeom>
        </p:spPr>
      </p:pic>
      <p:sp>
        <p:nvSpPr>
          <p:cNvPr id="11" name="TextBox 10">
            <a:extLst>
              <a:ext uri="{FF2B5EF4-FFF2-40B4-BE49-F238E27FC236}">
                <a16:creationId xmlns:a16="http://schemas.microsoft.com/office/drawing/2014/main" id="{707FA75D-51F5-4DA9-13BA-6D49DE9EDC59}"/>
              </a:ext>
            </a:extLst>
          </p:cNvPr>
          <p:cNvSpPr txBox="1"/>
          <p:nvPr/>
        </p:nvSpPr>
        <p:spPr>
          <a:xfrm>
            <a:off x="210775" y="4243447"/>
            <a:ext cx="577402" cy="369332"/>
          </a:xfrm>
          <a:prstGeom prst="rect">
            <a:avLst/>
          </a:prstGeom>
          <a:noFill/>
        </p:spPr>
        <p:txBody>
          <a:bodyPr wrap="none" rtlCol="0">
            <a:spAutoFit/>
          </a:bodyPr>
          <a:lstStyle/>
          <a:p>
            <a:r>
              <a:rPr lang="en-US" dirty="0"/>
              <a:t>S1B</a:t>
            </a:r>
          </a:p>
        </p:txBody>
      </p:sp>
      <p:sp>
        <p:nvSpPr>
          <p:cNvPr id="12" name="TextBox 11">
            <a:extLst>
              <a:ext uri="{FF2B5EF4-FFF2-40B4-BE49-F238E27FC236}">
                <a16:creationId xmlns:a16="http://schemas.microsoft.com/office/drawing/2014/main" id="{795E2299-F25A-524C-20B4-04281C9922DE}"/>
              </a:ext>
            </a:extLst>
          </p:cNvPr>
          <p:cNvSpPr txBox="1"/>
          <p:nvPr/>
        </p:nvSpPr>
        <p:spPr>
          <a:xfrm>
            <a:off x="3931340" y="5557610"/>
            <a:ext cx="324128" cy="369332"/>
          </a:xfrm>
          <a:prstGeom prst="rect">
            <a:avLst/>
          </a:prstGeom>
          <a:noFill/>
        </p:spPr>
        <p:txBody>
          <a:bodyPr wrap="none" rtlCol="0">
            <a:spAutoFit/>
          </a:bodyPr>
          <a:lstStyle/>
          <a:p>
            <a:r>
              <a:rPr lang="en-US" dirty="0"/>
              <a:t>B</a:t>
            </a:r>
          </a:p>
        </p:txBody>
      </p:sp>
      <p:sp>
        <p:nvSpPr>
          <p:cNvPr id="13" name="TextBox 12">
            <a:extLst>
              <a:ext uri="{FF2B5EF4-FFF2-40B4-BE49-F238E27FC236}">
                <a16:creationId xmlns:a16="http://schemas.microsoft.com/office/drawing/2014/main" id="{0976A6DC-434F-ABDF-B33E-93437D308A97}"/>
              </a:ext>
            </a:extLst>
          </p:cNvPr>
          <p:cNvSpPr txBox="1"/>
          <p:nvPr/>
        </p:nvSpPr>
        <p:spPr>
          <a:xfrm>
            <a:off x="1004955" y="5696166"/>
            <a:ext cx="2999347" cy="338554"/>
          </a:xfrm>
          <a:prstGeom prst="rect">
            <a:avLst/>
          </a:prstGeom>
          <a:noFill/>
        </p:spPr>
        <p:txBody>
          <a:bodyPr wrap="none" rtlCol="0">
            <a:spAutoFit/>
          </a:bodyPr>
          <a:lstStyle/>
          <a:p>
            <a:r>
              <a:rPr lang="en-US" sz="1600" dirty="0"/>
              <a:t>Prior to Dwell Time Prioritization</a:t>
            </a:r>
          </a:p>
        </p:txBody>
      </p:sp>
      <p:sp>
        <p:nvSpPr>
          <p:cNvPr id="14" name="TextBox 13">
            <a:extLst>
              <a:ext uri="{FF2B5EF4-FFF2-40B4-BE49-F238E27FC236}">
                <a16:creationId xmlns:a16="http://schemas.microsoft.com/office/drawing/2014/main" id="{8372945B-B951-EB93-B514-376187D7AFC7}"/>
              </a:ext>
            </a:extLst>
          </p:cNvPr>
          <p:cNvSpPr txBox="1"/>
          <p:nvPr/>
        </p:nvSpPr>
        <p:spPr>
          <a:xfrm>
            <a:off x="4560427" y="5696671"/>
            <a:ext cx="2786147" cy="338554"/>
          </a:xfrm>
          <a:prstGeom prst="rect">
            <a:avLst/>
          </a:prstGeom>
          <a:noFill/>
        </p:spPr>
        <p:txBody>
          <a:bodyPr wrap="none" rtlCol="0">
            <a:spAutoFit/>
          </a:bodyPr>
          <a:lstStyle/>
          <a:p>
            <a:r>
              <a:rPr lang="en-US" sz="1600" dirty="0"/>
              <a:t>After Dwell Time Prioritization</a:t>
            </a:r>
          </a:p>
        </p:txBody>
      </p:sp>
      <p:sp>
        <p:nvSpPr>
          <p:cNvPr id="15" name="TextBox 14">
            <a:extLst>
              <a:ext uri="{FF2B5EF4-FFF2-40B4-BE49-F238E27FC236}">
                <a16:creationId xmlns:a16="http://schemas.microsoft.com/office/drawing/2014/main" id="{FEDC7601-69C5-C220-8BDB-3D333F257196}"/>
              </a:ext>
            </a:extLst>
          </p:cNvPr>
          <p:cNvSpPr txBox="1"/>
          <p:nvPr/>
        </p:nvSpPr>
        <p:spPr>
          <a:xfrm>
            <a:off x="2611285" y="4656026"/>
            <a:ext cx="2348720" cy="923330"/>
          </a:xfrm>
          <a:prstGeom prst="rect">
            <a:avLst/>
          </a:prstGeom>
          <a:noFill/>
        </p:spPr>
        <p:txBody>
          <a:bodyPr wrap="none" rtlCol="0">
            <a:spAutoFit/>
          </a:bodyPr>
          <a:lstStyle/>
          <a:p>
            <a:r>
              <a:rPr lang="en-US" dirty="0"/>
              <a:t>U</a:t>
            </a:r>
            <a:r>
              <a:rPr lang="en-US" baseline="30000" dirty="0"/>
              <a:t>13</a:t>
            </a:r>
            <a:r>
              <a:rPr lang="en-US" dirty="0"/>
              <a:t>C-Guanosine</a:t>
            </a:r>
          </a:p>
          <a:p>
            <a:r>
              <a:rPr lang="en-US" dirty="0">
                <a:solidFill>
                  <a:srgbClr val="0000FF"/>
                </a:solidFill>
              </a:rPr>
              <a:t>m/z 294 </a:t>
            </a:r>
            <a:r>
              <a:rPr lang="en-US" dirty="0">
                <a:solidFill>
                  <a:srgbClr val="0000FF"/>
                </a:solidFill>
                <a:sym typeface="Wingdings" panose="05000000000000000000" pitchFamily="2" charset="2"/>
              </a:rPr>
              <a:t>m/z 157 (+)</a:t>
            </a:r>
          </a:p>
          <a:p>
            <a:r>
              <a:rPr lang="en-US" dirty="0">
                <a:solidFill>
                  <a:schemeClr val="accent5"/>
                </a:solidFill>
                <a:sym typeface="Wingdings" panose="05000000000000000000" pitchFamily="2" charset="2"/>
              </a:rPr>
              <a:t>m/z 294 m/z140 (+)</a:t>
            </a:r>
            <a:endParaRPr lang="en-US" dirty="0">
              <a:solidFill>
                <a:schemeClr val="accent5"/>
              </a:solidFill>
            </a:endParaRPr>
          </a:p>
        </p:txBody>
      </p:sp>
      <p:sp>
        <p:nvSpPr>
          <p:cNvPr id="16" name="TextBox 15">
            <a:extLst>
              <a:ext uri="{FF2B5EF4-FFF2-40B4-BE49-F238E27FC236}">
                <a16:creationId xmlns:a16="http://schemas.microsoft.com/office/drawing/2014/main" id="{FBB68053-39C8-EC22-174B-71DDDCE5E02F}"/>
              </a:ext>
            </a:extLst>
          </p:cNvPr>
          <p:cNvSpPr txBox="1"/>
          <p:nvPr/>
        </p:nvSpPr>
        <p:spPr>
          <a:xfrm>
            <a:off x="5953500" y="7503000"/>
            <a:ext cx="787395" cy="369332"/>
          </a:xfrm>
          <a:prstGeom prst="rect">
            <a:avLst/>
          </a:prstGeom>
          <a:noFill/>
        </p:spPr>
        <p:txBody>
          <a:bodyPr wrap="none" rtlCol="0">
            <a:spAutoFit/>
          </a:bodyPr>
          <a:lstStyle/>
          <a:p>
            <a:r>
              <a:rPr lang="en-US" dirty="0"/>
              <a:t>51 </a:t>
            </a:r>
            <a:r>
              <a:rPr lang="en-US" dirty="0" err="1"/>
              <a:t>ms</a:t>
            </a:r>
            <a:endParaRPr lang="en-US" dirty="0"/>
          </a:p>
        </p:txBody>
      </p:sp>
      <p:sp>
        <p:nvSpPr>
          <p:cNvPr id="17" name="TextBox 16">
            <a:extLst>
              <a:ext uri="{FF2B5EF4-FFF2-40B4-BE49-F238E27FC236}">
                <a16:creationId xmlns:a16="http://schemas.microsoft.com/office/drawing/2014/main" id="{112571CC-5B9A-83EB-5C2F-98A17578FB4D}"/>
              </a:ext>
            </a:extLst>
          </p:cNvPr>
          <p:cNvSpPr txBox="1"/>
          <p:nvPr/>
        </p:nvSpPr>
        <p:spPr>
          <a:xfrm>
            <a:off x="2471746" y="7503000"/>
            <a:ext cx="853119" cy="369332"/>
          </a:xfrm>
          <a:prstGeom prst="rect">
            <a:avLst/>
          </a:prstGeom>
          <a:noFill/>
        </p:spPr>
        <p:txBody>
          <a:bodyPr wrap="none" rtlCol="0">
            <a:spAutoFit/>
          </a:bodyPr>
          <a:lstStyle/>
          <a:p>
            <a:r>
              <a:rPr lang="en-US" dirty="0"/>
              <a:t>0.4 </a:t>
            </a:r>
            <a:r>
              <a:rPr lang="en-US" dirty="0" err="1"/>
              <a:t>ms</a:t>
            </a:r>
            <a:endParaRPr lang="en-US" dirty="0"/>
          </a:p>
        </p:txBody>
      </p:sp>
      <p:sp>
        <p:nvSpPr>
          <p:cNvPr id="18" name="TextBox 17">
            <a:extLst>
              <a:ext uri="{FF2B5EF4-FFF2-40B4-BE49-F238E27FC236}">
                <a16:creationId xmlns:a16="http://schemas.microsoft.com/office/drawing/2014/main" id="{7AC47DDF-5484-8915-5478-6C7E91F0D8E3}"/>
              </a:ext>
            </a:extLst>
          </p:cNvPr>
          <p:cNvSpPr txBox="1"/>
          <p:nvPr/>
        </p:nvSpPr>
        <p:spPr>
          <a:xfrm>
            <a:off x="380736" y="9180883"/>
            <a:ext cx="7121117" cy="369332"/>
          </a:xfrm>
          <a:prstGeom prst="rect">
            <a:avLst/>
          </a:prstGeom>
          <a:noFill/>
        </p:spPr>
        <p:txBody>
          <a:bodyPr wrap="none" rtlCol="0">
            <a:spAutoFit/>
          </a:bodyPr>
          <a:lstStyle/>
          <a:p>
            <a:r>
              <a:rPr lang="en-US" dirty="0"/>
              <a:t>U</a:t>
            </a:r>
            <a:r>
              <a:rPr lang="en-US" baseline="30000" dirty="0"/>
              <a:t>13</a:t>
            </a:r>
            <a:r>
              <a:rPr lang="en-US" dirty="0"/>
              <a:t>C-Guanosine in pooled urine, pre and post dwell time prioritization </a:t>
            </a:r>
          </a:p>
        </p:txBody>
      </p:sp>
      <p:sp>
        <p:nvSpPr>
          <p:cNvPr id="2" name="Rectangle 1">
            <a:extLst>
              <a:ext uri="{FF2B5EF4-FFF2-40B4-BE49-F238E27FC236}">
                <a16:creationId xmlns:a16="http://schemas.microsoft.com/office/drawing/2014/main" id="{23178C4D-B3E8-0972-3C3E-97795B3FAE5A}"/>
              </a:ext>
            </a:extLst>
          </p:cNvPr>
          <p:cNvSpPr/>
          <p:nvPr/>
        </p:nvSpPr>
        <p:spPr>
          <a:xfrm>
            <a:off x="809644" y="8865190"/>
            <a:ext cx="2745954" cy="20489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6663A3A0-76F2-0D7C-2966-64BE4EB0C795}"/>
              </a:ext>
            </a:extLst>
          </p:cNvPr>
          <p:cNvSpPr txBox="1"/>
          <p:nvPr/>
        </p:nvSpPr>
        <p:spPr>
          <a:xfrm>
            <a:off x="1479653" y="8985699"/>
            <a:ext cx="1324402" cy="246221"/>
          </a:xfrm>
          <a:prstGeom prst="rect">
            <a:avLst/>
          </a:prstGeom>
          <a:noFill/>
        </p:spPr>
        <p:txBody>
          <a:bodyPr wrap="none" rtlCol="0">
            <a:spAutoFit/>
          </a:bodyPr>
          <a:lstStyle/>
          <a:p>
            <a:r>
              <a:rPr lang="en-US" sz="1000" dirty="0"/>
              <a:t>Retention Time (min)</a:t>
            </a:r>
          </a:p>
        </p:txBody>
      </p:sp>
      <p:sp>
        <p:nvSpPr>
          <p:cNvPr id="4" name="TextBox 3">
            <a:extLst>
              <a:ext uri="{FF2B5EF4-FFF2-40B4-BE49-F238E27FC236}">
                <a16:creationId xmlns:a16="http://schemas.microsoft.com/office/drawing/2014/main" id="{05D71F9E-B5D0-675D-A974-D7FBFCF97FC6}"/>
              </a:ext>
            </a:extLst>
          </p:cNvPr>
          <p:cNvSpPr txBox="1"/>
          <p:nvPr/>
        </p:nvSpPr>
        <p:spPr>
          <a:xfrm>
            <a:off x="997537" y="8797104"/>
            <a:ext cx="359394" cy="246221"/>
          </a:xfrm>
          <a:prstGeom prst="rect">
            <a:avLst/>
          </a:prstGeom>
          <a:noFill/>
        </p:spPr>
        <p:txBody>
          <a:bodyPr wrap="none" rtlCol="0">
            <a:spAutoFit/>
          </a:bodyPr>
          <a:lstStyle/>
          <a:p>
            <a:r>
              <a:rPr lang="en-US" sz="1000" dirty="0"/>
              <a:t>5.5</a:t>
            </a:r>
          </a:p>
        </p:txBody>
      </p:sp>
      <p:sp>
        <p:nvSpPr>
          <p:cNvPr id="19" name="TextBox 18">
            <a:extLst>
              <a:ext uri="{FF2B5EF4-FFF2-40B4-BE49-F238E27FC236}">
                <a16:creationId xmlns:a16="http://schemas.microsoft.com/office/drawing/2014/main" id="{56B0C2D8-0896-4A4D-40DF-97DEE22C7C69}"/>
              </a:ext>
            </a:extLst>
          </p:cNvPr>
          <p:cNvSpPr txBox="1"/>
          <p:nvPr/>
        </p:nvSpPr>
        <p:spPr>
          <a:xfrm>
            <a:off x="1493530" y="8797104"/>
            <a:ext cx="359394" cy="246221"/>
          </a:xfrm>
          <a:prstGeom prst="rect">
            <a:avLst/>
          </a:prstGeom>
          <a:noFill/>
        </p:spPr>
        <p:txBody>
          <a:bodyPr wrap="none" rtlCol="0">
            <a:spAutoFit/>
          </a:bodyPr>
          <a:lstStyle/>
          <a:p>
            <a:r>
              <a:rPr lang="en-US" sz="1000" dirty="0"/>
              <a:t>5.7</a:t>
            </a:r>
          </a:p>
        </p:txBody>
      </p:sp>
      <p:sp>
        <p:nvSpPr>
          <p:cNvPr id="20" name="TextBox 19">
            <a:extLst>
              <a:ext uri="{FF2B5EF4-FFF2-40B4-BE49-F238E27FC236}">
                <a16:creationId xmlns:a16="http://schemas.microsoft.com/office/drawing/2014/main" id="{2206C8CF-63CC-DD81-F21D-E4652D3B8719}"/>
              </a:ext>
            </a:extLst>
          </p:cNvPr>
          <p:cNvSpPr txBox="1"/>
          <p:nvPr/>
        </p:nvSpPr>
        <p:spPr>
          <a:xfrm>
            <a:off x="2002924" y="8797104"/>
            <a:ext cx="359394" cy="246221"/>
          </a:xfrm>
          <a:prstGeom prst="rect">
            <a:avLst/>
          </a:prstGeom>
          <a:noFill/>
        </p:spPr>
        <p:txBody>
          <a:bodyPr wrap="none" rtlCol="0">
            <a:spAutoFit/>
          </a:bodyPr>
          <a:lstStyle/>
          <a:p>
            <a:r>
              <a:rPr lang="en-US" sz="1000" dirty="0"/>
              <a:t>5.9</a:t>
            </a:r>
          </a:p>
        </p:txBody>
      </p:sp>
      <p:sp>
        <p:nvSpPr>
          <p:cNvPr id="21" name="TextBox 20">
            <a:extLst>
              <a:ext uri="{FF2B5EF4-FFF2-40B4-BE49-F238E27FC236}">
                <a16:creationId xmlns:a16="http://schemas.microsoft.com/office/drawing/2014/main" id="{25824043-C488-F444-2EDF-CDFC8E5F2E2E}"/>
              </a:ext>
            </a:extLst>
          </p:cNvPr>
          <p:cNvSpPr txBox="1"/>
          <p:nvPr/>
        </p:nvSpPr>
        <p:spPr>
          <a:xfrm>
            <a:off x="2510621" y="8797104"/>
            <a:ext cx="359394" cy="246221"/>
          </a:xfrm>
          <a:prstGeom prst="rect">
            <a:avLst/>
          </a:prstGeom>
          <a:noFill/>
        </p:spPr>
        <p:txBody>
          <a:bodyPr wrap="none" rtlCol="0">
            <a:spAutoFit/>
          </a:bodyPr>
          <a:lstStyle/>
          <a:p>
            <a:r>
              <a:rPr lang="en-US" sz="1000" dirty="0"/>
              <a:t>6.1</a:t>
            </a:r>
          </a:p>
        </p:txBody>
      </p:sp>
      <p:sp>
        <p:nvSpPr>
          <p:cNvPr id="22" name="TextBox 21">
            <a:extLst>
              <a:ext uri="{FF2B5EF4-FFF2-40B4-BE49-F238E27FC236}">
                <a16:creationId xmlns:a16="http://schemas.microsoft.com/office/drawing/2014/main" id="{9C92F6D7-A62B-302D-3378-4DC04F3A4E4A}"/>
              </a:ext>
            </a:extLst>
          </p:cNvPr>
          <p:cNvSpPr txBox="1"/>
          <p:nvPr/>
        </p:nvSpPr>
        <p:spPr>
          <a:xfrm>
            <a:off x="3020778" y="8797104"/>
            <a:ext cx="359394" cy="246221"/>
          </a:xfrm>
          <a:prstGeom prst="rect">
            <a:avLst/>
          </a:prstGeom>
          <a:noFill/>
        </p:spPr>
        <p:txBody>
          <a:bodyPr wrap="none" rtlCol="0">
            <a:spAutoFit/>
          </a:bodyPr>
          <a:lstStyle/>
          <a:p>
            <a:r>
              <a:rPr lang="en-US" sz="1000" dirty="0"/>
              <a:t>6.3</a:t>
            </a:r>
          </a:p>
        </p:txBody>
      </p:sp>
      <p:sp>
        <p:nvSpPr>
          <p:cNvPr id="23" name="Rectangle 22">
            <a:extLst>
              <a:ext uri="{FF2B5EF4-FFF2-40B4-BE49-F238E27FC236}">
                <a16:creationId xmlns:a16="http://schemas.microsoft.com/office/drawing/2014/main" id="{76B8971D-809F-9B22-8E20-C7B637848CF0}"/>
              </a:ext>
            </a:extLst>
          </p:cNvPr>
          <p:cNvSpPr/>
          <p:nvPr/>
        </p:nvSpPr>
        <p:spPr>
          <a:xfrm>
            <a:off x="4421524" y="8880430"/>
            <a:ext cx="2745954" cy="20489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a:extLst>
              <a:ext uri="{FF2B5EF4-FFF2-40B4-BE49-F238E27FC236}">
                <a16:creationId xmlns:a16="http://schemas.microsoft.com/office/drawing/2014/main" id="{AC3A98BB-AD6A-FE79-1956-01195F27C969}"/>
              </a:ext>
            </a:extLst>
          </p:cNvPr>
          <p:cNvSpPr txBox="1"/>
          <p:nvPr/>
        </p:nvSpPr>
        <p:spPr>
          <a:xfrm>
            <a:off x="5091533" y="9000939"/>
            <a:ext cx="1324402" cy="246221"/>
          </a:xfrm>
          <a:prstGeom prst="rect">
            <a:avLst/>
          </a:prstGeom>
          <a:noFill/>
        </p:spPr>
        <p:txBody>
          <a:bodyPr wrap="none" rtlCol="0">
            <a:spAutoFit/>
          </a:bodyPr>
          <a:lstStyle/>
          <a:p>
            <a:r>
              <a:rPr lang="en-US" sz="1000" dirty="0"/>
              <a:t>Retention Time (min)</a:t>
            </a:r>
          </a:p>
        </p:txBody>
      </p:sp>
      <p:sp>
        <p:nvSpPr>
          <p:cNvPr id="25" name="TextBox 24">
            <a:extLst>
              <a:ext uri="{FF2B5EF4-FFF2-40B4-BE49-F238E27FC236}">
                <a16:creationId xmlns:a16="http://schemas.microsoft.com/office/drawing/2014/main" id="{8DDDC64A-B184-8DBA-7081-961B56236075}"/>
              </a:ext>
            </a:extLst>
          </p:cNvPr>
          <p:cNvSpPr txBox="1"/>
          <p:nvPr/>
        </p:nvSpPr>
        <p:spPr>
          <a:xfrm>
            <a:off x="4609417" y="8812344"/>
            <a:ext cx="359394" cy="246221"/>
          </a:xfrm>
          <a:prstGeom prst="rect">
            <a:avLst/>
          </a:prstGeom>
          <a:noFill/>
        </p:spPr>
        <p:txBody>
          <a:bodyPr wrap="none" rtlCol="0">
            <a:spAutoFit/>
          </a:bodyPr>
          <a:lstStyle/>
          <a:p>
            <a:r>
              <a:rPr lang="en-US" sz="1000" dirty="0"/>
              <a:t>5.5</a:t>
            </a:r>
          </a:p>
        </p:txBody>
      </p:sp>
      <p:sp>
        <p:nvSpPr>
          <p:cNvPr id="26" name="TextBox 25">
            <a:extLst>
              <a:ext uri="{FF2B5EF4-FFF2-40B4-BE49-F238E27FC236}">
                <a16:creationId xmlns:a16="http://schemas.microsoft.com/office/drawing/2014/main" id="{371D19EE-1274-C98E-F470-99C29AD29DDF}"/>
              </a:ext>
            </a:extLst>
          </p:cNvPr>
          <p:cNvSpPr txBox="1"/>
          <p:nvPr/>
        </p:nvSpPr>
        <p:spPr>
          <a:xfrm>
            <a:off x="5105410" y="8812344"/>
            <a:ext cx="359394" cy="246221"/>
          </a:xfrm>
          <a:prstGeom prst="rect">
            <a:avLst/>
          </a:prstGeom>
          <a:noFill/>
        </p:spPr>
        <p:txBody>
          <a:bodyPr wrap="none" rtlCol="0">
            <a:spAutoFit/>
          </a:bodyPr>
          <a:lstStyle/>
          <a:p>
            <a:r>
              <a:rPr lang="en-US" sz="1000" dirty="0"/>
              <a:t>5.7</a:t>
            </a:r>
          </a:p>
        </p:txBody>
      </p:sp>
      <p:sp>
        <p:nvSpPr>
          <p:cNvPr id="27" name="TextBox 26">
            <a:extLst>
              <a:ext uri="{FF2B5EF4-FFF2-40B4-BE49-F238E27FC236}">
                <a16:creationId xmlns:a16="http://schemas.microsoft.com/office/drawing/2014/main" id="{E5365B10-B19F-EB22-7AF3-F278D3361946}"/>
              </a:ext>
            </a:extLst>
          </p:cNvPr>
          <p:cNvSpPr txBox="1"/>
          <p:nvPr/>
        </p:nvSpPr>
        <p:spPr>
          <a:xfrm>
            <a:off x="5614804" y="8812344"/>
            <a:ext cx="359394" cy="246221"/>
          </a:xfrm>
          <a:prstGeom prst="rect">
            <a:avLst/>
          </a:prstGeom>
          <a:noFill/>
        </p:spPr>
        <p:txBody>
          <a:bodyPr wrap="none" rtlCol="0">
            <a:spAutoFit/>
          </a:bodyPr>
          <a:lstStyle/>
          <a:p>
            <a:r>
              <a:rPr lang="en-US" sz="1000" dirty="0"/>
              <a:t>5.9</a:t>
            </a:r>
          </a:p>
        </p:txBody>
      </p:sp>
      <p:sp>
        <p:nvSpPr>
          <p:cNvPr id="28" name="TextBox 27">
            <a:extLst>
              <a:ext uri="{FF2B5EF4-FFF2-40B4-BE49-F238E27FC236}">
                <a16:creationId xmlns:a16="http://schemas.microsoft.com/office/drawing/2014/main" id="{F160C26A-389B-D034-A5E8-8B13A79F4A17}"/>
              </a:ext>
            </a:extLst>
          </p:cNvPr>
          <p:cNvSpPr txBox="1"/>
          <p:nvPr/>
        </p:nvSpPr>
        <p:spPr>
          <a:xfrm>
            <a:off x="6122501" y="8812344"/>
            <a:ext cx="359394" cy="246221"/>
          </a:xfrm>
          <a:prstGeom prst="rect">
            <a:avLst/>
          </a:prstGeom>
          <a:noFill/>
        </p:spPr>
        <p:txBody>
          <a:bodyPr wrap="none" rtlCol="0">
            <a:spAutoFit/>
          </a:bodyPr>
          <a:lstStyle/>
          <a:p>
            <a:r>
              <a:rPr lang="en-US" sz="1000" dirty="0"/>
              <a:t>6.1</a:t>
            </a:r>
          </a:p>
        </p:txBody>
      </p:sp>
      <p:sp>
        <p:nvSpPr>
          <p:cNvPr id="29" name="TextBox 28">
            <a:extLst>
              <a:ext uri="{FF2B5EF4-FFF2-40B4-BE49-F238E27FC236}">
                <a16:creationId xmlns:a16="http://schemas.microsoft.com/office/drawing/2014/main" id="{1A6EA7AD-F480-7C11-11BB-E91B3626149D}"/>
              </a:ext>
            </a:extLst>
          </p:cNvPr>
          <p:cNvSpPr txBox="1"/>
          <p:nvPr/>
        </p:nvSpPr>
        <p:spPr>
          <a:xfrm>
            <a:off x="6632658" y="8812344"/>
            <a:ext cx="359394" cy="246221"/>
          </a:xfrm>
          <a:prstGeom prst="rect">
            <a:avLst/>
          </a:prstGeom>
          <a:noFill/>
        </p:spPr>
        <p:txBody>
          <a:bodyPr wrap="none" rtlCol="0">
            <a:spAutoFit/>
          </a:bodyPr>
          <a:lstStyle/>
          <a:p>
            <a:r>
              <a:rPr lang="en-US" sz="1000" dirty="0"/>
              <a:t>6.3</a:t>
            </a:r>
          </a:p>
        </p:txBody>
      </p:sp>
      <p:sp>
        <p:nvSpPr>
          <p:cNvPr id="30" name="TextBox 29">
            <a:extLst>
              <a:ext uri="{FF2B5EF4-FFF2-40B4-BE49-F238E27FC236}">
                <a16:creationId xmlns:a16="http://schemas.microsoft.com/office/drawing/2014/main" id="{7E17D839-3216-58AA-F928-C4B4254C2313}"/>
              </a:ext>
            </a:extLst>
          </p:cNvPr>
          <p:cNvSpPr txBox="1"/>
          <p:nvPr/>
        </p:nvSpPr>
        <p:spPr>
          <a:xfrm rot="16200000">
            <a:off x="32086" y="7091087"/>
            <a:ext cx="660758" cy="246221"/>
          </a:xfrm>
          <a:prstGeom prst="rect">
            <a:avLst/>
          </a:prstGeom>
          <a:noFill/>
        </p:spPr>
        <p:txBody>
          <a:bodyPr wrap="none" rtlCol="0">
            <a:spAutoFit/>
          </a:bodyPr>
          <a:lstStyle/>
          <a:p>
            <a:r>
              <a:rPr lang="en-US" sz="1000" dirty="0"/>
              <a:t>Intensity</a:t>
            </a:r>
          </a:p>
        </p:txBody>
      </p:sp>
      <p:sp>
        <p:nvSpPr>
          <p:cNvPr id="31" name="Rectangle 30">
            <a:extLst>
              <a:ext uri="{FF2B5EF4-FFF2-40B4-BE49-F238E27FC236}">
                <a16:creationId xmlns:a16="http://schemas.microsoft.com/office/drawing/2014/main" id="{CBCDD704-3512-11B0-0E89-6B24DE0EF0CB}"/>
              </a:ext>
            </a:extLst>
          </p:cNvPr>
          <p:cNvSpPr/>
          <p:nvPr/>
        </p:nvSpPr>
        <p:spPr>
          <a:xfrm rot="16200000">
            <a:off x="-942325" y="7418771"/>
            <a:ext cx="3311989" cy="31430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TextBox 31">
            <a:extLst>
              <a:ext uri="{FF2B5EF4-FFF2-40B4-BE49-F238E27FC236}">
                <a16:creationId xmlns:a16="http://schemas.microsoft.com/office/drawing/2014/main" id="{5CC48951-609F-0355-F717-D83AA823E981}"/>
              </a:ext>
            </a:extLst>
          </p:cNvPr>
          <p:cNvSpPr txBox="1"/>
          <p:nvPr/>
        </p:nvSpPr>
        <p:spPr>
          <a:xfrm>
            <a:off x="658881" y="8719022"/>
            <a:ext cx="253596" cy="246221"/>
          </a:xfrm>
          <a:prstGeom prst="rect">
            <a:avLst/>
          </a:prstGeom>
          <a:noFill/>
        </p:spPr>
        <p:txBody>
          <a:bodyPr wrap="none" rtlCol="0">
            <a:spAutoFit/>
          </a:bodyPr>
          <a:lstStyle/>
          <a:p>
            <a:r>
              <a:rPr lang="en-US" sz="1000" dirty="0"/>
              <a:t>0</a:t>
            </a:r>
          </a:p>
        </p:txBody>
      </p:sp>
      <p:sp>
        <p:nvSpPr>
          <p:cNvPr id="33" name="TextBox 32">
            <a:extLst>
              <a:ext uri="{FF2B5EF4-FFF2-40B4-BE49-F238E27FC236}">
                <a16:creationId xmlns:a16="http://schemas.microsoft.com/office/drawing/2014/main" id="{3E4AA37B-335F-D581-968E-44EDD695E211}"/>
              </a:ext>
            </a:extLst>
          </p:cNvPr>
          <p:cNvSpPr txBox="1"/>
          <p:nvPr/>
        </p:nvSpPr>
        <p:spPr>
          <a:xfrm>
            <a:off x="556513" y="8399717"/>
            <a:ext cx="391454" cy="246221"/>
          </a:xfrm>
          <a:prstGeom prst="rect">
            <a:avLst/>
          </a:prstGeom>
          <a:noFill/>
        </p:spPr>
        <p:txBody>
          <a:bodyPr wrap="none" rtlCol="0">
            <a:spAutoFit/>
          </a:bodyPr>
          <a:lstStyle/>
          <a:p>
            <a:r>
              <a:rPr lang="en-US" sz="1000" dirty="0"/>
              <a:t>200</a:t>
            </a:r>
          </a:p>
        </p:txBody>
      </p:sp>
      <p:sp>
        <p:nvSpPr>
          <p:cNvPr id="34" name="TextBox 33">
            <a:extLst>
              <a:ext uri="{FF2B5EF4-FFF2-40B4-BE49-F238E27FC236}">
                <a16:creationId xmlns:a16="http://schemas.microsoft.com/office/drawing/2014/main" id="{0B5A5E84-121C-878D-4FBD-01C56E9FB6C5}"/>
              </a:ext>
            </a:extLst>
          </p:cNvPr>
          <p:cNvSpPr txBox="1"/>
          <p:nvPr/>
        </p:nvSpPr>
        <p:spPr>
          <a:xfrm>
            <a:off x="556513" y="8083893"/>
            <a:ext cx="391454" cy="246221"/>
          </a:xfrm>
          <a:prstGeom prst="rect">
            <a:avLst/>
          </a:prstGeom>
          <a:noFill/>
        </p:spPr>
        <p:txBody>
          <a:bodyPr wrap="none" rtlCol="0">
            <a:spAutoFit/>
          </a:bodyPr>
          <a:lstStyle/>
          <a:p>
            <a:r>
              <a:rPr lang="en-US" sz="1000" dirty="0"/>
              <a:t>400</a:t>
            </a:r>
          </a:p>
        </p:txBody>
      </p:sp>
      <p:sp>
        <p:nvSpPr>
          <p:cNvPr id="35" name="TextBox 34">
            <a:extLst>
              <a:ext uri="{FF2B5EF4-FFF2-40B4-BE49-F238E27FC236}">
                <a16:creationId xmlns:a16="http://schemas.microsoft.com/office/drawing/2014/main" id="{2C8DA58C-1FEB-46E6-33BB-0527ECCF1B3B}"/>
              </a:ext>
            </a:extLst>
          </p:cNvPr>
          <p:cNvSpPr txBox="1"/>
          <p:nvPr/>
        </p:nvSpPr>
        <p:spPr>
          <a:xfrm>
            <a:off x="556513" y="7765131"/>
            <a:ext cx="391454" cy="246221"/>
          </a:xfrm>
          <a:prstGeom prst="rect">
            <a:avLst/>
          </a:prstGeom>
          <a:noFill/>
        </p:spPr>
        <p:txBody>
          <a:bodyPr wrap="none" rtlCol="0">
            <a:spAutoFit/>
          </a:bodyPr>
          <a:lstStyle/>
          <a:p>
            <a:r>
              <a:rPr lang="en-US" sz="1000" dirty="0"/>
              <a:t>600</a:t>
            </a:r>
          </a:p>
        </p:txBody>
      </p:sp>
      <p:sp>
        <p:nvSpPr>
          <p:cNvPr id="36" name="TextBox 35">
            <a:extLst>
              <a:ext uri="{FF2B5EF4-FFF2-40B4-BE49-F238E27FC236}">
                <a16:creationId xmlns:a16="http://schemas.microsoft.com/office/drawing/2014/main" id="{9D536413-47A7-40F6-9E6B-3E19BA6C44AC}"/>
              </a:ext>
            </a:extLst>
          </p:cNvPr>
          <p:cNvSpPr txBox="1"/>
          <p:nvPr/>
        </p:nvSpPr>
        <p:spPr>
          <a:xfrm>
            <a:off x="560604" y="7454800"/>
            <a:ext cx="391454" cy="246221"/>
          </a:xfrm>
          <a:prstGeom prst="rect">
            <a:avLst/>
          </a:prstGeom>
          <a:noFill/>
        </p:spPr>
        <p:txBody>
          <a:bodyPr wrap="none" rtlCol="0">
            <a:spAutoFit/>
          </a:bodyPr>
          <a:lstStyle/>
          <a:p>
            <a:r>
              <a:rPr lang="en-US" sz="1000" dirty="0"/>
              <a:t>800</a:t>
            </a:r>
          </a:p>
        </p:txBody>
      </p:sp>
      <p:sp>
        <p:nvSpPr>
          <p:cNvPr id="37" name="TextBox 36">
            <a:extLst>
              <a:ext uri="{FF2B5EF4-FFF2-40B4-BE49-F238E27FC236}">
                <a16:creationId xmlns:a16="http://schemas.microsoft.com/office/drawing/2014/main" id="{C37DC5DE-3C58-D922-17B0-C0D15B906CDC}"/>
              </a:ext>
            </a:extLst>
          </p:cNvPr>
          <p:cNvSpPr txBox="1"/>
          <p:nvPr/>
        </p:nvSpPr>
        <p:spPr>
          <a:xfrm>
            <a:off x="511862" y="7142177"/>
            <a:ext cx="460382" cy="246221"/>
          </a:xfrm>
          <a:prstGeom prst="rect">
            <a:avLst/>
          </a:prstGeom>
          <a:noFill/>
        </p:spPr>
        <p:txBody>
          <a:bodyPr wrap="none" rtlCol="0">
            <a:spAutoFit/>
          </a:bodyPr>
          <a:lstStyle/>
          <a:p>
            <a:r>
              <a:rPr lang="en-US" sz="1000" dirty="0"/>
              <a:t>1000</a:t>
            </a:r>
          </a:p>
        </p:txBody>
      </p:sp>
      <p:sp>
        <p:nvSpPr>
          <p:cNvPr id="38" name="TextBox 37">
            <a:extLst>
              <a:ext uri="{FF2B5EF4-FFF2-40B4-BE49-F238E27FC236}">
                <a16:creationId xmlns:a16="http://schemas.microsoft.com/office/drawing/2014/main" id="{6886DF27-9E5D-B687-792C-872E2ED6CBB9}"/>
              </a:ext>
            </a:extLst>
          </p:cNvPr>
          <p:cNvSpPr txBox="1"/>
          <p:nvPr/>
        </p:nvSpPr>
        <p:spPr>
          <a:xfrm>
            <a:off x="511862" y="6822872"/>
            <a:ext cx="460382" cy="246221"/>
          </a:xfrm>
          <a:prstGeom prst="rect">
            <a:avLst/>
          </a:prstGeom>
          <a:noFill/>
        </p:spPr>
        <p:txBody>
          <a:bodyPr wrap="none" rtlCol="0">
            <a:spAutoFit/>
          </a:bodyPr>
          <a:lstStyle/>
          <a:p>
            <a:r>
              <a:rPr lang="en-US" sz="1000" dirty="0"/>
              <a:t>1200</a:t>
            </a:r>
          </a:p>
        </p:txBody>
      </p:sp>
      <p:sp>
        <p:nvSpPr>
          <p:cNvPr id="39" name="TextBox 38">
            <a:extLst>
              <a:ext uri="{FF2B5EF4-FFF2-40B4-BE49-F238E27FC236}">
                <a16:creationId xmlns:a16="http://schemas.microsoft.com/office/drawing/2014/main" id="{F84C9252-40E9-D4EC-AB78-2510F2ECA93F}"/>
              </a:ext>
            </a:extLst>
          </p:cNvPr>
          <p:cNvSpPr txBox="1"/>
          <p:nvPr/>
        </p:nvSpPr>
        <p:spPr>
          <a:xfrm>
            <a:off x="511862" y="6510472"/>
            <a:ext cx="460382" cy="246221"/>
          </a:xfrm>
          <a:prstGeom prst="rect">
            <a:avLst/>
          </a:prstGeom>
          <a:noFill/>
        </p:spPr>
        <p:txBody>
          <a:bodyPr wrap="none" rtlCol="0">
            <a:spAutoFit/>
          </a:bodyPr>
          <a:lstStyle/>
          <a:p>
            <a:r>
              <a:rPr lang="en-US" sz="1000" dirty="0"/>
              <a:t>1400</a:t>
            </a:r>
          </a:p>
        </p:txBody>
      </p:sp>
      <p:sp>
        <p:nvSpPr>
          <p:cNvPr id="40" name="TextBox 39">
            <a:extLst>
              <a:ext uri="{FF2B5EF4-FFF2-40B4-BE49-F238E27FC236}">
                <a16:creationId xmlns:a16="http://schemas.microsoft.com/office/drawing/2014/main" id="{1CC3B4FC-150B-AE9F-36A2-D6E4F07380C8}"/>
              </a:ext>
            </a:extLst>
          </p:cNvPr>
          <p:cNvSpPr txBox="1"/>
          <p:nvPr/>
        </p:nvSpPr>
        <p:spPr>
          <a:xfrm>
            <a:off x="511862" y="6197791"/>
            <a:ext cx="460382" cy="246221"/>
          </a:xfrm>
          <a:prstGeom prst="rect">
            <a:avLst/>
          </a:prstGeom>
          <a:noFill/>
        </p:spPr>
        <p:txBody>
          <a:bodyPr wrap="none" rtlCol="0">
            <a:spAutoFit/>
          </a:bodyPr>
          <a:lstStyle/>
          <a:p>
            <a:r>
              <a:rPr lang="en-US" sz="1000" dirty="0"/>
              <a:t>1600</a:t>
            </a:r>
          </a:p>
        </p:txBody>
      </p:sp>
      <p:sp>
        <p:nvSpPr>
          <p:cNvPr id="41" name="TextBox 40">
            <a:extLst>
              <a:ext uri="{FF2B5EF4-FFF2-40B4-BE49-F238E27FC236}">
                <a16:creationId xmlns:a16="http://schemas.microsoft.com/office/drawing/2014/main" id="{B6ECD60F-9FB1-334A-26ED-85E4D42FDEEA}"/>
              </a:ext>
            </a:extLst>
          </p:cNvPr>
          <p:cNvSpPr txBox="1"/>
          <p:nvPr/>
        </p:nvSpPr>
        <p:spPr>
          <a:xfrm>
            <a:off x="515623" y="5869511"/>
            <a:ext cx="460382" cy="246221"/>
          </a:xfrm>
          <a:prstGeom prst="rect">
            <a:avLst/>
          </a:prstGeom>
          <a:noFill/>
        </p:spPr>
        <p:txBody>
          <a:bodyPr wrap="none" rtlCol="0">
            <a:spAutoFit/>
          </a:bodyPr>
          <a:lstStyle/>
          <a:p>
            <a:r>
              <a:rPr lang="en-US" sz="1000" dirty="0"/>
              <a:t>1800</a:t>
            </a:r>
          </a:p>
        </p:txBody>
      </p:sp>
      <p:sp>
        <p:nvSpPr>
          <p:cNvPr id="42" name="Rectangle 41">
            <a:extLst>
              <a:ext uri="{FF2B5EF4-FFF2-40B4-BE49-F238E27FC236}">
                <a16:creationId xmlns:a16="http://schemas.microsoft.com/office/drawing/2014/main" id="{C6182264-ACA9-9FE7-E092-96E3038FFA4B}"/>
              </a:ext>
            </a:extLst>
          </p:cNvPr>
          <p:cNvSpPr/>
          <p:nvPr/>
        </p:nvSpPr>
        <p:spPr>
          <a:xfrm rot="16200000">
            <a:off x="2683995" y="7434011"/>
            <a:ext cx="3311989" cy="31430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TextBox 42">
            <a:extLst>
              <a:ext uri="{FF2B5EF4-FFF2-40B4-BE49-F238E27FC236}">
                <a16:creationId xmlns:a16="http://schemas.microsoft.com/office/drawing/2014/main" id="{67AA7E1B-DD5F-3D1F-4986-5BB01A9DCCB6}"/>
              </a:ext>
            </a:extLst>
          </p:cNvPr>
          <p:cNvSpPr txBox="1"/>
          <p:nvPr/>
        </p:nvSpPr>
        <p:spPr>
          <a:xfrm>
            <a:off x="4278449" y="8727445"/>
            <a:ext cx="253596" cy="246221"/>
          </a:xfrm>
          <a:prstGeom prst="rect">
            <a:avLst/>
          </a:prstGeom>
          <a:noFill/>
        </p:spPr>
        <p:txBody>
          <a:bodyPr wrap="none" rtlCol="0">
            <a:spAutoFit/>
          </a:bodyPr>
          <a:lstStyle/>
          <a:p>
            <a:r>
              <a:rPr lang="en-US" sz="1000" dirty="0"/>
              <a:t>0</a:t>
            </a:r>
          </a:p>
        </p:txBody>
      </p:sp>
      <p:sp>
        <p:nvSpPr>
          <p:cNvPr id="44" name="TextBox 43">
            <a:extLst>
              <a:ext uri="{FF2B5EF4-FFF2-40B4-BE49-F238E27FC236}">
                <a16:creationId xmlns:a16="http://schemas.microsoft.com/office/drawing/2014/main" id="{BB9F9508-D1C0-228A-6900-3A62E9B34746}"/>
              </a:ext>
            </a:extLst>
          </p:cNvPr>
          <p:cNvSpPr txBox="1"/>
          <p:nvPr/>
        </p:nvSpPr>
        <p:spPr>
          <a:xfrm>
            <a:off x="4179019" y="8238864"/>
            <a:ext cx="391454" cy="246221"/>
          </a:xfrm>
          <a:prstGeom prst="rect">
            <a:avLst/>
          </a:prstGeom>
          <a:noFill/>
        </p:spPr>
        <p:txBody>
          <a:bodyPr wrap="none" rtlCol="0">
            <a:spAutoFit/>
          </a:bodyPr>
          <a:lstStyle/>
          <a:p>
            <a:r>
              <a:rPr lang="en-US" sz="1000" dirty="0"/>
              <a:t>500</a:t>
            </a:r>
          </a:p>
        </p:txBody>
      </p:sp>
      <p:sp>
        <p:nvSpPr>
          <p:cNvPr id="45" name="TextBox 44">
            <a:extLst>
              <a:ext uri="{FF2B5EF4-FFF2-40B4-BE49-F238E27FC236}">
                <a16:creationId xmlns:a16="http://schemas.microsoft.com/office/drawing/2014/main" id="{9FB3F477-B8B5-4862-0969-6D60FD77BD35}"/>
              </a:ext>
            </a:extLst>
          </p:cNvPr>
          <p:cNvSpPr txBox="1"/>
          <p:nvPr/>
        </p:nvSpPr>
        <p:spPr>
          <a:xfrm>
            <a:off x="4118721" y="7765131"/>
            <a:ext cx="460382" cy="246221"/>
          </a:xfrm>
          <a:prstGeom prst="rect">
            <a:avLst/>
          </a:prstGeom>
          <a:noFill/>
        </p:spPr>
        <p:txBody>
          <a:bodyPr wrap="none" rtlCol="0">
            <a:spAutoFit/>
          </a:bodyPr>
          <a:lstStyle/>
          <a:p>
            <a:r>
              <a:rPr lang="en-US" sz="1000" dirty="0"/>
              <a:t>1000</a:t>
            </a:r>
          </a:p>
        </p:txBody>
      </p:sp>
      <p:sp>
        <p:nvSpPr>
          <p:cNvPr id="46" name="TextBox 45">
            <a:extLst>
              <a:ext uri="{FF2B5EF4-FFF2-40B4-BE49-F238E27FC236}">
                <a16:creationId xmlns:a16="http://schemas.microsoft.com/office/drawing/2014/main" id="{17DA22EE-2898-393E-6A96-54F92CAE588B}"/>
              </a:ext>
            </a:extLst>
          </p:cNvPr>
          <p:cNvSpPr txBox="1"/>
          <p:nvPr/>
        </p:nvSpPr>
        <p:spPr>
          <a:xfrm>
            <a:off x="4118721" y="7300674"/>
            <a:ext cx="460382" cy="246221"/>
          </a:xfrm>
          <a:prstGeom prst="rect">
            <a:avLst/>
          </a:prstGeom>
          <a:noFill/>
        </p:spPr>
        <p:txBody>
          <a:bodyPr wrap="none" rtlCol="0">
            <a:spAutoFit/>
          </a:bodyPr>
          <a:lstStyle/>
          <a:p>
            <a:r>
              <a:rPr lang="en-US" sz="1000" dirty="0"/>
              <a:t>1500</a:t>
            </a:r>
          </a:p>
        </p:txBody>
      </p:sp>
      <p:sp>
        <p:nvSpPr>
          <p:cNvPr id="47" name="TextBox 46">
            <a:extLst>
              <a:ext uri="{FF2B5EF4-FFF2-40B4-BE49-F238E27FC236}">
                <a16:creationId xmlns:a16="http://schemas.microsoft.com/office/drawing/2014/main" id="{95E1A0AF-2B01-DB92-2743-EB8744AA60C5}"/>
              </a:ext>
            </a:extLst>
          </p:cNvPr>
          <p:cNvSpPr txBox="1"/>
          <p:nvPr/>
        </p:nvSpPr>
        <p:spPr>
          <a:xfrm>
            <a:off x="4118721" y="6830969"/>
            <a:ext cx="460382" cy="246221"/>
          </a:xfrm>
          <a:prstGeom prst="rect">
            <a:avLst/>
          </a:prstGeom>
          <a:noFill/>
        </p:spPr>
        <p:txBody>
          <a:bodyPr wrap="none" rtlCol="0">
            <a:spAutoFit/>
          </a:bodyPr>
          <a:lstStyle/>
          <a:p>
            <a:r>
              <a:rPr lang="en-US" sz="1000" dirty="0"/>
              <a:t>2000</a:t>
            </a:r>
          </a:p>
        </p:txBody>
      </p:sp>
      <p:sp>
        <p:nvSpPr>
          <p:cNvPr id="48" name="TextBox 47">
            <a:extLst>
              <a:ext uri="{FF2B5EF4-FFF2-40B4-BE49-F238E27FC236}">
                <a16:creationId xmlns:a16="http://schemas.microsoft.com/office/drawing/2014/main" id="{06FF1907-F78C-29A8-EFF8-B366E4EA7805}"/>
              </a:ext>
            </a:extLst>
          </p:cNvPr>
          <p:cNvSpPr txBox="1"/>
          <p:nvPr/>
        </p:nvSpPr>
        <p:spPr>
          <a:xfrm>
            <a:off x="4126350" y="6353520"/>
            <a:ext cx="460382" cy="246221"/>
          </a:xfrm>
          <a:prstGeom prst="rect">
            <a:avLst/>
          </a:prstGeom>
          <a:noFill/>
        </p:spPr>
        <p:txBody>
          <a:bodyPr wrap="none" rtlCol="0">
            <a:spAutoFit/>
          </a:bodyPr>
          <a:lstStyle/>
          <a:p>
            <a:r>
              <a:rPr lang="en-US" sz="1000" dirty="0"/>
              <a:t>2500</a:t>
            </a:r>
          </a:p>
        </p:txBody>
      </p:sp>
      <p:sp>
        <p:nvSpPr>
          <p:cNvPr id="49" name="TextBox 48">
            <a:extLst>
              <a:ext uri="{FF2B5EF4-FFF2-40B4-BE49-F238E27FC236}">
                <a16:creationId xmlns:a16="http://schemas.microsoft.com/office/drawing/2014/main" id="{C281BE37-5B8C-3843-F9B1-F0A7ACD60698}"/>
              </a:ext>
            </a:extLst>
          </p:cNvPr>
          <p:cNvSpPr txBox="1"/>
          <p:nvPr/>
        </p:nvSpPr>
        <p:spPr>
          <a:xfrm>
            <a:off x="4118721" y="5879766"/>
            <a:ext cx="460382" cy="246221"/>
          </a:xfrm>
          <a:prstGeom prst="rect">
            <a:avLst/>
          </a:prstGeom>
          <a:noFill/>
        </p:spPr>
        <p:txBody>
          <a:bodyPr wrap="none" rtlCol="0">
            <a:spAutoFit/>
          </a:bodyPr>
          <a:lstStyle/>
          <a:p>
            <a:r>
              <a:rPr lang="en-US" sz="1000" dirty="0"/>
              <a:t>3000</a:t>
            </a:r>
          </a:p>
        </p:txBody>
      </p:sp>
      <p:sp>
        <p:nvSpPr>
          <p:cNvPr id="50" name="TextBox 49">
            <a:extLst>
              <a:ext uri="{FF2B5EF4-FFF2-40B4-BE49-F238E27FC236}">
                <a16:creationId xmlns:a16="http://schemas.microsoft.com/office/drawing/2014/main" id="{38AD9FFB-DC61-09B8-B182-5550C0F08BBD}"/>
              </a:ext>
            </a:extLst>
          </p:cNvPr>
          <p:cNvSpPr txBox="1"/>
          <p:nvPr/>
        </p:nvSpPr>
        <p:spPr>
          <a:xfrm rot="16200000">
            <a:off x="3694445" y="7091088"/>
            <a:ext cx="660758" cy="246221"/>
          </a:xfrm>
          <a:prstGeom prst="rect">
            <a:avLst/>
          </a:prstGeom>
          <a:noFill/>
        </p:spPr>
        <p:txBody>
          <a:bodyPr wrap="none" rtlCol="0">
            <a:spAutoFit/>
          </a:bodyPr>
          <a:lstStyle/>
          <a:p>
            <a:r>
              <a:rPr lang="en-US" sz="1000" dirty="0"/>
              <a:t>Intensity</a:t>
            </a:r>
          </a:p>
        </p:txBody>
      </p:sp>
      <p:sp>
        <p:nvSpPr>
          <p:cNvPr id="51" name="TextBox 50">
            <a:extLst>
              <a:ext uri="{FF2B5EF4-FFF2-40B4-BE49-F238E27FC236}">
                <a16:creationId xmlns:a16="http://schemas.microsoft.com/office/drawing/2014/main" id="{B4F956EC-92E9-EBB1-04BF-C1112D014113}"/>
              </a:ext>
            </a:extLst>
          </p:cNvPr>
          <p:cNvSpPr txBox="1"/>
          <p:nvPr/>
        </p:nvSpPr>
        <p:spPr>
          <a:xfrm>
            <a:off x="187734" y="5496616"/>
            <a:ext cx="324128" cy="369332"/>
          </a:xfrm>
          <a:prstGeom prst="rect">
            <a:avLst/>
          </a:prstGeom>
          <a:noFill/>
        </p:spPr>
        <p:txBody>
          <a:bodyPr wrap="none" rtlCol="0">
            <a:spAutoFit/>
          </a:bodyPr>
          <a:lstStyle/>
          <a:p>
            <a:r>
              <a:rPr lang="en-US" dirty="0"/>
              <a:t>A</a:t>
            </a:r>
          </a:p>
        </p:txBody>
      </p:sp>
      <p:sp>
        <p:nvSpPr>
          <p:cNvPr id="52" name="TextBox 51">
            <a:extLst>
              <a:ext uri="{FF2B5EF4-FFF2-40B4-BE49-F238E27FC236}">
                <a16:creationId xmlns:a16="http://schemas.microsoft.com/office/drawing/2014/main" id="{2E55F72E-53F1-D20B-C3BE-45C5CB7DD733}"/>
              </a:ext>
            </a:extLst>
          </p:cNvPr>
          <p:cNvSpPr txBox="1"/>
          <p:nvPr/>
        </p:nvSpPr>
        <p:spPr>
          <a:xfrm>
            <a:off x="60392" y="9599157"/>
            <a:ext cx="7441461" cy="954107"/>
          </a:xfrm>
          <a:prstGeom prst="rect">
            <a:avLst/>
          </a:prstGeom>
          <a:noFill/>
        </p:spPr>
        <p:txBody>
          <a:bodyPr wrap="square" rtlCol="0">
            <a:spAutoFit/>
          </a:bodyPr>
          <a:lstStyle/>
          <a:p>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Figure S1</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Optimizing chromatographic and MS conditions to facilitate at scale metabolite measurements: (</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Number of SRM transitions per measurement cycle as a function of LC-MS run time; (</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B</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Representative metabolite (U-</a:t>
            </a:r>
            <a:r>
              <a:rPr lang="en-US" sz="1400" baseline="300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13</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C Guanosine) demonstrating how dwell time prioritization improves signal quality for low abundant metabolites. </a:t>
            </a:r>
          </a:p>
        </p:txBody>
      </p:sp>
    </p:spTree>
    <p:extLst>
      <p:ext uri="{BB962C8B-B14F-4D97-AF65-F5344CB8AC3E}">
        <p14:creationId xmlns:p14="http://schemas.microsoft.com/office/powerpoint/2010/main" val="15138365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descr="A graph with numbers and text&#10;&#10;Description automatically generated with medium confidence">
            <a:extLst>
              <a:ext uri="{FF2B5EF4-FFF2-40B4-BE49-F238E27FC236}">
                <a16:creationId xmlns:a16="http://schemas.microsoft.com/office/drawing/2014/main" id="{142CDCD9-D0A9-112D-C97D-EB4BF9253DF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885678" y="5617423"/>
            <a:ext cx="3536462" cy="3536462"/>
          </a:xfrm>
          <a:prstGeom prst="rect">
            <a:avLst/>
          </a:prstGeom>
        </p:spPr>
      </p:pic>
      <p:sp>
        <p:nvSpPr>
          <p:cNvPr id="3" name="TextBox 2">
            <a:extLst>
              <a:ext uri="{FF2B5EF4-FFF2-40B4-BE49-F238E27FC236}">
                <a16:creationId xmlns:a16="http://schemas.microsoft.com/office/drawing/2014/main" id="{D639D69B-7D89-A401-C1B1-DCE326262DCF}"/>
              </a:ext>
            </a:extLst>
          </p:cNvPr>
          <p:cNvSpPr txBox="1"/>
          <p:nvPr/>
        </p:nvSpPr>
        <p:spPr>
          <a:xfrm>
            <a:off x="262122" y="126667"/>
            <a:ext cx="574196" cy="369332"/>
          </a:xfrm>
          <a:prstGeom prst="rect">
            <a:avLst/>
          </a:prstGeom>
          <a:noFill/>
        </p:spPr>
        <p:txBody>
          <a:bodyPr wrap="none" rtlCol="0">
            <a:spAutoFit/>
          </a:bodyPr>
          <a:lstStyle/>
          <a:p>
            <a:r>
              <a:rPr lang="en-US" dirty="0"/>
              <a:t>S2A</a:t>
            </a:r>
          </a:p>
        </p:txBody>
      </p:sp>
      <p:sp>
        <p:nvSpPr>
          <p:cNvPr id="4" name="TextBox 3">
            <a:extLst>
              <a:ext uri="{FF2B5EF4-FFF2-40B4-BE49-F238E27FC236}">
                <a16:creationId xmlns:a16="http://schemas.microsoft.com/office/drawing/2014/main" id="{70778960-9A41-7EA9-E3B6-3F271E2FA499}"/>
              </a:ext>
            </a:extLst>
          </p:cNvPr>
          <p:cNvSpPr txBox="1"/>
          <p:nvPr/>
        </p:nvSpPr>
        <p:spPr>
          <a:xfrm>
            <a:off x="158951" y="5338699"/>
            <a:ext cx="577402" cy="369332"/>
          </a:xfrm>
          <a:prstGeom prst="rect">
            <a:avLst/>
          </a:prstGeom>
          <a:noFill/>
        </p:spPr>
        <p:txBody>
          <a:bodyPr wrap="none" rtlCol="0">
            <a:spAutoFit/>
          </a:bodyPr>
          <a:lstStyle/>
          <a:p>
            <a:r>
              <a:rPr lang="en-US" dirty="0"/>
              <a:t>S2B</a:t>
            </a:r>
          </a:p>
        </p:txBody>
      </p:sp>
      <p:graphicFrame>
        <p:nvGraphicFramePr>
          <p:cNvPr id="5" name="Chart 4">
            <a:extLst>
              <a:ext uri="{FF2B5EF4-FFF2-40B4-BE49-F238E27FC236}">
                <a16:creationId xmlns:a16="http://schemas.microsoft.com/office/drawing/2014/main" id="{B7ADEA06-DD7E-452F-7E41-D9D7DD81C511}"/>
              </a:ext>
            </a:extLst>
          </p:cNvPr>
          <p:cNvGraphicFramePr>
            <a:graphicFrameLocks/>
          </p:cNvGraphicFramePr>
          <p:nvPr>
            <p:extLst>
              <p:ext uri="{D42A27DB-BD31-4B8C-83A1-F6EECF244321}">
                <p14:modId xmlns:p14="http://schemas.microsoft.com/office/powerpoint/2010/main" val="1262526170"/>
              </p:ext>
            </p:extLst>
          </p:nvPr>
        </p:nvGraphicFramePr>
        <p:xfrm>
          <a:off x="814821" y="7370328"/>
          <a:ext cx="1387961" cy="130436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6708EA20-EE9C-0519-F8FC-5CA6DC0698D3}"/>
              </a:ext>
            </a:extLst>
          </p:cNvPr>
          <p:cNvGraphicFramePr>
            <a:graphicFrameLocks/>
          </p:cNvGraphicFramePr>
          <p:nvPr>
            <p:extLst>
              <p:ext uri="{D42A27DB-BD31-4B8C-83A1-F6EECF244321}">
                <p14:modId xmlns:p14="http://schemas.microsoft.com/office/powerpoint/2010/main" val="3689645436"/>
              </p:ext>
            </p:extLst>
          </p:nvPr>
        </p:nvGraphicFramePr>
        <p:xfrm>
          <a:off x="555966" y="5924954"/>
          <a:ext cx="1646815" cy="1373797"/>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a:extLst>
              <a:ext uri="{FF2B5EF4-FFF2-40B4-BE49-F238E27FC236}">
                <a16:creationId xmlns:a16="http://schemas.microsoft.com/office/drawing/2014/main" id="{56025FF9-58BC-DE9C-2FBE-FDD2CBE37FB1}"/>
              </a:ext>
            </a:extLst>
          </p:cNvPr>
          <p:cNvSpPr txBox="1"/>
          <p:nvPr/>
        </p:nvSpPr>
        <p:spPr>
          <a:xfrm>
            <a:off x="1126077" y="5708031"/>
            <a:ext cx="978152" cy="307777"/>
          </a:xfrm>
          <a:prstGeom prst="rect">
            <a:avLst/>
          </a:prstGeom>
          <a:noFill/>
        </p:spPr>
        <p:txBody>
          <a:bodyPr wrap="square" rtlCol="0">
            <a:spAutoFit/>
          </a:bodyPr>
          <a:lstStyle/>
          <a:p>
            <a:r>
              <a:rPr lang="en-US" sz="1400" dirty="0"/>
              <a:t>Adenine</a:t>
            </a:r>
          </a:p>
        </p:txBody>
      </p:sp>
      <p:graphicFrame>
        <p:nvGraphicFramePr>
          <p:cNvPr id="8" name="Chart 7">
            <a:extLst>
              <a:ext uri="{FF2B5EF4-FFF2-40B4-BE49-F238E27FC236}">
                <a16:creationId xmlns:a16="http://schemas.microsoft.com/office/drawing/2014/main" id="{D55106A4-5565-2ECA-A9D0-D348A3DB1912}"/>
              </a:ext>
            </a:extLst>
          </p:cNvPr>
          <p:cNvGraphicFramePr>
            <a:graphicFrameLocks/>
          </p:cNvGraphicFramePr>
          <p:nvPr>
            <p:extLst>
              <p:ext uri="{D42A27DB-BD31-4B8C-83A1-F6EECF244321}">
                <p14:modId xmlns:p14="http://schemas.microsoft.com/office/powerpoint/2010/main" val="949427838"/>
              </p:ext>
            </p:extLst>
          </p:nvPr>
        </p:nvGraphicFramePr>
        <p:xfrm>
          <a:off x="2128874" y="7365942"/>
          <a:ext cx="1451278" cy="1304366"/>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9" name="Chart 8">
            <a:extLst>
              <a:ext uri="{FF2B5EF4-FFF2-40B4-BE49-F238E27FC236}">
                <a16:creationId xmlns:a16="http://schemas.microsoft.com/office/drawing/2014/main" id="{BCEE585D-B964-A4E1-A649-DB347AD4B9FE}"/>
              </a:ext>
            </a:extLst>
          </p:cNvPr>
          <p:cNvGraphicFramePr>
            <a:graphicFrameLocks/>
          </p:cNvGraphicFramePr>
          <p:nvPr>
            <p:extLst>
              <p:ext uri="{D42A27DB-BD31-4B8C-83A1-F6EECF244321}">
                <p14:modId xmlns:p14="http://schemas.microsoft.com/office/powerpoint/2010/main" val="3576675499"/>
              </p:ext>
            </p:extLst>
          </p:nvPr>
        </p:nvGraphicFramePr>
        <p:xfrm>
          <a:off x="1878898" y="5912340"/>
          <a:ext cx="1701254" cy="1373797"/>
        </p:xfrm>
        <a:graphic>
          <a:graphicData uri="http://schemas.openxmlformats.org/drawingml/2006/chart">
            <c:chart xmlns:c="http://schemas.openxmlformats.org/drawingml/2006/chart" xmlns:r="http://schemas.openxmlformats.org/officeDocument/2006/relationships" r:id="rId6"/>
          </a:graphicData>
        </a:graphic>
      </p:graphicFrame>
      <p:sp>
        <p:nvSpPr>
          <p:cNvPr id="10" name="TextBox 9">
            <a:extLst>
              <a:ext uri="{FF2B5EF4-FFF2-40B4-BE49-F238E27FC236}">
                <a16:creationId xmlns:a16="http://schemas.microsoft.com/office/drawing/2014/main" id="{845389DF-4A9C-3AE6-6F89-6232D8BE35DD}"/>
              </a:ext>
            </a:extLst>
          </p:cNvPr>
          <p:cNvSpPr txBox="1"/>
          <p:nvPr/>
        </p:nvSpPr>
        <p:spPr>
          <a:xfrm>
            <a:off x="2587232" y="5708031"/>
            <a:ext cx="978152" cy="307777"/>
          </a:xfrm>
          <a:prstGeom prst="rect">
            <a:avLst/>
          </a:prstGeom>
          <a:noFill/>
        </p:spPr>
        <p:txBody>
          <a:bodyPr wrap="square" rtlCol="0">
            <a:spAutoFit/>
          </a:bodyPr>
          <a:lstStyle/>
          <a:p>
            <a:r>
              <a:rPr lang="en-US" sz="1400" dirty="0" err="1"/>
              <a:t>Arabitol</a:t>
            </a:r>
            <a:endParaRPr lang="en-US" sz="1400" dirty="0"/>
          </a:p>
        </p:txBody>
      </p:sp>
      <p:sp>
        <p:nvSpPr>
          <p:cNvPr id="11" name="TextBox 10">
            <a:extLst>
              <a:ext uri="{FF2B5EF4-FFF2-40B4-BE49-F238E27FC236}">
                <a16:creationId xmlns:a16="http://schemas.microsoft.com/office/drawing/2014/main" id="{2798851D-ADF4-E294-E38B-F63E1095A837}"/>
              </a:ext>
            </a:extLst>
          </p:cNvPr>
          <p:cNvSpPr txBox="1"/>
          <p:nvPr/>
        </p:nvSpPr>
        <p:spPr>
          <a:xfrm>
            <a:off x="146429" y="8679080"/>
            <a:ext cx="3874779" cy="400110"/>
          </a:xfrm>
          <a:prstGeom prst="rect">
            <a:avLst/>
          </a:prstGeom>
          <a:noFill/>
        </p:spPr>
        <p:txBody>
          <a:bodyPr wrap="none" rtlCol="0">
            <a:spAutoFit/>
          </a:bodyPr>
          <a:lstStyle/>
          <a:p>
            <a:pPr algn="ctr"/>
            <a:r>
              <a:rPr lang="en-US" sz="1000" dirty="0"/>
              <a:t>Fold change in urine sample concentration, relative to pooled urine</a:t>
            </a:r>
          </a:p>
          <a:p>
            <a:pPr algn="ctr"/>
            <a:r>
              <a:rPr lang="en-US" sz="1000" dirty="0"/>
              <a:t>(Specific Gravity range: 1.0018 – 1.0382)</a:t>
            </a:r>
          </a:p>
        </p:txBody>
      </p:sp>
      <p:sp>
        <p:nvSpPr>
          <p:cNvPr id="12" name="TextBox 11">
            <a:extLst>
              <a:ext uri="{FF2B5EF4-FFF2-40B4-BE49-F238E27FC236}">
                <a16:creationId xmlns:a16="http://schemas.microsoft.com/office/drawing/2014/main" id="{946C90A9-EB83-090B-9F03-BF3FB2122CD7}"/>
              </a:ext>
            </a:extLst>
          </p:cNvPr>
          <p:cNvSpPr txBox="1"/>
          <p:nvPr/>
        </p:nvSpPr>
        <p:spPr>
          <a:xfrm rot="16200000">
            <a:off x="-169555" y="6261247"/>
            <a:ext cx="1155188" cy="523220"/>
          </a:xfrm>
          <a:prstGeom prst="rect">
            <a:avLst/>
          </a:prstGeom>
          <a:noFill/>
        </p:spPr>
        <p:txBody>
          <a:bodyPr wrap="none" rtlCol="0">
            <a:spAutoFit/>
          </a:bodyPr>
          <a:lstStyle/>
          <a:p>
            <a:r>
              <a:rPr lang="en-US" sz="1400" dirty="0"/>
              <a:t>Absolute MS</a:t>
            </a:r>
          </a:p>
          <a:p>
            <a:pPr algn="ctr"/>
            <a:r>
              <a:rPr lang="en-US" sz="1400" dirty="0"/>
              <a:t>Intensity</a:t>
            </a:r>
            <a:endParaRPr lang="en-US" dirty="0"/>
          </a:p>
        </p:txBody>
      </p:sp>
      <p:sp>
        <p:nvSpPr>
          <p:cNvPr id="13" name="TextBox 12">
            <a:extLst>
              <a:ext uri="{FF2B5EF4-FFF2-40B4-BE49-F238E27FC236}">
                <a16:creationId xmlns:a16="http://schemas.microsoft.com/office/drawing/2014/main" id="{13BF9BEC-1C17-64BD-A91B-B0E567DAC2D1}"/>
              </a:ext>
            </a:extLst>
          </p:cNvPr>
          <p:cNvSpPr txBox="1"/>
          <p:nvPr/>
        </p:nvSpPr>
        <p:spPr>
          <a:xfrm rot="16200000">
            <a:off x="-81186" y="7778249"/>
            <a:ext cx="967060" cy="307777"/>
          </a:xfrm>
          <a:prstGeom prst="rect">
            <a:avLst/>
          </a:prstGeom>
          <a:noFill/>
        </p:spPr>
        <p:txBody>
          <a:bodyPr wrap="none" rtlCol="0">
            <a:spAutoFit/>
          </a:bodyPr>
          <a:lstStyle/>
          <a:p>
            <a:r>
              <a:rPr lang="en-US" sz="1400" dirty="0"/>
              <a:t>Ratio to IS</a:t>
            </a:r>
            <a:endParaRPr lang="en-US" dirty="0"/>
          </a:p>
        </p:txBody>
      </p:sp>
      <p:sp>
        <p:nvSpPr>
          <p:cNvPr id="14" name="TextBox 13">
            <a:extLst>
              <a:ext uri="{FF2B5EF4-FFF2-40B4-BE49-F238E27FC236}">
                <a16:creationId xmlns:a16="http://schemas.microsoft.com/office/drawing/2014/main" id="{B696EEB4-AE4E-F5F7-3285-54B7135A6835}"/>
              </a:ext>
            </a:extLst>
          </p:cNvPr>
          <p:cNvSpPr txBox="1"/>
          <p:nvPr/>
        </p:nvSpPr>
        <p:spPr>
          <a:xfrm>
            <a:off x="3931911" y="5338699"/>
            <a:ext cx="598241" cy="369332"/>
          </a:xfrm>
          <a:prstGeom prst="rect">
            <a:avLst/>
          </a:prstGeom>
          <a:noFill/>
        </p:spPr>
        <p:txBody>
          <a:bodyPr wrap="none" rtlCol="0">
            <a:spAutoFit/>
          </a:bodyPr>
          <a:lstStyle/>
          <a:p>
            <a:r>
              <a:rPr lang="en-US" dirty="0"/>
              <a:t>S2C</a:t>
            </a:r>
          </a:p>
        </p:txBody>
      </p:sp>
      <p:graphicFrame>
        <p:nvGraphicFramePr>
          <p:cNvPr id="15" name="Chart 14">
            <a:extLst>
              <a:ext uri="{FF2B5EF4-FFF2-40B4-BE49-F238E27FC236}">
                <a16:creationId xmlns:a16="http://schemas.microsoft.com/office/drawing/2014/main" id="{C521C839-9306-4228-E40F-96A3DFA5CF5F}"/>
              </a:ext>
            </a:extLst>
          </p:cNvPr>
          <p:cNvGraphicFramePr>
            <a:graphicFrameLocks/>
          </p:cNvGraphicFramePr>
          <p:nvPr>
            <p:extLst>
              <p:ext uri="{D42A27DB-BD31-4B8C-83A1-F6EECF244321}">
                <p14:modId xmlns:p14="http://schemas.microsoft.com/office/powerpoint/2010/main" val="4292213172"/>
              </p:ext>
            </p:extLst>
          </p:nvPr>
        </p:nvGraphicFramePr>
        <p:xfrm>
          <a:off x="23612" y="695983"/>
          <a:ext cx="7234822" cy="4543077"/>
        </p:xfrm>
        <a:graphic>
          <a:graphicData uri="http://schemas.openxmlformats.org/drawingml/2006/chart">
            <c:chart xmlns:c="http://schemas.openxmlformats.org/drawingml/2006/chart" xmlns:r="http://schemas.openxmlformats.org/officeDocument/2006/relationships" r:id="rId7"/>
          </a:graphicData>
        </a:graphic>
      </p:graphicFrame>
      <p:sp>
        <p:nvSpPr>
          <p:cNvPr id="17" name="TextBox 16">
            <a:extLst>
              <a:ext uri="{FF2B5EF4-FFF2-40B4-BE49-F238E27FC236}">
                <a16:creationId xmlns:a16="http://schemas.microsoft.com/office/drawing/2014/main" id="{ED079F89-A266-351F-A718-A7EBA4D908BC}"/>
              </a:ext>
            </a:extLst>
          </p:cNvPr>
          <p:cNvSpPr txBox="1"/>
          <p:nvPr/>
        </p:nvSpPr>
        <p:spPr>
          <a:xfrm>
            <a:off x="836318" y="346014"/>
            <a:ext cx="6098721" cy="369332"/>
          </a:xfrm>
          <a:prstGeom prst="rect">
            <a:avLst/>
          </a:prstGeom>
          <a:noFill/>
        </p:spPr>
        <p:txBody>
          <a:bodyPr wrap="none" rtlCol="0">
            <a:spAutoFit/>
          </a:bodyPr>
          <a:lstStyle/>
          <a:p>
            <a:r>
              <a:rPr lang="en-US" dirty="0"/>
              <a:t>U-</a:t>
            </a:r>
            <a:r>
              <a:rPr lang="en-US" baseline="30000" dirty="0"/>
              <a:t>13</a:t>
            </a:r>
            <a:r>
              <a:rPr lang="en-US" dirty="0"/>
              <a:t>C Metabolite Yeast Extract Chemical Class Composition</a:t>
            </a:r>
          </a:p>
        </p:txBody>
      </p:sp>
      <p:sp>
        <p:nvSpPr>
          <p:cNvPr id="2" name="TextBox 1">
            <a:extLst>
              <a:ext uri="{FF2B5EF4-FFF2-40B4-BE49-F238E27FC236}">
                <a16:creationId xmlns:a16="http://schemas.microsoft.com/office/drawing/2014/main" id="{41A4E1ED-C99F-B4E0-1133-6E0C6F9A44A1}"/>
              </a:ext>
            </a:extLst>
          </p:cNvPr>
          <p:cNvSpPr txBox="1"/>
          <p:nvPr/>
        </p:nvSpPr>
        <p:spPr>
          <a:xfrm>
            <a:off x="37199" y="9132781"/>
            <a:ext cx="7488452" cy="1600438"/>
          </a:xfrm>
          <a:prstGeom prst="rect">
            <a:avLst/>
          </a:prstGeom>
          <a:noFill/>
        </p:spPr>
        <p:txBody>
          <a:bodyPr wrap="square" rtlCol="0">
            <a:spAutoFit/>
          </a:bodyPr>
          <a:lstStyle/>
          <a:p>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Figure S2</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U-</a:t>
            </a:r>
            <a:r>
              <a:rPr lang="en-US" sz="1400" baseline="300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13</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C metabolite yeast extract improves linearity of response: (</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chemical class composition of the 78 U-13C metabolites detected by the OGP in yeast extract. Class assignment is based on HMDB; (</a:t>
            </a:r>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B</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Examples of how the ratio to internal standard improves linearity of response compared to the absolute metabolite signal. Data points are averages of 3 replicate measurements and error bars are </a:t>
            </a:r>
            <a:r>
              <a:rPr lang="en-US" sz="14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d.</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t>
            </a:r>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C</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Degree of correlation to a linear calibration curve of metabolite ratios to internal standard vs ratios to surrogate standards for all OGP metabolites.</a:t>
            </a:r>
            <a:endParaRPr lang="en-US" dirty="0"/>
          </a:p>
        </p:txBody>
      </p:sp>
    </p:spTree>
    <p:extLst>
      <p:ext uri="{BB962C8B-B14F-4D97-AF65-F5344CB8AC3E}">
        <p14:creationId xmlns:p14="http://schemas.microsoft.com/office/powerpoint/2010/main" val="25764299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96AF1ED-85D6-5B62-F40A-E3A2582E20AC}"/>
              </a:ext>
            </a:extLst>
          </p:cNvPr>
          <p:cNvSpPr txBox="1"/>
          <p:nvPr/>
        </p:nvSpPr>
        <p:spPr>
          <a:xfrm>
            <a:off x="262122" y="126667"/>
            <a:ext cx="437940" cy="369332"/>
          </a:xfrm>
          <a:prstGeom prst="rect">
            <a:avLst/>
          </a:prstGeom>
          <a:noFill/>
        </p:spPr>
        <p:txBody>
          <a:bodyPr wrap="none" rtlCol="0">
            <a:spAutoFit/>
          </a:bodyPr>
          <a:lstStyle/>
          <a:p>
            <a:r>
              <a:rPr lang="en-US" dirty="0"/>
              <a:t>S3</a:t>
            </a:r>
          </a:p>
        </p:txBody>
      </p:sp>
      <p:pic>
        <p:nvPicPr>
          <p:cNvPr id="6" name="Picture 5" descr="A graph of a graph showing a diagram of a slope&#10;&#10;Description automatically generated with medium confidence">
            <a:extLst>
              <a:ext uri="{FF2B5EF4-FFF2-40B4-BE49-F238E27FC236}">
                <a16:creationId xmlns:a16="http://schemas.microsoft.com/office/drawing/2014/main" id="{18A5B968-9AAA-512E-3EEF-9BC5A07BF5CA}"/>
              </a:ext>
            </a:extLst>
          </p:cNvPr>
          <p:cNvPicPr>
            <a:picLocks noChangeAspect="1"/>
          </p:cNvPicPr>
          <p:nvPr/>
        </p:nvPicPr>
        <p:blipFill rotWithShape="1">
          <a:blip r:embed="rId2">
            <a:extLst>
              <a:ext uri="{28A0092B-C50C-407E-A947-70E740481C1C}">
                <a14:useLocalDpi xmlns:a14="http://schemas.microsoft.com/office/drawing/2010/main" val="0"/>
              </a:ext>
            </a:extLst>
          </a:blip>
          <a:srcRect b="17981"/>
          <a:stretch/>
        </p:blipFill>
        <p:spPr>
          <a:xfrm>
            <a:off x="1393061" y="63674"/>
            <a:ext cx="3915918" cy="3211789"/>
          </a:xfrm>
          <a:prstGeom prst="rect">
            <a:avLst/>
          </a:prstGeom>
        </p:spPr>
      </p:pic>
      <p:sp>
        <p:nvSpPr>
          <p:cNvPr id="2" name="Rectangle 1">
            <a:extLst>
              <a:ext uri="{FF2B5EF4-FFF2-40B4-BE49-F238E27FC236}">
                <a16:creationId xmlns:a16="http://schemas.microsoft.com/office/drawing/2014/main" id="{C3D943B9-5C70-16E8-FDB1-53B6DA96A743}"/>
              </a:ext>
            </a:extLst>
          </p:cNvPr>
          <p:cNvSpPr/>
          <p:nvPr/>
        </p:nvSpPr>
        <p:spPr>
          <a:xfrm rot="16200000">
            <a:off x="534080" y="1401679"/>
            <a:ext cx="1717963" cy="49183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old Change</a:t>
            </a:r>
          </a:p>
        </p:txBody>
      </p:sp>
      <p:graphicFrame>
        <p:nvGraphicFramePr>
          <p:cNvPr id="3" name="Table 2">
            <a:extLst>
              <a:ext uri="{FF2B5EF4-FFF2-40B4-BE49-F238E27FC236}">
                <a16:creationId xmlns:a16="http://schemas.microsoft.com/office/drawing/2014/main" id="{E5240DA8-BD9D-A1EC-FA81-4F4863242403}"/>
              </a:ext>
            </a:extLst>
          </p:cNvPr>
          <p:cNvGraphicFramePr>
            <a:graphicFrameLocks noGrp="1"/>
          </p:cNvGraphicFramePr>
          <p:nvPr>
            <p:extLst>
              <p:ext uri="{D42A27DB-BD31-4B8C-83A1-F6EECF244321}">
                <p14:modId xmlns:p14="http://schemas.microsoft.com/office/powerpoint/2010/main" val="2691092996"/>
              </p:ext>
            </p:extLst>
          </p:nvPr>
        </p:nvGraphicFramePr>
        <p:xfrm>
          <a:off x="307992" y="5462405"/>
          <a:ext cx="7061972" cy="4437129"/>
        </p:xfrm>
        <a:graphic>
          <a:graphicData uri="http://schemas.openxmlformats.org/drawingml/2006/table">
            <a:tbl>
              <a:tblPr firstRow="1" bandRow="1">
                <a:tableStyleId>{5C22544A-7EE6-4342-B048-85BDC9FD1C3A}</a:tableStyleId>
              </a:tblPr>
              <a:tblGrid>
                <a:gridCol w="1765493">
                  <a:extLst>
                    <a:ext uri="{9D8B030D-6E8A-4147-A177-3AD203B41FA5}">
                      <a16:colId xmlns:a16="http://schemas.microsoft.com/office/drawing/2014/main" val="841356433"/>
                    </a:ext>
                  </a:extLst>
                </a:gridCol>
                <a:gridCol w="1765493">
                  <a:extLst>
                    <a:ext uri="{9D8B030D-6E8A-4147-A177-3AD203B41FA5}">
                      <a16:colId xmlns:a16="http://schemas.microsoft.com/office/drawing/2014/main" val="1754495264"/>
                    </a:ext>
                  </a:extLst>
                </a:gridCol>
                <a:gridCol w="1765493">
                  <a:extLst>
                    <a:ext uri="{9D8B030D-6E8A-4147-A177-3AD203B41FA5}">
                      <a16:colId xmlns:a16="http://schemas.microsoft.com/office/drawing/2014/main" val="3664494414"/>
                    </a:ext>
                  </a:extLst>
                </a:gridCol>
                <a:gridCol w="1765493">
                  <a:extLst>
                    <a:ext uri="{9D8B030D-6E8A-4147-A177-3AD203B41FA5}">
                      <a16:colId xmlns:a16="http://schemas.microsoft.com/office/drawing/2014/main" val="754414009"/>
                    </a:ext>
                  </a:extLst>
                </a:gridCol>
              </a:tblGrid>
              <a:tr h="802736">
                <a:tc>
                  <a:txBody>
                    <a:bodyPr/>
                    <a:lstStyle/>
                    <a:p>
                      <a:pPr algn="ctr"/>
                      <a:r>
                        <a:rPr lang="en-US" dirty="0"/>
                        <a:t>Vendor</a:t>
                      </a:r>
                    </a:p>
                  </a:txBody>
                  <a:tcPr anchor="ctr"/>
                </a:tc>
                <a:tc>
                  <a:txBody>
                    <a:bodyPr/>
                    <a:lstStyle/>
                    <a:p>
                      <a:pPr algn="ctr"/>
                      <a:r>
                        <a:rPr lang="en-US" dirty="0"/>
                        <a:t>Platform</a:t>
                      </a:r>
                    </a:p>
                  </a:txBody>
                  <a:tcPr anchor="ctr"/>
                </a:tc>
                <a:tc>
                  <a:txBody>
                    <a:bodyPr/>
                    <a:lstStyle/>
                    <a:p>
                      <a:pPr algn="ctr"/>
                      <a:r>
                        <a:rPr lang="en-US" dirty="0"/>
                        <a:t>Method features</a:t>
                      </a:r>
                    </a:p>
                  </a:txBody>
                  <a:tcPr anchor="ctr"/>
                </a:tc>
                <a:tc>
                  <a:txBody>
                    <a:bodyPr/>
                    <a:lstStyle/>
                    <a:p>
                      <a:pPr algn="ctr"/>
                      <a:r>
                        <a:rPr lang="en-US" dirty="0"/>
                        <a:t>Across-batch CV</a:t>
                      </a:r>
                    </a:p>
                  </a:txBody>
                  <a:tcPr anchor="ctr"/>
                </a:tc>
                <a:extLst>
                  <a:ext uri="{0D108BD9-81ED-4DB2-BD59-A6C34878D82A}">
                    <a16:rowId xmlns:a16="http://schemas.microsoft.com/office/drawing/2014/main" val="1161990351"/>
                  </a:ext>
                </a:extLst>
              </a:tr>
              <a:tr h="802736">
                <a:tc>
                  <a:txBody>
                    <a:bodyPr/>
                    <a:lstStyle/>
                    <a:p>
                      <a:r>
                        <a:rPr lang="en-US" dirty="0" err="1"/>
                        <a:t>Biocrates</a:t>
                      </a:r>
                      <a:endParaRPr lang="en-US" dirty="0"/>
                    </a:p>
                  </a:txBody>
                  <a:tcPr/>
                </a:tc>
                <a:tc>
                  <a:txBody>
                    <a:bodyPr/>
                    <a:lstStyle/>
                    <a:p>
                      <a:r>
                        <a:rPr lang="en-US" dirty="0" err="1"/>
                        <a:t>MxP</a:t>
                      </a:r>
                      <a:r>
                        <a:rPr lang="en-US" dirty="0"/>
                        <a:t> Quant 500 kit</a:t>
                      </a:r>
                    </a:p>
                  </a:txBody>
                  <a:tcPr/>
                </a:tc>
                <a:tc>
                  <a:txBody>
                    <a:bodyPr/>
                    <a:lstStyle/>
                    <a:p>
                      <a:r>
                        <a:rPr lang="en-US" dirty="0"/>
                        <a:t>LC-MS, quantitative, uses derivatization </a:t>
                      </a:r>
                    </a:p>
                  </a:txBody>
                  <a:tcPr/>
                </a:tc>
                <a:tc>
                  <a:txBody>
                    <a:bodyPr/>
                    <a:lstStyle/>
                    <a:p>
                      <a:pPr algn="ctr"/>
                      <a:r>
                        <a:rPr lang="en-US" dirty="0"/>
                        <a:t>14%</a:t>
                      </a:r>
                    </a:p>
                  </a:txBody>
                  <a:tcPr/>
                </a:tc>
                <a:extLst>
                  <a:ext uri="{0D108BD9-81ED-4DB2-BD59-A6C34878D82A}">
                    <a16:rowId xmlns:a16="http://schemas.microsoft.com/office/drawing/2014/main" val="2159171305"/>
                  </a:ext>
                </a:extLst>
              </a:tr>
              <a:tr h="802736">
                <a:tc>
                  <a:txBody>
                    <a:bodyPr/>
                    <a:lstStyle/>
                    <a:p>
                      <a:r>
                        <a:rPr lang="en-US" dirty="0"/>
                        <a:t>Human Metabolome Technologies (HMT)</a:t>
                      </a:r>
                    </a:p>
                  </a:txBody>
                  <a:tcPr/>
                </a:tc>
                <a:tc>
                  <a:txBody>
                    <a:bodyPr/>
                    <a:lstStyle/>
                    <a:p>
                      <a:r>
                        <a:rPr lang="en-US" dirty="0"/>
                        <a:t>Omega Scan using CE-Orbitrap, M-SCAN</a:t>
                      </a:r>
                    </a:p>
                  </a:txBody>
                  <a:tcPr/>
                </a:tc>
                <a:tc>
                  <a:txBody>
                    <a:bodyPr/>
                    <a:lstStyle/>
                    <a:p>
                      <a:r>
                        <a:rPr lang="en-US" dirty="0"/>
                        <a:t>CE-MS, quantitative for subset, non-quantitative for rest.</a:t>
                      </a:r>
                    </a:p>
                  </a:txBody>
                  <a:tcPr/>
                </a:tc>
                <a:tc>
                  <a:txBody>
                    <a:bodyPr/>
                    <a:lstStyle/>
                    <a:p>
                      <a:pPr algn="ctr"/>
                      <a:r>
                        <a:rPr lang="en-US" dirty="0"/>
                        <a:t>12%</a:t>
                      </a:r>
                    </a:p>
                  </a:txBody>
                  <a:tcPr/>
                </a:tc>
                <a:extLst>
                  <a:ext uri="{0D108BD9-81ED-4DB2-BD59-A6C34878D82A}">
                    <a16:rowId xmlns:a16="http://schemas.microsoft.com/office/drawing/2014/main" val="1299429549"/>
                  </a:ext>
                </a:extLst>
              </a:tr>
              <a:tr h="802736">
                <a:tc>
                  <a:txBody>
                    <a:bodyPr/>
                    <a:lstStyle/>
                    <a:p>
                      <a:r>
                        <a:rPr lang="en-US" dirty="0"/>
                        <a:t>Metabolon</a:t>
                      </a:r>
                    </a:p>
                  </a:txBody>
                  <a:tcPr/>
                </a:tc>
                <a:tc>
                  <a:txBody>
                    <a:bodyPr/>
                    <a:lstStyle/>
                    <a:p>
                      <a:r>
                        <a:rPr lang="en-US" dirty="0"/>
                        <a:t>Global metabolomics</a:t>
                      </a:r>
                    </a:p>
                  </a:txBody>
                  <a:tcPr/>
                </a:tc>
                <a:tc>
                  <a:txBody>
                    <a:bodyPr/>
                    <a:lstStyle/>
                    <a:p>
                      <a:r>
                        <a:rPr lang="en-US" dirty="0"/>
                        <a:t>LC-MS, non-quantitative</a:t>
                      </a:r>
                    </a:p>
                  </a:txBody>
                  <a:tcPr/>
                </a:tc>
                <a:tc>
                  <a:txBody>
                    <a:bodyPr/>
                    <a:lstStyle/>
                    <a:p>
                      <a:pPr algn="ctr"/>
                      <a:r>
                        <a:rPr lang="en-US" dirty="0"/>
                        <a:t>18%</a:t>
                      </a:r>
                    </a:p>
                  </a:txBody>
                  <a:tcPr/>
                </a:tc>
                <a:extLst>
                  <a:ext uri="{0D108BD9-81ED-4DB2-BD59-A6C34878D82A}">
                    <a16:rowId xmlns:a16="http://schemas.microsoft.com/office/drawing/2014/main" val="1902374248"/>
                  </a:ext>
                </a:extLst>
              </a:tr>
              <a:tr h="802736">
                <a:tc>
                  <a:txBody>
                    <a:bodyPr/>
                    <a:lstStyle/>
                    <a:p>
                      <a:r>
                        <a:rPr lang="en-US" dirty="0"/>
                        <a:t>Nightingale</a:t>
                      </a:r>
                    </a:p>
                  </a:txBody>
                  <a:tcPr/>
                </a:tc>
                <a:tc>
                  <a:txBody>
                    <a:bodyPr/>
                    <a:lstStyle/>
                    <a:p>
                      <a:r>
                        <a:rPr lang="en-US" dirty="0"/>
                        <a:t>Nightingale Blood Biomarker Analysis Service</a:t>
                      </a:r>
                    </a:p>
                  </a:txBody>
                  <a:tcPr/>
                </a:tc>
                <a:tc>
                  <a:txBody>
                    <a:bodyPr/>
                    <a:lstStyle/>
                    <a:p>
                      <a:r>
                        <a:rPr lang="en-US" dirty="0"/>
                        <a:t>NMR, quantitative</a:t>
                      </a:r>
                    </a:p>
                  </a:txBody>
                  <a:tcPr/>
                </a:tc>
                <a:tc>
                  <a:txBody>
                    <a:bodyPr/>
                    <a:lstStyle/>
                    <a:p>
                      <a:pPr algn="ctr"/>
                      <a:r>
                        <a:rPr lang="en-US"/>
                        <a:t>8%</a:t>
                      </a:r>
                      <a:endParaRPr lang="en-US" dirty="0"/>
                    </a:p>
                  </a:txBody>
                  <a:tcPr/>
                </a:tc>
                <a:extLst>
                  <a:ext uri="{0D108BD9-81ED-4DB2-BD59-A6C34878D82A}">
                    <a16:rowId xmlns:a16="http://schemas.microsoft.com/office/drawing/2014/main" val="2416772775"/>
                  </a:ext>
                </a:extLst>
              </a:tr>
            </a:tbl>
          </a:graphicData>
        </a:graphic>
      </p:graphicFrame>
      <p:sp>
        <p:nvSpPr>
          <p:cNvPr id="5" name="TextBox 4">
            <a:extLst>
              <a:ext uri="{FF2B5EF4-FFF2-40B4-BE49-F238E27FC236}">
                <a16:creationId xmlns:a16="http://schemas.microsoft.com/office/drawing/2014/main" id="{1AD1843E-78C2-717E-46C9-2090D89968C2}"/>
              </a:ext>
            </a:extLst>
          </p:cNvPr>
          <p:cNvSpPr txBox="1"/>
          <p:nvPr/>
        </p:nvSpPr>
        <p:spPr>
          <a:xfrm>
            <a:off x="262122" y="5093073"/>
            <a:ext cx="1012072" cy="369332"/>
          </a:xfrm>
          <a:prstGeom prst="rect">
            <a:avLst/>
          </a:prstGeom>
          <a:noFill/>
        </p:spPr>
        <p:txBody>
          <a:bodyPr wrap="none" rtlCol="0">
            <a:spAutoFit/>
          </a:bodyPr>
          <a:lstStyle/>
          <a:p>
            <a:r>
              <a:rPr lang="en-US" dirty="0"/>
              <a:t>Table S2</a:t>
            </a:r>
          </a:p>
        </p:txBody>
      </p:sp>
      <p:sp>
        <p:nvSpPr>
          <p:cNvPr id="8" name="TextBox 7">
            <a:extLst>
              <a:ext uri="{FF2B5EF4-FFF2-40B4-BE49-F238E27FC236}">
                <a16:creationId xmlns:a16="http://schemas.microsoft.com/office/drawing/2014/main" id="{3E386A09-746C-07E2-C30C-6F36A29DBF17}"/>
              </a:ext>
            </a:extLst>
          </p:cNvPr>
          <p:cNvSpPr txBox="1"/>
          <p:nvPr/>
        </p:nvSpPr>
        <p:spPr>
          <a:xfrm>
            <a:off x="238756" y="3682326"/>
            <a:ext cx="7061972" cy="1661993"/>
          </a:xfrm>
          <a:prstGeom prst="rect">
            <a:avLst/>
          </a:prstGeom>
          <a:noFill/>
        </p:spPr>
        <p:txBody>
          <a:bodyPr wrap="square" rtlCol="0">
            <a:spAutoFit/>
          </a:bodyPr>
          <a:lstStyle/>
          <a:p>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Figure S3</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OGP performance for a batch of study samples: Per sample normalization based on the median of metabolite ratios to internal and surrogate standards (teal) is more accurate than normalization using the median of absolute metabolite signals (red). Shown is the fold change between a 2-fold diluted and 2-fold concentrated pooled urine sample post normalization. As this is the same sample, the fold change post-normalization should be as close to 1 as possible.</a:t>
            </a:r>
          </a:p>
          <a:p>
            <a:endParaRPr lang="en-US" dirty="0"/>
          </a:p>
        </p:txBody>
      </p:sp>
      <p:pic>
        <p:nvPicPr>
          <p:cNvPr id="9" name="Picture 8" descr="A graph of a graph showing a diagram of a slope&#10;&#10;Description automatically generated with medium confidence">
            <a:extLst>
              <a:ext uri="{FF2B5EF4-FFF2-40B4-BE49-F238E27FC236}">
                <a16:creationId xmlns:a16="http://schemas.microsoft.com/office/drawing/2014/main" id="{D2585556-E3E7-D425-356C-C1307CFFE92D}"/>
              </a:ext>
            </a:extLst>
          </p:cNvPr>
          <p:cNvPicPr>
            <a:picLocks noChangeAspect="1"/>
          </p:cNvPicPr>
          <p:nvPr/>
        </p:nvPicPr>
        <p:blipFill rotWithShape="1">
          <a:blip r:embed="rId2">
            <a:extLst>
              <a:ext uri="{28A0092B-C50C-407E-A947-70E740481C1C}">
                <a14:useLocalDpi xmlns:a14="http://schemas.microsoft.com/office/drawing/2010/main" val="0"/>
              </a:ext>
            </a:extLst>
          </a:blip>
          <a:srcRect t="91119"/>
          <a:stretch/>
        </p:blipFill>
        <p:spPr>
          <a:xfrm>
            <a:off x="1318493" y="3279757"/>
            <a:ext cx="3915918" cy="347770"/>
          </a:xfrm>
          <a:prstGeom prst="rect">
            <a:avLst/>
          </a:prstGeom>
        </p:spPr>
      </p:pic>
      <p:sp>
        <p:nvSpPr>
          <p:cNvPr id="10" name="TextBox 9">
            <a:extLst>
              <a:ext uri="{FF2B5EF4-FFF2-40B4-BE49-F238E27FC236}">
                <a16:creationId xmlns:a16="http://schemas.microsoft.com/office/drawing/2014/main" id="{8DCF5705-E09B-CEA5-C9D6-BFDDCD877BEB}"/>
              </a:ext>
            </a:extLst>
          </p:cNvPr>
          <p:cNvSpPr txBox="1"/>
          <p:nvPr/>
        </p:nvSpPr>
        <p:spPr>
          <a:xfrm>
            <a:off x="237744" y="9899534"/>
            <a:ext cx="7061972" cy="738664"/>
          </a:xfrm>
          <a:prstGeom prst="rect">
            <a:avLst/>
          </a:prstGeom>
          <a:noFill/>
        </p:spPr>
        <p:txBody>
          <a:bodyPr wrap="square" rtlCol="0">
            <a:spAutoFit/>
          </a:bodyPr>
          <a:lstStyle/>
          <a:p>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Table S2. </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Overview of vendors, their metabolomics technologies, and across-batch CV. Across-batch CVs are from </a:t>
            </a:r>
            <a:r>
              <a:rPr lang="en-US" sz="14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Chaby</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t>
            </a:r>
            <a:r>
              <a:rPr lang="en-US" sz="1400" i="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et al </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2],</a:t>
            </a:r>
            <a:r>
              <a:rPr lang="en-US" sz="1400" i="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and for each vendor are calculated for metabolite classes overlapping with the OGP. </a:t>
            </a:r>
            <a:endParaRPr lang="en-US" sz="1400" dirty="0"/>
          </a:p>
        </p:txBody>
      </p:sp>
    </p:spTree>
    <p:extLst>
      <p:ext uri="{BB962C8B-B14F-4D97-AF65-F5344CB8AC3E}">
        <p14:creationId xmlns:p14="http://schemas.microsoft.com/office/powerpoint/2010/main" val="155893236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TaxCatchAll xmlns="a1f5c97c-4d41-47f7-b18f-14913914c4c0" xsi:nil="true"/>
    <lcf76f155ced4ddcb4097134ff3c332f xmlns="7de422de-ddb2-4da7-85f2-3ea10eea23e4">
      <Terms xmlns="http://schemas.microsoft.com/office/infopath/2007/PartnerControls"/>
    </lcf76f155ced4ddcb4097134ff3c332f>
    <Detailsaboutvideos xmlns="7de422de-ddb2-4da7-85f2-3ea10eea23e4"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AF1C3B4BF6881F4DB23383C439883027" ma:contentTypeVersion="19" ma:contentTypeDescription="Create a new document." ma:contentTypeScope="" ma:versionID="b849f0bdd4bd775bfffccba819372594">
  <xsd:schema xmlns:xsd="http://www.w3.org/2001/XMLSchema" xmlns:xs="http://www.w3.org/2001/XMLSchema" xmlns:p="http://schemas.microsoft.com/office/2006/metadata/properties" xmlns:ns2="7de422de-ddb2-4da7-85f2-3ea10eea23e4" xmlns:ns3="a1f5c97c-4d41-47f7-b18f-14913914c4c0" targetNamespace="http://schemas.microsoft.com/office/2006/metadata/properties" ma:root="true" ma:fieldsID="9192b473f17bfee41239f5eec840d456" ns2:_="" ns3:_="">
    <xsd:import namespace="7de422de-ddb2-4da7-85f2-3ea10eea23e4"/>
    <xsd:import namespace="a1f5c97c-4d41-47f7-b18f-14913914c4c0"/>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AutoTags" minOccurs="0"/>
                <xsd:element ref="ns2:MediaServiceOCR" minOccurs="0"/>
                <xsd:element ref="ns2:MediaServiceGenerationTime" minOccurs="0"/>
                <xsd:element ref="ns2:MediaServiceEventHashCode" minOccurs="0"/>
                <xsd:element ref="ns2:MediaServiceAutoKeyPoints" minOccurs="0"/>
                <xsd:element ref="ns2:MediaServiceKeyPoints" minOccurs="0"/>
                <xsd:element ref="ns2:MediaServiceDateTaken" minOccurs="0"/>
                <xsd:element ref="ns2:MediaServiceLocation" minOccurs="0"/>
                <xsd:element ref="ns2:MediaLengthInSeconds" minOccurs="0"/>
                <xsd:element ref="ns2:lcf76f155ced4ddcb4097134ff3c332f" minOccurs="0"/>
                <xsd:element ref="ns3:TaxCatchAll" minOccurs="0"/>
                <xsd:element ref="ns2:Detailsaboutvideo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de422de-ddb2-4da7-85f2-3ea10eea23e4"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ServiceDateTaken" ma:index="18" nillable="true" ma:displayName="MediaServiceDateTaken" ma:hidden="true" ma:internalName="MediaServiceDateTaken" ma:readOnly="true">
      <xsd:simpleType>
        <xsd:restriction base="dms:Text"/>
      </xsd:simpleType>
    </xsd:element>
    <xsd:element name="MediaServiceLocation" ma:index="19" nillable="true" ma:displayName="Location" ma:internalName="MediaServiceLocation" ma:readOnly="true">
      <xsd:simpleType>
        <xsd:restriction base="dms:Text"/>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de3ca4e4-2419-46e1-8600-c5c51b5b4a13" ma:termSetId="09814cd3-568e-fe90-9814-8d621ff8fb84" ma:anchorId="fba54fb3-c3e1-fe81-a776-ca4b69148c4d" ma:open="true" ma:isKeyword="false">
      <xsd:complexType>
        <xsd:sequence>
          <xsd:element ref="pc:Terms" minOccurs="0" maxOccurs="1"/>
        </xsd:sequence>
      </xsd:complexType>
    </xsd:element>
    <xsd:element name="Detailsaboutvideos" ma:index="24" nillable="true" ma:displayName="Details about videos" ma:format="Dropdown" ma:internalName="Detailsaboutvideos">
      <xsd:simpleType>
        <xsd:restriction base="dms:Note">
          <xsd:maxLength value="255"/>
        </xsd:restriction>
      </xsd:simpleType>
    </xsd:element>
    <xsd:element name="MediaServiceObjectDetectorVersions" ma:index="25"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6"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a1f5c97c-4d41-47f7-b18f-14913914c4c0"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4b595ccb-e3c1-474b-b4d0-aae1bcf7348a}" ma:internalName="TaxCatchAll" ma:showField="CatchAllData" ma:web="a1f5c97c-4d41-47f7-b18f-14913914c4c0">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3E8C0513-E355-4C68-A5E4-FF101D741DAF}">
  <ds:schemaRefs>
    <ds:schemaRef ds:uri="7de422de-ddb2-4da7-85f2-3ea10eea23e4"/>
    <ds:schemaRef ds:uri="http://purl.org/dc/elements/1.1/"/>
    <ds:schemaRef ds:uri="http://www.w3.org/XML/1998/namespace"/>
    <ds:schemaRef ds:uri="http://schemas.microsoft.com/office/2006/documentManagement/types"/>
    <ds:schemaRef ds:uri="http://purl.org/dc/dcmitype/"/>
    <ds:schemaRef ds:uri="http://schemas.microsoft.com/office/infopath/2007/PartnerControls"/>
    <ds:schemaRef ds:uri="a1f5c97c-4d41-47f7-b18f-14913914c4c0"/>
    <ds:schemaRef ds:uri="http://schemas.openxmlformats.org/package/2006/metadata/core-properties"/>
    <ds:schemaRef ds:uri="http://schemas.microsoft.com/office/2006/metadata/properties"/>
    <ds:schemaRef ds:uri="http://purl.org/dc/terms/"/>
  </ds:schemaRefs>
</ds:datastoreItem>
</file>

<file path=customXml/itemProps2.xml><?xml version="1.0" encoding="utf-8"?>
<ds:datastoreItem xmlns:ds="http://schemas.openxmlformats.org/officeDocument/2006/customXml" ds:itemID="{567C3480-C10B-4211-AFD7-673620A1853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de422de-ddb2-4da7-85f2-3ea10eea23e4"/>
    <ds:schemaRef ds:uri="a1f5c97c-4d41-47f7-b18f-14913914c4c0"/>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D8BAB483-52B6-49E4-B338-E12E3B8BFD9D}">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893</TotalTime>
  <Words>482</Words>
  <Application>Microsoft Office PowerPoint</Application>
  <PresentationFormat>Custom</PresentationFormat>
  <Paragraphs>82</Paragraphs>
  <Slides>3</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vt:i4>
      </vt:variant>
    </vt:vector>
  </HeadingPairs>
  <TitlesOfParts>
    <vt:vector size="9" baseType="lpstr">
      <vt:lpstr>Aptos</vt:lpstr>
      <vt:lpstr>Aptos Display</vt:lpstr>
      <vt:lpstr>Arial</vt:lpstr>
      <vt:lpstr>Palatino Linotype</vt:lpstr>
      <vt:lpstr>Wingdings</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rre Kamphorst</dc:creator>
  <cp:lastModifiedBy>Jurre Kamphorst</cp:lastModifiedBy>
  <cp:revision>3</cp:revision>
  <dcterms:created xsi:type="dcterms:W3CDTF">2024-02-29T18:06:41Z</dcterms:created>
  <dcterms:modified xsi:type="dcterms:W3CDTF">2024-05-09T18:06: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F1C3B4BF6881F4DB23383C439883027</vt:lpwstr>
  </property>
  <property fmtid="{D5CDD505-2E9C-101B-9397-08002B2CF9AE}" pid="3" name="MediaServiceImageTags">
    <vt:lpwstr/>
  </property>
</Properties>
</file>